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0958B7F-DA56-4EE4-A142-34060A6C04EA}" v="24" dt="2024-01-20T14:39:11.771"/>
    <p1510:client id="{47E41604-0C7C-435B-A107-D9296C7C3701}" v="5" dt="2024-01-20T17:48:49.320"/>
    <p1510:client id="{73B0631D-FD37-44B5-B6A2-152E3460FC52}" v="5" dt="2024-01-20T16:50:37.35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4212" y="1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ARLOS COSTAS INSUA" userId="e10c8832-4d3d-4782-833a-236983bbf7b2" providerId="ADAL" clId="{73B0631D-FD37-44B5-B6A2-152E3460FC52}"/>
    <pc:docChg chg="undo custSel modSld">
      <pc:chgData name="CARLOS COSTAS INSUA" userId="e10c8832-4d3d-4782-833a-236983bbf7b2" providerId="ADAL" clId="{73B0631D-FD37-44B5-B6A2-152E3460FC52}" dt="2024-01-20T16:55:07.602" v="283" actId="6549"/>
      <pc:docMkLst>
        <pc:docMk/>
      </pc:docMkLst>
      <pc:sldChg chg="addSp delSp modSp mod">
        <pc:chgData name="CARLOS COSTAS INSUA" userId="e10c8832-4d3d-4782-833a-236983bbf7b2" providerId="ADAL" clId="{73B0631D-FD37-44B5-B6A2-152E3460FC52}" dt="2024-01-20T16:55:07.602" v="283" actId="6549"/>
        <pc:sldMkLst>
          <pc:docMk/>
          <pc:sldMk cId="2004873951" sldId="256"/>
        </pc:sldMkLst>
        <pc:spChg chg="add mod topLvl">
          <ac:chgData name="CARLOS COSTAS INSUA" userId="e10c8832-4d3d-4782-833a-236983bbf7b2" providerId="ADAL" clId="{73B0631D-FD37-44B5-B6A2-152E3460FC52}" dt="2024-01-20T16:53:06.756" v="155" actId="14100"/>
          <ac:spMkLst>
            <pc:docMk/>
            <pc:sldMk cId="2004873951" sldId="256"/>
            <ac:spMk id="6" creationId="{062AEB9E-797E-A12A-0F53-B288691E624C}"/>
          </ac:spMkLst>
        </pc:spChg>
        <pc:spChg chg="mod">
          <ac:chgData name="CARLOS COSTAS INSUA" userId="e10c8832-4d3d-4782-833a-236983bbf7b2" providerId="ADAL" clId="{73B0631D-FD37-44B5-B6A2-152E3460FC52}" dt="2024-01-20T16:48:58.793" v="80"/>
          <ac:spMkLst>
            <pc:docMk/>
            <pc:sldMk cId="2004873951" sldId="256"/>
            <ac:spMk id="11" creationId="{407C6F6A-5A2B-EDFD-B031-9CCC950236DB}"/>
          </ac:spMkLst>
        </pc:spChg>
        <pc:spChg chg="mod">
          <ac:chgData name="CARLOS COSTAS INSUA" userId="e10c8832-4d3d-4782-833a-236983bbf7b2" providerId="ADAL" clId="{73B0631D-FD37-44B5-B6A2-152E3460FC52}" dt="2024-01-20T16:48:58.793" v="80"/>
          <ac:spMkLst>
            <pc:docMk/>
            <pc:sldMk cId="2004873951" sldId="256"/>
            <ac:spMk id="12" creationId="{81F1C6DB-4FE9-14EF-C6C8-289969765A58}"/>
          </ac:spMkLst>
        </pc:spChg>
        <pc:spChg chg="mod">
          <ac:chgData name="CARLOS COSTAS INSUA" userId="e10c8832-4d3d-4782-833a-236983bbf7b2" providerId="ADAL" clId="{73B0631D-FD37-44B5-B6A2-152E3460FC52}" dt="2024-01-20T16:48:58.793" v="80"/>
          <ac:spMkLst>
            <pc:docMk/>
            <pc:sldMk cId="2004873951" sldId="256"/>
            <ac:spMk id="13" creationId="{F9F5E387-24BF-8EFB-7B1D-CC83678FEEDE}"/>
          </ac:spMkLst>
        </pc:spChg>
        <pc:spChg chg="mod">
          <ac:chgData name="CARLOS COSTAS INSUA" userId="e10c8832-4d3d-4782-833a-236983bbf7b2" providerId="ADAL" clId="{73B0631D-FD37-44B5-B6A2-152E3460FC52}" dt="2024-01-20T16:48:58.793" v="80"/>
          <ac:spMkLst>
            <pc:docMk/>
            <pc:sldMk cId="2004873951" sldId="256"/>
            <ac:spMk id="14" creationId="{99016635-A630-214E-F4FF-B9F22A5DC3E5}"/>
          </ac:spMkLst>
        </pc:spChg>
        <pc:spChg chg="mod">
          <ac:chgData name="CARLOS COSTAS INSUA" userId="e10c8832-4d3d-4782-833a-236983bbf7b2" providerId="ADAL" clId="{73B0631D-FD37-44B5-B6A2-152E3460FC52}" dt="2024-01-20T16:48:58.793" v="80"/>
          <ac:spMkLst>
            <pc:docMk/>
            <pc:sldMk cId="2004873951" sldId="256"/>
            <ac:spMk id="15" creationId="{AB7C22C8-F05F-E354-CA99-7D1B3EDFDD1D}"/>
          </ac:spMkLst>
        </pc:spChg>
        <pc:spChg chg="mod">
          <ac:chgData name="CARLOS COSTAS INSUA" userId="e10c8832-4d3d-4782-833a-236983bbf7b2" providerId="ADAL" clId="{73B0631D-FD37-44B5-B6A2-152E3460FC52}" dt="2024-01-20T16:48:58.793" v="80"/>
          <ac:spMkLst>
            <pc:docMk/>
            <pc:sldMk cId="2004873951" sldId="256"/>
            <ac:spMk id="19" creationId="{81F8EAA6-995A-294F-4081-14763EB80FBD}"/>
          </ac:spMkLst>
        </pc:spChg>
        <pc:spChg chg="mod">
          <ac:chgData name="CARLOS COSTAS INSUA" userId="e10c8832-4d3d-4782-833a-236983bbf7b2" providerId="ADAL" clId="{73B0631D-FD37-44B5-B6A2-152E3460FC52}" dt="2024-01-20T16:48:58.793" v="80"/>
          <ac:spMkLst>
            <pc:docMk/>
            <pc:sldMk cId="2004873951" sldId="256"/>
            <ac:spMk id="21" creationId="{98E5F04E-1E86-5DC9-94AD-2F640FEB67D2}"/>
          </ac:spMkLst>
        </pc:spChg>
        <pc:spChg chg="mod">
          <ac:chgData name="CARLOS COSTAS INSUA" userId="e10c8832-4d3d-4782-833a-236983bbf7b2" providerId="ADAL" clId="{73B0631D-FD37-44B5-B6A2-152E3460FC52}" dt="2024-01-20T16:48:58.793" v="80"/>
          <ac:spMkLst>
            <pc:docMk/>
            <pc:sldMk cId="2004873951" sldId="256"/>
            <ac:spMk id="22" creationId="{59A133B0-79D2-959F-8222-5E37E828B334}"/>
          </ac:spMkLst>
        </pc:spChg>
        <pc:spChg chg="mod">
          <ac:chgData name="CARLOS COSTAS INSUA" userId="e10c8832-4d3d-4782-833a-236983bbf7b2" providerId="ADAL" clId="{73B0631D-FD37-44B5-B6A2-152E3460FC52}" dt="2024-01-20T16:48:58.793" v="80"/>
          <ac:spMkLst>
            <pc:docMk/>
            <pc:sldMk cId="2004873951" sldId="256"/>
            <ac:spMk id="23" creationId="{9A9B5B7A-42D6-94E5-EF46-EDEEDE36C8FE}"/>
          </ac:spMkLst>
        </pc:spChg>
        <pc:spChg chg="mod">
          <ac:chgData name="CARLOS COSTAS INSUA" userId="e10c8832-4d3d-4782-833a-236983bbf7b2" providerId="ADAL" clId="{73B0631D-FD37-44B5-B6A2-152E3460FC52}" dt="2024-01-20T16:48:58.793" v="80"/>
          <ac:spMkLst>
            <pc:docMk/>
            <pc:sldMk cId="2004873951" sldId="256"/>
            <ac:spMk id="24" creationId="{6E8D5B12-D73D-F80A-56D3-FEFD41B2B4F4}"/>
          </ac:spMkLst>
        </pc:spChg>
        <pc:spChg chg="mod">
          <ac:chgData name="CARLOS COSTAS INSUA" userId="e10c8832-4d3d-4782-833a-236983bbf7b2" providerId="ADAL" clId="{73B0631D-FD37-44B5-B6A2-152E3460FC52}" dt="2024-01-20T16:54:07.513" v="236" actId="20577"/>
          <ac:spMkLst>
            <pc:docMk/>
            <pc:sldMk cId="2004873951" sldId="256"/>
            <ac:spMk id="1362" creationId="{A0D1A375-D2D6-FD4A-6775-D426EC941C6A}"/>
          </ac:spMkLst>
        </pc:spChg>
        <pc:spChg chg="mod">
          <ac:chgData name="CARLOS COSTAS INSUA" userId="e10c8832-4d3d-4782-833a-236983bbf7b2" providerId="ADAL" clId="{73B0631D-FD37-44B5-B6A2-152E3460FC52}" dt="2024-01-20T16:53:37.051" v="187" actId="20577"/>
          <ac:spMkLst>
            <pc:docMk/>
            <pc:sldMk cId="2004873951" sldId="256"/>
            <ac:spMk id="1754" creationId="{05907BE4-EAE5-6026-200F-8E7E984B2864}"/>
          </ac:spMkLst>
        </pc:spChg>
        <pc:spChg chg="del">
          <ac:chgData name="CARLOS COSTAS INSUA" userId="e10c8832-4d3d-4782-833a-236983bbf7b2" providerId="ADAL" clId="{73B0631D-FD37-44B5-B6A2-152E3460FC52}" dt="2024-01-20T16:49:20.583" v="88" actId="478"/>
          <ac:spMkLst>
            <pc:docMk/>
            <pc:sldMk cId="2004873951" sldId="256"/>
            <ac:spMk id="2547" creationId="{038B4F6E-AE7C-81EF-9B70-206B249496C9}"/>
          </ac:spMkLst>
        </pc:spChg>
        <pc:spChg chg="del">
          <ac:chgData name="CARLOS COSTAS INSUA" userId="e10c8832-4d3d-4782-833a-236983bbf7b2" providerId="ADAL" clId="{73B0631D-FD37-44B5-B6A2-152E3460FC52}" dt="2024-01-20T16:49:11.325" v="85" actId="478"/>
          <ac:spMkLst>
            <pc:docMk/>
            <pc:sldMk cId="2004873951" sldId="256"/>
            <ac:spMk id="2549" creationId="{02083E3C-1DC7-91D7-3870-E148BEA7D4D4}"/>
          </ac:spMkLst>
        </pc:spChg>
        <pc:spChg chg="mod">
          <ac:chgData name="CARLOS COSTAS INSUA" userId="e10c8832-4d3d-4782-833a-236983bbf7b2" providerId="ADAL" clId="{73B0631D-FD37-44B5-B6A2-152E3460FC52}" dt="2024-01-20T16:54:14.147" v="238" actId="20577"/>
          <ac:spMkLst>
            <pc:docMk/>
            <pc:sldMk cId="2004873951" sldId="256"/>
            <ac:spMk id="2553" creationId="{75DAD5D6-EE9B-3F86-4DB1-13AFD23F71BE}"/>
          </ac:spMkLst>
        </pc:spChg>
        <pc:spChg chg="del">
          <ac:chgData name="CARLOS COSTAS INSUA" userId="e10c8832-4d3d-4782-833a-236983bbf7b2" providerId="ADAL" clId="{73B0631D-FD37-44B5-B6A2-152E3460FC52}" dt="2024-01-20T16:49:16.770" v="86" actId="478"/>
          <ac:spMkLst>
            <pc:docMk/>
            <pc:sldMk cId="2004873951" sldId="256"/>
            <ac:spMk id="2554" creationId="{B0CF2F16-ED7E-E99E-EFF7-B0615AC4E336}"/>
          </ac:spMkLst>
        </pc:spChg>
        <pc:spChg chg="del">
          <ac:chgData name="CARLOS COSTAS INSUA" userId="e10c8832-4d3d-4782-833a-236983bbf7b2" providerId="ADAL" clId="{73B0631D-FD37-44B5-B6A2-152E3460FC52}" dt="2024-01-20T16:49:16.770" v="86" actId="478"/>
          <ac:spMkLst>
            <pc:docMk/>
            <pc:sldMk cId="2004873951" sldId="256"/>
            <ac:spMk id="2555" creationId="{743B99BA-D5E8-8BE3-28D3-1D1C7A4119F3}"/>
          </ac:spMkLst>
        </pc:spChg>
        <pc:spChg chg="del">
          <ac:chgData name="CARLOS COSTAS INSUA" userId="e10c8832-4d3d-4782-833a-236983bbf7b2" providerId="ADAL" clId="{73B0631D-FD37-44B5-B6A2-152E3460FC52}" dt="2024-01-20T16:49:16.770" v="86" actId="478"/>
          <ac:spMkLst>
            <pc:docMk/>
            <pc:sldMk cId="2004873951" sldId="256"/>
            <ac:spMk id="2556" creationId="{A934634D-990D-C344-A2A4-F1B6656D0C5D}"/>
          </ac:spMkLst>
        </pc:spChg>
        <pc:spChg chg="del">
          <ac:chgData name="CARLOS COSTAS INSUA" userId="e10c8832-4d3d-4782-833a-236983bbf7b2" providerId="ADAL" clId="{73B0631D-FD37-44B5-B6A2-152E3460FC52}" dt="2024-01-20T16:49:16.770" v="86" actId="478"/>
          <ac:spMkLst>
            <pc:docMk/>
            <pc:sldMk cId="2004873951" sldId="256"/>
            <ac:spMk id="2562" creationId="{964DE709-22DD-7CB7-AB8A-93AA6455A50E}"/>
          </ac:spMkLst>
        </pc:spChg>
        <pc:spChg chg="del">
          <ac:chgData name="CARLOS COSTAS INSUA" userId="e10c8832-4d3d-4782-833a-236983bbf7b2" providerId="ADAL" clId="{73B0631D-FD37-44B5-B6A2-152E3460FC52}" dt="2024-01-20T16:49:23.990" v="89" actId="478"/>
          <ac:spMkLst>
            <pc:docMk/>
            <pc:sldMk cId="2004873951" sldId="256"/>
            <ac:spMk id="2566" creationId="{186620A4-910C-F2F2-E1C8-015FF2EF112A}"/>
          </ac:spMkLst>
        </pc:spChg>
        <pc:spChg chg="del">
          <ac:chgData name="CARLOS COSTAS INSUA" userId="e10c8832-4d3d-4782-833a-236983bbf7b2" providerId="ADAL" clId="{73B0631D-FD37-44B5-B6A2-152E3460FC52}" dt="2024-01-20T16:49:23.990" v="89" actId="478"/>
          <ac:spMkLst>
            <pc:docMk/>
            <pc:sldMk cId="2004873951" sldId="256"/>
            <ac:spMk id="2567" creationId="{CF7D08F4-A638-CA13-4285-D0CEBB3F35E1}"/>
          </ac:spMkLst>
        </pc:spChg>
        <pc:spChg chg="del">
          <ac:chgData name="CARLOS COSTAS INSUA" userId="e10c8832-4d3d-4782-833a-236983bbf7b2" providerId="ADAL" clId="{73B0631D-FD37-44B5-B6A2-152E3460FC52}" dt="2024-01-20T16:49:23.990" v="89" actId="478"/>
          <ac:spMkLst>
            <pc:docMk/>
            <pc:sldMk cId="2004873951" sldId="256"/>
            <ac:spMk id="2568" creationId="{292FE5CD-44B9-9B72-C209-7E2E81FABDD3}"/>
          </ac:spMkLst>
        </pc:spChg>
        <pc:spChg chg="del">
          <ac:chgData name="CARLOS COSTAS INSUA" userId="e10c8832-4d3d-4782-833a-236983bbf7b2" providerId="ADAL" clId="{73B0631D-FD37-44B5-B6A2-152E3460FC52}" dt="2024-01-20T16:49:23.990" v="89" actId="478"/>
          <ac:spMkLst>
            <pc:docMk/>
            <pc:sldMk cId="2004873951" sldId="256"/>
            <ac:spMk id="2569" creationId="{84C7EB1B-7D89-7097-0E6C-D538858D6079}"/>
          </ac:spMkLst>
        </pc:spChg>
        <pc:spChg chg="mod">
          <ac:chgData name="CARLOS COSTAS INSUA" userId="e10c8832-4d3d-4782-833a-236983bbf7b2" providerId="ADAL" clId="{73B0631D-FD37-44B5-B6A2-152E3460FC52}" dt="2024-01-20T16:50:37.352" v="94" actId="165"/>
          <ac:spMkLst>
            <pc:docMk/>
            <pc:sldMk cId="2004873951" sldId="256"/>
            <ac:spMk id="2588" creationId="{2AAFC5FB-03C2-A03D-D872-95BAC81D0E90}"/>
          </ac:spMkLst>
        </pc:spChg>
        <pc:spChg chg="mod">
          <ac:chgData name="CARLOS COSTAS INSUA" userId="e10c8832-4d3d-4782-833a-236983bbf7b2" providerId="ADAL" clId="{73B0631D-FD37-44B5-B6A2-152E3460FC52}" dt="2024-01-20T16:51:33.416" v="144" actId="1035"/>
          <ac:spMkLst>
            <pc:docMk/>
            <pc:sldMk cId="2004873951" sldId="256"/>
            <ac:spMk id="2589" creationId="{69A5F5F9-9909-4AB1-673B-F17ADE2D31E0}"/>
          </ac:spMkLst>
        </pc:spChg>
        <pc:spChg chg="mod">
          <ac:chgData name="CARLOS COSTAS INSUA" userId="e10c8832-4d3d-4782-833a-236983bbf7b2" providerId="ADAL" clId="{73B0631D-FD37-44B5-B6A2-152E3460FC52}" dt="2024-01-20T16:51:33.416" v="144" actId="1035"/>
          <ac:spMkLst>
            <pc:docMk/>
            <pc:sldMk cId="2004873951" sldId="256"/>
            <ac:spMk id="2590" creationId="{955C66DD-20B7-16F6-92C6-50BF1E41AE2A}"/>
          </ac:spMkLst>
        </pc:spChg>
        <pc:spChg chg="mod">
          <ac:chgData name="CARLOS COSTAS INSUA" userId="e10c8832-4d3d-4782-833a-236983bbf7b2" providerId="ADAL" clId="{73B0631D-FD37-44B5-B6A2-152E3460FC52}" dt="2024-01-20T16:51:33.416" v="144" actId="1035"/>
          <ac:spMkLst>
            <pc:docMk/>
            <pc:sldMk cId="2004873951" sldId="256"/>
            <ac:spMk id="2591" creationId="{E8142825-92D4-605B-0680-E449FD1DEFD4}"/>
          </ac:spMkLst>
        </pc:spChg>
        <pc:spChg chg="mod topLvl">
          <ac:chgData name="CARLOS COSTAS INSUA" userId="e10c8832-4d3d-4782-833a-236983bbf7b2" providerId="ADAL" clId="{73B0631D-FD37-44B5-B6A2-152E3460FC52}" dt="2024-01-20T16:51:18.655" v="125" actId="1035"/>
          <ac:spMkLst>
            <pc:docMk/>
            <pc:sldMk cId="2004873951" sldId="256"/>
            <ac:spMk id="2595" creationId="{195849F1-B1C1-529B-BDD8-228619FBCA2A}"/>
          </ac:spMkLst>
        </pc:spChg>
        <pc:spChg chg="mod">
          <ac:chgData name="CARLOS COSTAS INSUA" userId="e10c8832-4d3d-4782-833a-236983bbf7b2" providerId="ADAL" clId="{73B0631D-FD37-44B5-B6A2-152E3460FC52}" dt="2024-01-20T16:54:25.132" v="259" actId="6549"/>
          <ac:spMkLst>
            <pc:docMk/>
            <pc:sldMk cId="2004873951" sldId="256"/>
            <ac:spMk id="2596" creationId="{3C216ABE-A851-E86F-B037-6EB1E7CEFF39}"/>
          </ac:spMkLst>
        </pc:spChg>
        <pc:spChg chg="mod">
          <ac:chgData name="CARLOS COSTAS INSUA" userId="e10c8832-4d3d-4782-833a-236983bbf7b2" providerId="ADAL" clId="{73B0631D-FD37-44B5-B6A2-152E3460FC52}" dt="2024-01-20T16:55:07.602" v="283" actId="6549"/>
          <ac:spMkLst>
            <pc:docMk/>
            <pc:sldMk cId="2004873951" sldId="256"/>
            <ac:spMk id="2597" creationId="{DA76FD5F-F405-DC69-14A8-32184A7CB30A}"/>
          </ac:spMkLst>
        </pc:spChg>
        <pc:spChg chg="del">
          <ac:chgData name="CARLOS COSTAS INSUA" userId="e10c8832-4d3d-4782-833a-236983bbf7b2" providerId="ADAL" clId="{73B0631D-FD37-44B5-B6A2-152E3460FC52}" dt="2024-01-20T16:47:35.812" v="67" actId="478"/>
          <ac:spMkLst>
            <pc:docMk/>
            <pc:sldMk cId="2004873951" sldId="256"/>
            <ac:spMk id="2598" creationId="{F50718BB-89B3-97AB-C202-F68A6539B4FB}"/>
          </ac:spMkLst>
        </pc:spChg>
        <pc:spChg chg="mod topLvl">
          <ac:chgData name="CARLOS COSTAS INSUA" userId="e10c8832-4d3d-4782-833a-236983bbf7b2" providerId="ADAL" clId="{73B0631D-FD37-44B5-B6A2-152E3460FC52}" dt="2024-01-20T16:50:37.352" v="94" actId="165"/>
          <ac:spMkLst>
            <pc:docMk/>
            <pc:sldMk cId="2004873951" sldId="256"/>
            <ac:spMk id="2601" creationId="{4418FFC3-B8DE-F623-2C47-DD22285BFE76}"/>
          </ac:spMkLst>
        </pc:spChg>
        <pc:spChg chg="mod topLvl">
          <ac:chgData name="CARLOS COSTAS INSUA" userId="e10c8832-4d3d-4782-833a-236983bbf7b2" providerId="ADAL" clId="{73B0631D-FD37-44B5-B6A2-152E3460FC52}" dt="2024-01-20T16:53:27.780" v="180" actId="1036"/>
          <ac:spMkLst>
            <pc:docMk/>
            <pc:sldMk cId="2004873951" sldId="256"/>
            <ac:spMk id="2602" creationId="{EF303AF1-73D3-D6EB-0E0D-E489EE393CD9}"/>
          </ac:spMkLst>
        </pc:spChg>
        <pc:spChg chg="mod topLvl">
          <ac:chgData name="CARLOS COSTAS INSUA" userId="e10c8832-4d3d-4782-833a-236983bbf7b2" providerId="ADAL" clId="{73B0631D-FD37-44B5-B6A2-152E3460FC52}" dt="2024-01-20T16:53:27.780" v="180" actId="1036"/>
          <ac:spMkLst>
            <pc:docMk/>
            <pc:sldMk cId="2004873951" sldId="256"/>
            <ac:spMk id="2603" creationId="{3121C709-7B7F-F4EA-2408-BDE4B9D21036}"/>
          </ac:spMkLst>
        </pc:spChg>
        <pc:spChg chg="mod topLvl">
          <ac:chgData name="CARLOS COSTAS INSUA" userId="e10c8832-4d3d-4782-833a-236983bbf7b2" providerId="ADAL" clId="{73B0631D-FD37-44B5-B6A2-152E3460FC52}" dt="2024-01-20T16:53:27.780" v="180" actId="1036"/>
          <ac:spMkLst>
            <pc:docMk/>
            <pc:sldMk cId="2004873951" sldId="256"/>
            <ac:spMk id="2604" creationId="{8AC20314-E187-32DF-9C4C-D8A97241CBBE}"/>
          </ac:spMkLst>
        </pc:spChg>
        <pc:spChg chg="del">
          <ac:chgData name="CARLOS COSTAS INSUA" userId="e10c8832-4d3d-4782-833a-236983bbf7b2" providerId="ADAL" clId="{73B0631D-FD37-44B5-B6A2-152E3460FC52}" dt="2024-01-20T16:53:33.631" v="181" actId="478"/>
          <ac:spMkLst>
            <pc:docMk/>
            <pc:sldMk cId="2004873951" sldId="256"/>
            <ac:spMk id="2605" creationId="{96AAE413-4AA5-AC33-BFA5-08810E1D7620}"/>
          </ac:spMkLst>
        </pc:spChg>
        <pc:spChg chg="del">
          <ac:chgData name="CARLOS COSTAS INSUA" userId="e10c8832-4d3d-4782-833a-236983bbf7b2" providerId="ADAL" clId="{73B0631D-FD37-44B5-B6A2-152E3460FC52}" dt="2024-01-20T16:53:33.631" v="181" actId="478"/>
          <ac:spMkLst>
            <pc:docMk/>
            <pc:sldMk cId="2004873951" sldId="256"/>
            <ac:spMk id="2606" creationId="{89C092FB-9971-36EC-498E-8E1F3C62B4CF}"/>
          </ac:spMkLst>
        </pc:spChg>
        <pc:spChg chg="del">
          <ac:chgData name="CARLOS COSTAS INSUA" userId="e10c8832-4d3d-4782-833a-236983bbf7b2" providerId="ADAL" clId="{73B0631D-FD37-44B5-B6A2-152E3460FC52}" dt="2024-01-20T16:53:33.631" v="181" actId="478"/>
          <ac:spMkLst>
            <pc:docMk/>
            <pc:sldMk cId="2004873951" sldId="256"/>
            <ac:spMk id="2619" creationId="{A4B7E94F-C2E5-3139-922C-4566DE95CDA0}"/>
          </ac:spMkLst>
        </pc:spChg>
        <pc:spChg chg="del">
          <ac:chgData name="CARLOS COSTAS INSUA" userId="e10c8832-4d3d-4782-833a-236983bbf7b2" providerId="ADAL" clId="{73B0631D-FD37-44B5-B6A2-152E3460FC52}" dt="2024-01-20T16:53:33.631" v="181" actId="478"/>
          <ac:spMkLst>
            <pc:docMk/>
            <pc:sldMk cId="2004873951" sldId="256"/>
            <ac:spMk id="2620" creationId="{0A7CE3A5-1640-E845-5B26-7768DC5E5F67}"/>
          </ac:spMkLst>
        </pc:spChg>
        <pc:spChg chg="del">
          <ac:chgData name="CARLOS COSTAS INSUA" userId="e10c8832-4d3d-4782-833a-236983bbf7b2" providerId="ADAL" clId="{73B0631D-FD37-44B5-B6A2-152E3460FC52}" dt="2024-01-20T16:51:46.809" v="145" actId="478"/>
          <ac:spMkLst>
            <pc:docMk/>
            <pc:sldMk cId="2004873951" sldId="256"/>
            <ac:spMk id="2630" creationId="{7AF5EF7A-B7E8-F2F8-551F-4FEE4E02024D}"/>
          </ac:spMkLst>
        </pc:spChg>
        <pc:spChg chg="del">
          <ac:chgData name="CARLOS COSTAS INSUA" userId="e10c8832-4d3d-4782-833a-236983bbf7b2" providerId="ADAL" clId="{73B0631D-FD37-44B5-B6A2-152E3460FC52}" dt="2024-01-20T16:51:46.809" v="145" actId="478"/>
          <ac:spMkLst>
            <pc:docMk/>
            <pc:sldMk cId="2004873951" sldId="256"/>
            <ac:spMk id="2631" creationId="{55BF0729-F50B-5644-68AE-30A7EF4C6AFB}"/>
          </ac:spMkLst>
        </pc:spChg>
        <pc:spChg chg="del">
          <ac:chgData name="CARLOS COSTAS INSUA" userId="e10c8832-4d3d-4782-833a-236983bbf7b2" providerId="ADAL" clId="{73B0631D-FD37-44B5-B6A2-152E3460FC52}" dt="2024-01-20T16:51:46.809" v="145" actId="478"/>
          <ac:spMkLst>
            <pc:docMk/>
            <pc:sldMk cId="2004873951" sldId="256"/>
            <ac:spMk id="2643" creationId="{F704E449-5841-C614-C262-A7216F1A08F7}"/>
          </ac:spMkLst>
        </pc:spChg>
        <pc:spChg chg="del">
          <ac:chgData name="CARLOS COSTAS INSUA" userId="e10c8832-4d3d-4782-833a-236983bbf7b2" providerId="ADAL" clId="{73B0631D-FD37-44B5-B6A2-152E3460FC52}" dt="2024-01-20T16:51:46.809" v="145" actId="478"/>
          <ac:spMkLst>
            <pc:docMk/>
            <pc:sldMk cId="2004873951" sldId="256"/>
            <ac:spMk id="2653" creationId="{D56B2F0B-2A7E-995E-138F-2BF6E63A4100}"/>
          </ac:spMkLst>
        </pc:spChg>
        <pc:spChg chg="del">
          <ac:chgData name="CARLOS COSTAS INSUA" userId="e10c8832-4d3d-4782-833a-236983bbf7b2" providerId="ADAL" clId="{73B0631D-FD37-44B5-B6A2-152E3460FC52}" dt="2024-01-20T16:51:46.809" v="145" actId="478"/>
          <ac:spMkLst>
            <pc:docMk/>
            <pc:sldMk cId="2004873951" sldId="256"/>
            <ac:spMk id="2654" creationId="{DB6799C3-8D22-C5B2-5635-1E5C1C108CDD}"/>
          </ac:spMkLst>
        </pc:spChg>
        <pc:spChg chg="del">
          <ac:chgData name="CARLOS COSTAS INSUA" userId="e10c8832-4d3d-4782-833a-236983bbf7b2" providerId="ADAL" clId="{73B0631D-FD37-44B5-B6A2-152E3460FC52}" dt="2024-01-20T16:51:46.809" v="145" actId="478"/>
          <ac:spMkLst>
            <pc:docMk/>
            <pc:sldMk cId="2004873951" sldId="256"/>
            <ac:spMk id="2657" creationId="{467BB8CB-B100-B73B-BC40-634A016026B9}"/>
          </ac:spMkLst>
        </pc:spChg>
        <pc:spChg chg="del">
          <ac:chgData name="CARLOS COSTAS INSUA" userId="e10c8832-4d3d-4782-833a-236983bbf7b2" providerId="ADAL" clId="{73B0631D-FD37-44B5-B6A2-152E3460FC52}" dt="2024-01-20T16:51:46.809" v="145" actId="478"/>
          <ac:spMkLst>
            <pc:docMk/>
            <pc:sldMk cId="2004873951" sldId="256"/>
            <ac:spMk id="2658" creationId="{2703FBF5-8FC8-D315-7B05-3E66DD813E97}"/>
          </ac:spMkLst>
        </pc:spChg>
        <pc:spChg chg="del">
          <ac:chgData name="CARLOS COSTAS INSUA" userId="e10c8832-4d3d-4782-833a-236983bbf7b2" providerId="ADAL" clId="{73B0631D-FD37-44B5-B6A2-152E3460FC52}" dt="2024-01-20T16:51:46.809" v="145" actId="478"/>
          <ac:spMkLst>
            <pc:docMk/>
            <pc:sldMk cId="2004873951" sldId="256"/>
            <ac:spMk id="2662" creationId="{496CC556-1278-9AC9-472E-1476C805A056}"/>
          </ac:spMkLst>
        </pc:spChg>
        <pc:spChg chg="del">
          <ac:chgData name="CARLOS COSTAS INSUA" userId="e10c8832-4d3d-4782-833a-236983bbf7b2" providerId="ADAL" clId="{73B0631D-FD37-44B5-B6A2-152E3460FC52}" dt="2024-01-20T16:51:46.809" v="145" actId="478"/>
          <ac:spMkLst>
            <pc:docMk/>
            <pc:sldMk cId="2004873951" sldId="256"/>
            <ac:spMk id="2672" creationId="{C6A3D622-EAFD-E2A1-76CC-DD713B6EED42}"/>
          </ac:spMkLst>
        </pc:spChg>
        <pc:spChg chg="del">
          <ac:chgData name="CARLOS COSTAS INSUA" userId="e10c8832-4d3d-4782-833a-236983bbf7b2" providerId="ADAL" clId="{73B0631D-FD37-44B5-B6A2-152E3460FC52}" dt="2024-01-20T16:51:46.809" v="145" actId="478"/>
          <ac:spMkLst>
            <pc:docMk/>
            <pc:sldMk cId="2004873951" sldId="256"/>
            <ac:spMk id="2673" creationId="{1872F854-537C-B2E0-2857-CCA61A30A3D3}"/>
          </ac:spMkLst>
        </pc:spChg>
        <pc:spChg chg="del">
          <ac:chgData name="CARLOS COSTAS INSUA" userId="e10c8832-4d3d-4782-833a-236983bbf7b2" providerId="ADAL" clId="{73B0631D-FD37-44B5-B6A2-152E3460FC52}" dt="2024-01-20T16:51:46.809" v="145" actId="478"/>
          <ac:spMkLst>
            <pc:docMk/>
            <pc:sldMk cId="2004873951" sldId="256"/>
            <ac:spMk id="2675" creationId="{87D140AC-5D34-F7A8-413B-1ECCACFD9F92}"/>
          </ac:spMkLst>
        </pc:spChg>
        <pc:spChg chg="del">
          <ac:chgData name="CARLOS COSTAS INSUA" userId="e10c8832-4d3d-4782-833a-236983bbf7b2" providerId="ADAL" clId="{73B0631D-FD37-44B5-B6A2-152E3460FC52}" dt="2024-01-20T16:51:46.809" v="145" actId="478"/>
          <ac:spMkLst>
            <pc:docMk/>
            <pc:sldMk cId="2004873951" sldId="256"/>
            <ac:spMk id="2676" creationId="{C0350B31-1C1B-55D4-7F27-1FDF39AC80E8}"/>
          </ac:spMkLst>
        </pc:spChg>
        <pc:spChg chg="del">
          <ac:chgData name="CARLOS COSTAS INSUA" userId="e10c8832-4d3d-4782-833a-236983bbf7b2" providerId="ADAL" clId="{73B0631D-FD37-44B5-B6A2-152E3460FC52}" dt="2024-01-20T16:51:46.809" v="145" actId="478"/>
          <ac:spMkLst>
            <pc:docMk/>
            <pc:sldMk cId="2004873951" sldId="256"/>
            <ac:spMk id="2691" creationId="{6F0CD617-F9A6-BF04-350C-916F13AFD145}"/>
          </ac:spMkLst>
        </pc:spChg>
        <pc:spChg chg="del">
          <ac:chgData name="CARLOS COSTAS INSUA" userId="e10c8832-4d3d-4782-833a-236983bbf7b2" providerId="ADAL" clId="{73B0631D-FD37-44B5-B6A2-152E3460FC52}" dt="2024-01-20T16:51:46.809" v="145" actId="478"/>
          <ac:spMkLst>
            <pc:docMk/>
            <pc:sldMk cId="2004873951" sldId="256"/>
            <ac:spMk id="2692" creationId="{FB4B3A03-BA5B-9E21-B851-F9BAD7D5260F}"/>
          </ac:spMkLst>
        </pc:spChg>
        <pc:grpChg chg="add del mod">
          <ac:chgData name="CARLOS COSTAS INSUA" userId="e10c8832-4d3d-4782-833a-236983bbf7b2" providerId="ADAL" clId="{73B0631D-FD37-44B5-B6A2-152E3460FC52}" dt="2024-01-20T16:50:37.352" v="94" actId="165"/>
          <ac:grpSpMkLst>
            <pc:docMk/>
            <pc:sldMk cId="2004873951" sldId="256"/>
            <ac:grpSpMk id="7" creationId="{AC420EF7-B103-757C-391B-70FE8FD1CA7E}"/>
          </ac:grpSpMkLst>
        </pc:grpChg>
        <pc:grpChg chg="add mod ord">
          <ac:chgData name="CARLOS COSTAS INSUA" userId="e10c8832-4d3d-4782-833a-236983bbf7b2" providerId="ADAL" clId="{73B0631D-FD37-44B5-B6A2-152E3460FC52}" dt="2024-01-20T16:49:08.206" v="83" actId="167"/>
          <ac:grpSpMkLst>
            <pc:docMk/>
            <pc:sldMk cId="2004873951" sldId="256"/>
            <ac:grpSpMk id="8" creationId="{0EA5F65C-EF2D-C720-F0A1-1EE734242075}"/>
          </ac:grpSpMkLst>
        </pc:grpChg>
        <pc:grpChg chg="mod">
          <ac:chgData name="CARLOS COSTAS INSUA" userId="e10c8832-4d3d-4782-833a-236983bbf7b2" providerId="ADAL" clId="{73B0631D-FD37-44B5-B6A2-152E3460FC52}" dt="2024-01-20T16:48:58.793" v="80"/>
          <ac:grpSpMkLst>
            <pc:docMk/>
            <pc:sldMk cId="2004873951" sldId="256"/>
            <ac:grpSpMk id="16" creationId="{D633F6BD-977A-E2D8-E2B5-AD76B9A9A452}"/>
          </ac:grpSpMkLst>
        </pc:grpChg>
        <pc:grpChg chg="mod">
          <ac:chgData name="CARLOS COSTAS INSUA" userId="e10c8832-4d3d-4782-833a-236983bbf7b2" providerId="ADAL" clId="{73B0631D-FD37-44B5-B6A2-152E3460FC52}" dt="2024-01-20T16:48:58.793" v="80"/>
          <ac:grpSpMkLst>
            <pc:docMk/>
            <pc:sldMk cId="2004873951" sldId="256"/>
            <ac:grpSpMk id="20" creationId="{A6F17EAB-BE5F-E35D-2170-8FF519FF9C10}"/>
          </ac:grpSpMkLst>
        </pc:grpChg>
        <pc:grpChg chg="mod topLvl">
          <ac:chgData name="CARLOS COSTAS INSUA" userId="e10c8832-4d3d-4782-833a-236983bbf7b2" providerId="ADAL" clId="{73B0631D-FD37-44B5-B6A2-152E3460FC52}" dt="2024-01-20T16:50:37.352" v="94" actId="165"/>
          <ac:grpSpMkLst>
            <pc:docMk/>
            <pc:sldMk cId="2004873951" sldId="256"/>
            <ac:grpSpMk id="2586" creationId="{57C35D29-D1FF-810D-43EC-7CCCD12B22C4}"/>
          </ac:grpSpMkLst>
        </pc:grpChg>
        <pc:grpChg chg="mod">
          <ac:chgData name="CARLOS COSTAS INSUA" userId="e10c8832-4d3d-4782-833a-236983bbf7b2" providerId="ADAL" clId="{73B0631D-FD37-44B5-B6A2-152E3460FC52}" dt="2024-01-20T16:50:37.352" v="94" actId="165"/>
          <ac:grpSpMkLst>
            <pc:docMk/>
            <pc:sldMk cId="2004873951" sldId="256"/>
            <ac:grpSpMk id="2587" creationId="{4C387F59-0650-B35B-6D8B-9681AE7B2ACF}"/>
          </ac:grpSpMkLst>
        </pc:grpChg>
        <pc:grpChg chg="del">
          <ac:chgData name="CARLOS COSTAS INSUA" userId="e10c8832-4d3d-4782-833a-236983bbf7b2" providerId="ADAL" clId="{73B0631D-FD37-44B5-B6A2-152E3460FC52}" dt="2024-01-20T16:53:33.631" v="181" actId="478"/>
          <ac:grpSpMkLst>
            <pc:docMk/>
            <pc:sldMk cId="2004873951" sldId="256"/>
            <ac:grpSpMk id="2607" creationId="{7EBC1A4B-0428-FE94-9515-C7351D7542B1}"/>
          </ac:grpSpMkLst>
        </pc:grpChg>
        <pc:grpChg chg="del">
          <ac:chgData name="CARLOS COSTAS INSUA" userId="e10c8832-4d3d-4782-833a-236983bbf7b2" providerId="ADAL" clId="{73B0631D-FD37-44B5-B6A2-152E3460FC52}" dt="2024-01-20T16:53:33.631" v="181" actId="478"/>
          <ac:grpSpMkLst>
            <pc:docMk/>
            <pc:sldMk cId="2004873951" sldId="256"/>
            <ac:grpSpMk id="2613" creationId="{C19D0571-6F25-BA50-94F2-8D17D467DFF0}"/>
          </ac:grpSpMkLst>
        </pc:grpChg>
        <pc:grpChg chg="del">
          <ac:chgData name="CARLOS COSTAS INSUA" userId="e10c8832-4d3d-4782-833a-236983bbf7b2" providerId="ADAL" clId="{73B0631D-FD37-44B5-B6A2-152E3460FC52}" dt="2024-01-20T16:51:46.809" v="145" actId="478"/>
          <ac:grpSpMkLst>
            <pc:docMk/>
            <pc:sldMk cId="2004873951" sldId="256"/>
            <ac:grpSpMk id="2636" creationId="{1F9E191C-778C-7B14-4229-081456194647}"/>
          </ac:grpSpMkLst>
        </pc:grpChg>
        <pc:grpChg chg="del">
          <ac:chgData name="CARLOS COSTAS INSUA" userId="e10c8832-4d3d-4782-833a-236983bbf7b2" providerId="ADAL" clId="{73B0631D-FD37-44B5-B6A2-152E3460FC52}" dt="2024-01-20T16:51:46.809" v="145" actId="478"/>
          <ac:grpSpMkLst>
            <pc:docMk/>
            <pc:sldMk cId="2004873951" sldId="256"/>
            <ac:grpSpMk id="2642" creationId="{64806836-AE34-423D-8778-6DBABD0331E9}"/>
          </ac:grpSpMkLst>
        </pc:grpChg>
        <pc:grpChg chg="del">
          <ac:chgData name="CARLOS COSTAS INSUA" userId="e10c8832-4d3d-4782-833a-236983bbf7b2" providerId="ADAL" clId="{73B0631D-FD37-44B5-B6A2-152E3460FC52}" dt="2024-01-20T16:51:46.809" v="145" actId="478"/>
          <ac:grpSpMkLst>
            <pc:docMk/>
            <pc:sldMk cId="2004873951" sldId="256"/>
            <ac:grpSpMk id="2659" creationId="{59E81DA0-A4E8-DA92-1536-0288735EE632}"/>
          </ac:grpSpMkLst>
        </pc:grpChg>
        <pc:grpChg chg="del">
          <ac:chgData name="CARLOS COSTAS INSUA" userId="e10c8832-4d3d-4782-833a-236983bbf7b2" providerId="ADAL" clId="{73B0631D-FD37-44B5-B6A2-152E3460FC52}" dt="2024-01-20T16:51:46.809" v="145" actId="478"/>
          <ac:grpSpMkLst>
            <pc:docMk/>
            <pc:sldMk cId="2004873951" sldId="256"/>
            <ac:grpSpMk id="2661" creationId="{268DA54E-C364-20F9-65C1-A15338664BE2}"/>
          </ac:grpSpMkLst>
        </pc:grpChg>
        <pc:grpChg chg="del">
          <ac:chgData name="CARLOS COSTAS INSUA" userId="e10c8832-4d3d-4782-833a-236983bbf7b2" providerId="ADAL" clId="{73B0631D-FD37-44B5-B6A2-152E3460FC52}" dt="2024-01-20T16:51:46.809" v="145" actId="478"/>
          <ac:grpSpMkLst>
            <pc:docMk/>
            <pc:sldMk cId="2004873951" sldId="256"/>
            <ac:grpSpMk id="2677" creationId="{22268DB4-2099-53D5-5C78-55E3E7A3877D}"/>
          </ac:grpSpMkLst>
        </pc:grpChg>
        <pc:grpChg chg="del">
          <ac:chgData name="CARLOS COSTAS INSUA" userId="e10c8832-4d3d-4782-833a-236983bbf7b2" providerId="ADAL" clId="{73B0631D-FD37-44B5-B6A2-152E3460FC52}" dt="2024-01-20T16:51:46.809" v="145" actId="478"/>
          <ac:grpSpMkLst>
            <pc:docMk/>
            <pc:sldMk cId="2004873951" sldId="256"/>
            <ac:grpSpMk id="2678" creationId="{A0F16AB6-C6D1-107F-E2CA-61E23E1C1BFA}"/>
          </ac:grpSpMkLst>
        </pc:grpChg>
        <pc:picChg chg="add del mod ord topLvl modCrop">
          <ac:chgData name="CARLOS COSTAS INSUA" userId="e10c8832-4d3d-4782-833a-236983bbf7b2" providerId="ADAL" clId="{73B0631D-FD37-44B5-B6A2-152E3460FC52}" dt="2024-01-20T16:52:58.114" v="153" actId="478"/>
          <ac:picMkLst>
            <pc:docMk/>
            <pc:sldMk cId="2004873951" sldId="256"/>
            <ac:picMk id="2" creationId="{8D61849B-A052-9C42-51F2-E1FF02FD70B9}"/>
          </ac:picMkLst>
        </pc:picChg>
        <pc:picChg chg="add del mod ord topLvl modCrop">
          <ac:chgData name="CARLOS COSTAS INSUA" userId="e10c8832-4d3d-4782-833a-236983bbf7b2" providerId="ADAL" clId="{73B0631D-FD37-44B5-B6A2-152E3460FC52}" dt="2024-01-20T16:50:54.306" v="99" actId="478"/>
          <ac:picMkLst>
            <pc:docMk/>
            <pc:sldMk cId="2004873951" sldId="256"/>
            <ac:picMk id="3" creationId="{21E0661D-A683-83A6-7FCC-18DFD3FD5C16}"/>
          </ac:picMkLst>
        </pc:picChg>
        <pc:picChg chg="add mod modCrop">
          <ac:chgData name="CARLOS COSTAS INSUA" userId="e10c8832-4d3d-4782-833a-236983bbf7b2" providerId="ADAL" clId="{73B0631D-FD37-44B5-B6A2-152E3460FC52}" dt="2024-01-20T16:51:10.795" v="102" actId="14100"/>
          <ac:picMkLst>
            <pc:docMk/>
            <pc:sldMk cId="2004873951" sldId="256"/>
            <ac:picMk id="4" creationId="{F4174E87-5A8F-6FDB-D478-F4E6EADCA5FD}"/>
          </ac:picMkLst>
        </pc:picChg>
        <pc:picChg chg="add mod modCrop">
          <ac:chgData name="CARLOS COSTAS INSUA" userId="e10c8832-4d3d-4782-833a-236983bbf7b2" providerId="ADAL" clId="{73B0631D-FD37-44B5-B6A2-152E3460FC52}" dt="2024-01-20T16:52:55.777" v="152" actId="552"/>
          <ac:picMkLst>
            <pc:docMk/>
            <pc:sldMk cId="2004873951" sldId="256"/>
            <ac:picMk id="5" creationId="{6E3FCCF2-483D-C2E0-CE9F-F22D7E0933EB}"/>
          </ac:picMkLst>
        </pc:picChg>
        <pc:picChg chg="mod">
          <ac:chgData name="CARLOS COSTAS INSUA" userId="e10c8832-4d3d-4782-833a-236983bbf7b2" providerId="ADAL" clId="{73B0631D-FD37-44B5-B6A2-152E3460FC52}" dt="2024-01-20T16:48:58.793" v="80"/>
          <ac:picMkLst>
            <pc:docMk/>
            <pc:sldMk cId="2004873951" sldId="256"/>
            <ac:picMk id="9" creationId="{A73EC47C-6762-3BCD-1E2C-CABD59027AC2}"/>
          </ac:picMkLst>
        </pc:picChg>
        <pc:picChg chg="mod">
          <ac:chgData name="CARLOS COSTAS INSUA" userId="e10c8832-4d3d-4782-833a-236983bbf7b2" providerId="ADAL" clId="{73B0631D-FD37-44B5-B6A2-152E3460FC52}" dt="2024-01-20T16:48:58.793" v="80"/>
          <ac:picMkLst>
            <pc:docMk/>
            <pc:sldMk cId="2004873951" sldId="256"/>
            <ac:picMk id="10" creationId="{D29A1802-3AA5-74FD-59C3-C0EDECCC5315}"/>
          </ac:picMkLst>
        </pc:picChg>
        <pc:picChg chg="del">
          <ac:chgData name="CARLOS COSTAS INSUA" userId="e10c8832-4d3d-4782-833a-236983bbf7b2" providerId="ADAL" clId="{73B0631D-FD37-44B5-B6A2-152E3460FC52}" dt="2024-01-20T16:51:46.809" v="145" actId="478"/>
          <ac:picMkLst>
            <pc:docMk/>
            <pc:sldMk cId="2004873951" sldId="256"/>
            <ac:picMk id="17" creationId="{3DB22280-92D9-B962-C01A-4358E8F29C5E}"/>
          </ac:picMkLst>
        </pc:picChg>
        <pc:picChg chg="del">
          <ac:chgData name="CARLOS COSTAS INSUA" userId="e10c8832-4d3d-4782-833a-236983bbf7b2" providerId="ADAL" clId="{73B0631D-FD37-44B5-B6A2-152E3460FC52}" dt="2024-01-20T16:51:46.809" v="145" actId="478"/>
          <ac:picMkLst>
            <pc:docMk/>
            <pc:sldMk cId="2004873951" sldId="256"/>
            <ac:picMk id="18" creationId="{A66167CB-8C7C-C2CF-B3AB-0C2510BA7943}"/>
          </ac:picMkLst>
        </pc:picChg>
        <pc:picChg chg="del">
          <ac:chgData name="CARLOS COSTAS INSUA" userId="e10c8832-4d3d-4782-833a-236983bbf7b2" providerId="ADAL" clId="{73B0631D-FD37-44B5-B6A2-152E3460FC52}" dt="2024-01-20T16:51:46.809" v="145" actId="478"/>
          <ac:picMkLst>
            <pc:docMk/>
            <pc:sldMk cId="2004873951" sldId="256"/>
            <ac:picMk id="33" creationId="{7D63F8BB-A658-C4DB-58B1-77FC174CCB48}"/>
          </ac:picMkLst>
        </pc:picChg>
        <pc:picChg chg="del">
          <ac:chgData name="CARLOS COSTAS INSUA" userId="e10c8832-4d3d-4782-833a-236983bbf7b2" providerId="ADAL" clId="{73B0631D-FD37-44B5-B6A2-152E3460FC52}" dt="2024-01-20T16:51:46.809" v="145" actId="478"/>
          <ac:picMkLst>
            <pc:docMk/>
            <pc:sldMk cId="2004873951" sldId="256"/>
            <ac:picMk id="34" creationId="{BA63CD44-373C-20CA-C7AA-4A5045B53656}"/>
          </ac:picMkLst>
        </pc:picChg>
        <pc:picChg chg="del">
          <ac:chgData name="CARLOS COSTAS INSUA" userId="e10c8832-4d3d-4782-833a-236983bbf7b2" providerId="ADAL" clId="{73B0631D-FD37-44B5-B6A2-152E3460FC52}" dt="2024-01-20T16:51:46.809" v="145" actId="478"/>
          <ac:picMkLst>
            <pc:docMk/>
            <pc:sldMk cId="2004873951" sldId="256"/>
            <ac:picMk id="45" creationId="{9EF28668-01BC-5FAB-6D52-4F0A45ABEBFB}"/>
          </ac:picMkLst>
        </pc:picChg>
        <pc:picChg chg="del">
          <ac:chgData name="CARLOS COSTAS INSUA" userId="e10c8832-4d3d-4782-833a-236983bbf7b2" providerId="ADAL" clId="{73B0631D-FD37-44B5-B6A2-152E3460FC52}" dt="2024-01-20T16:51:46.809" v="145" actId="478"/>
          <ac:picMkLst>
            <pc:docMk/>
            <pc:sldMk cId="2004873951" sldId="256"/>
            <ac:picMk id="46" creationId="{586F894F-5930-3A25-D848-A4388749E775}"/>
          </ac:picMkLst>
        </pc:picChg>
        <pc:picChg chg="del">
          <ac:chgData name="CARLOS COSTAS INSUA" userId="e10c8832-4d3d-4782-833a-236983bbf7b2" providerId="ADAL" clId="{73B0631D-FD37-44B5-B6A2-152E3460FC52}" dt="2024-01-20T16:49:18.559" v="87" actId="478"/>
          <ac:picMkLst>
            <pc:docMk/>
            <pc:sldMk cId="2004873951" sldId="256"/>
            <ac:picMk id="1351" creationId="{0F81475C-4A3C-28C2-02D3-B10CC2BBB61D}"/>
          </ac:picMkLst>
        </pc:picChg>
        <pc:picChg chg="del mod">
          <ac:chgData name="CARLOS COSTAS INSUA" userId="e10c8832-4d3d-4782-833a-236983bbf7b2" providerId="ADAL" clId="{73B0631D-FD37-44B5-B6A2-152E3460FC52}" dt="2024-01-20T16:49:09.809" v="84" actId="478"/>
          <ac:picMkLst>
            <pc:docMk/>
            <pc:sldMk cId="2004873951" sldId="256"/>
            <ac:picMk id="1352" creationId="{F85D98BE-1B3A-75F9-E3B9-39C277E3DF81}"/>
          </ac:picMkLst>
        </pc:picChg>
        <pc:picChg chg="del mod">
          <ac:chgData name="CARLOS COSTAS INSUA" userId="e10c8832-4d3d-4782-833a-236983bbf7b2" providerId="ADAL" clId="{73B0631D-FD37-44B5-B6A2-152E3460FC52}" dt="2024-01-20T16:47:26.871" v="66" actId="478"/>
          <ac:picMkLst>
            <pc:docMk/>
            <pc:sldMk cId="2004873951" sldId="256"/>
            <ac:picMk id="1358" creationId="{50853B11-EA30-FD77-3ACB-DEA6493CB3C3}"/>
          </ac:picMkLst>
        </pc:picChg>
        <pc:picChg chg="del mod">
          <ac:chgData name="CARLOS COSTAS INSUA" userId="e10c8832-4d3d-4782-833a-236983bbf7b2" providerId="ADAL" clId="{73B0631D-FD37-44B5-B6A2-152E3460FC52}" dt="2024-01-20T16:46:08.555" v="20" actId="478"/>
          <ac:picMkLst>
            <pc:docMk/>
            <pc:sldMk cId="2004873951" sldId="256"/>
            <ac:picMk id="1359" creationId="{9D5A8C4A-84A3-8884-6F30-4691B4EC8807}"/>
          </ac:picMkLst>
        </pc:picChg>
        <pc:picChg chg="del">
          <ac:chgData name="CARLOS COSTAS INSUA" userId="e10c8832-4d3d-4782-833a-236983bbf7b2" providerId="ADAL" clId="{73B0631D-FD37-44B5-B6A2-152E3460FC52}" dt="2024-01-20T16:53:33.631" v="181" actId="478"/>
          <ac:picMkLst>
            <pc:docMk/>
            <pc:sldMk cId="2004873951" sldId="256"/>
            <ac:picMk id="1369" creationId="{AC31266E-4B04-A579-18D7-FD68AC0CF89B}"/>
          </ac:picMkLst>
        </pc:picChg>
        <pc:picChg chg="del">
          <ac:chgData name="CARLOS COSTAS INSUA" userId="e10c8832-4d3d-4782-833a-236983bbf7b2" providerId="ADAL" clId="{73B0631D-FD37-44B5-B6A2-152E3460FC52}" dt="2024-01-20T16:53:33.631" v="181" actId="478"/>
          <ac:picMkLst>
            <pc:docMk/>
            <pc:sldMk cId="2004873951" sldId="256"/>
            <ac:picMk id="1370" creationId="{5153288B-942D-8F85-13F1-A0F325D759CE}"/>
          </ac:picMkLst>
        </pc:picChg>
      </pc:sldChg>
    </pc:docChg>
  </pc:docChgLst>
  <pc:docChgLst>
    <pc:chgData name="CARLOS COSTAS INSUA" userId="e10c8832-4d3d-4782-833a-236983bbf7b2" providerId="ADAL" clId="{40958B7F-DA56-4EE4-A142-34060A6C04EA}"/>
    <pc:docChg chg="undo redo custSel modSld">
      <pc:chgData name="CARLOS COSTAS INSUA" userId="e10c8832-4d3d-4782-833a-236983bbf7b2" providerId="ADAL" clId="{40958B7F-DA56-4EE4-A142-34060A6C04EA}" dt="2024-01-20T14:39:11.771" v="896"/>
      <pc:docMkLst>
        <pc:docMk/>
      </pc:docMkLst>
      <pc:sldChg chg="addSp delSp modSp mod">
        <pc:chgData name="CARLOS COSTAS INSUA" userId="e10c8832-4d3d-4782-833a-236983bbf7b2" providerId="ADAL" clId="{40958B7F-DA56-4EE4-A142-34060A6C04EA}" dt="2024-01-20T14:39:11.771" v="896"/>
        <pc:sldMkLst>
          <pc:docMk/>
          <pc:sldMk cId="2004873951" sldId="256"/>
        </pc:sldMkLst>
        <pc:spChg chg="add del mod">
          <ac:chgData name="CARLOS COSTAS INSUA" userId="e10c8832-4d3d-4782-833a-236983bbf7b2" providerId="ADAL" clId="{40958B7F-DA56-4EE4-A142-34060A6C04EA}" dt="2024-01-20T14:37:37.276" v="864" actId="478"/>
          <ac:spMkLst>
            <pc:docMk/>
            <pc:sldMk cId="2004873951" sldId="256"/>
            <ac:spMk id="2" creationId="{2C71B1AA-E397-1F8C-8A53-86DD1C7F6EA9}"/>
          </ac:spMkLst>
        </pc:spChg>
        <pc:spChg chg="add del mod">
          <ac:chgData name="CARLOS COSTAS INSUA" userId="e10c8832-4d3d-4782-833a-236983bbf7b2" providerId="ADAL" clId="{40958B7F-DA56-4EE4-A142-34060A6C04EA}" dt="2024-01-20T14:37:36.681" v="863" actId="478"/>
          <ac:spMkLst>
            <pc:docMk/>
            <pc:sldMk cId="2004873951" sldId="256"/>
            <ac:spMk id="3" creationId="{EF794BB6-CAC4-4C03-2D61-7D6E1BD16376}"/>
          </ac:spMkLst>
        </pc:spChg>
        <pc:spChg chg="add del mod">
          <ac:chgData name="CARLOS COSTAS INSUA" userId="e10c8832-4d3d-4782-833a-236983bbf7b2" providerId="ADAL" clId="{40958B7F-DA56-4EE4-A142-34060A6C04EA}" dt="2024-01-20T14:37:24.169" v="855" actId="478"/>
          <ac:spMkLst>
            <pc:docMk/>
            <pc:sldMk cId="2004873951" sldId="256"/>
            <ac:spMk id="4" creationId="{2A25668D-8E66-7FA0-58B0-2E2EF4EE1097}"/>
          </ac:spMkLst>
        </pc:spChg>
        <pc:spChg chg="add del mod">
          <ac:chgData name="CARLOS COSTAS INSUA" userId="e10c8832-4d3d-4782-833a-236983bbf7b2" providerId="ADAL" clId="{40958B7F-DA56-4EE4-A142-34060A6C04EA}" dt="2024-01-20T14:37:24.169" v="855" actId="478"/>
          <ac:spMkLst>
            <pc:docMk/>
            <pc:sldMk cId="2004873951" sldId="256"/>
            <ac:spMk id="5" creationId="{2FB33950-797B-C1A1-A064-3DA1FEF90389}"/>
          </ac:spMkLst>
        </pc:spChg>
        <pc:spChg chg="add del mod">
          <ac:chgData name="CARLOS COSTAS INSUA" userId="e10c8832-4d3d-4782-833a-236983bbf7b2" providerId="ADAL" clId="{40958B7F-DA56-4EE4-A142-34060A6C04EA}" dt="2024-01-20T14:34:38.071" v="729" actId="478"/>
          <ac:spMkLst>
            <pc:docMk/>
            <pc:sldMk cId="2004873951" sldId="256"/>
            <ac:spMk id="6" creationId="{5E46A9BF-968B-3903-9EA3-D40C90E6EE31}"/>
          </ac:spMkLst>
        </pc:spChg>
        <pc:spChg chg="add del mod">
          <ac:chgData name="CARLOS COSTAS INSUA" userId="e10c8832-4d3d-4782-833a-236983bbf7b2" providerId="ADAL" clId="{40958B7F-DA56-4EE4-A142-34060A6C04EA}" dt="2024-01-20T14:34:38.071" v="729" actId="478"/>
          <ac:spMkLst>
            <pc:docMk/>
            <pc:sldMk cId="2004873951" sldId="256"/>
            <ac:spMk id="7" creationId="{612E177B-14E3-F2EA-7BE8-6A007ADB1E42}"/>
          </ac:spMkLst>
        </pc:spChg>
        <pc:spChg chg="add del mod">
          <ac:chgData name="CARLOS COSTAS INSUA" userId="e10c8832-4d3d-4782-833a-236983bbf7b2" providerId="ADAL" clId="{40958B7F-DA56-4EE4-A142-34060A6C04EA}" dt="2024-01-20T14:34:38.071" v="729" actId="478"/>
          <ac:spMkLst>
            <pc:docMk/>
            <pc:sldMk cId="2004873951" sldId="256"/>
            <ac:spMk id="8" creationId="{653753E5-43CB-A883-D12A-7D7A88EE576B}"/>
          </ac:spMkLst>
        </pc:spChg>
        <pc:spChg chg="add del mod">
          <ac:chgData name="CARLOS COSTAS INSUA" userId="e10c8832-4d3d-4782-833a-236983bbf7b2" providerId="ADAL" clId="{40958B7F-DA56-4EE4-A142-34060A6C04EA}" dt="2024-01-20T14:34:38.071" v="729" actId="478"/>
          <ac:spMkLst>
            <pc:docMk/>
            <pc:sldMk cId="2004873951" sldId="256"/>
            <ac:spMk id="9" creationId="{A8DC8B1A-2CBF-8382-B0FB-76809FC4B499}"/>
          </ac:spMkLst>
        </pc:spChg>
        <pc:spChg chg="add del mod">
          <ac:chgData name="CARLOS COSTAS INSUA" userId="e10c8832-4d3d-4782-833a-236983bbf7b2" providerId="ADAL" clId="{40958B7F-DA56-4EE4-A142-34060A6C04EA}" dt="2024-01-20T14:34:38.071" v="729" actId="478"/>
          <ac:spMkLst>
            <pc:docMk/>
            <pc:sldMk cId="2004873951" sldId="256"/>
            <ac:spMk id="10" creationId="{9B7C1261-C359-6939-1253-4DA33FAB2073}"/>
          </ac:spMkLst>
        </pc:spChg>
        <pc:spChg chg="add del mod">
          <ac:chgData name="CARLOS COSTAS INSUA" userId="e10c8832-4d3d-4782-833a-236983bbf7b2" providerId="ADAL" clId="{40958B7F-DA56-4EE4-A142-34060A6C04EA}" dt="2024-01-20T14:34:38.071" v="729" actId="478"/>
          <ac:spMkLst>
            <pc:docMk/>
            <pc:sldMk cId="2004873951" sldId="256"/>
            <ac:spMk id="11" creationId="{D1CF47B4-AF08-FA07-FC03-D8E57363897B}"/>
          </ac:spMkLst>
        </pc:spChg>
        <pc:spChg chg="add del mod">
          <ac:chgData name="CARLOS COSTAS INSUA" userId="e10c8832-4d3d-4782-833a-236983bbf7b2" providerId="ADAL" clId="{40958B7F-DA56-4EE4-A142-34060A6C04EA}" dt="2024-01-20T14:28:49.666" v="422" actId="478"/>
          <ac:spMkLst>
            <pc:docMk/>
            <pc:sldMk cId="2004873951" sldId="256"/>
            <ac:spMk id="12" creationId="{5DAC5F70-64F8-12EF-EE54-3761215410E2}"/>
          </ac:spMkLst>
        </pc:spChg>
        <pc:spChg chg="add del mod">
          <ac:chgData name="CARLOS COSTAS INSUA" userId="e10c8832-4d3d-4782-833a-236983bbf7b2" providerId="ADAL" clId="{40958B7F-DA56-4EE4-A142-34060A6C04EA}" dt="2024-01-20T14:28:49.666" v="422" actId="478"/>
          <ac:spMkLst>
            <pc:docMk/>
            <pc:sldMk cId="2004873951" sldId="256"/>
            <ac:spMk id="13" creationId="{E6E663AB-26FB-4CBA-C8C7-B3057104C0E7}"/>
          </ac:spMkLst>
        </pc:spChg>
        <pc:spChg chg="add del mod">
          <ac:chgData name="CARLOS COSTAS INSUA" userId="e10c8832-4d3d-4782-833a-236983bbf7b2" providerId="ADAL" clId="{40958B7F-DA56-4EE4-A142-34060A6C04EA}" dt="2024-01-20T14:25:11.068" v="210" actId="478"/>
          <ac:spMkLst>
            <pc:docMk/>
            <pc:sldMk cId="2004873951" sldId="256"/>
            <ac:spMk id="14" creationId="{1D5405C8-D0C5-1273-EA17-F42F06642567}"/>
          </ac:spMkLst>
        </pc:spChg>
        <pc:spChg chg="add del mod">
          <ac:chgData name="CARLOS COSTAS INSUA" userId="e10c8832-4d3d-4782-833a-236983bbf7b2" providerId="ADAL" clId="{40958B7F-DA56-4EE4-A142-34060A6C04EA}" dt="2024-01-20T14:25:11.068" v="210" actId="478"/>
          <ac:spMkLst>
            <pc:docMk/>
            <pc:sldMk cId="2004873951" sldId="256"/>
            <ac:spMk id="15" creationId="{0DD24127-A8E9-25FD-361D-6C3946244D94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23" creationId="{348C231B-7DC9-29D5-E1A6-D90188B2632A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25" creationId="{159ED2EA-DD89-25C8-5C5C-EAEA323B5F12}"/>
          </ac:spMkLst>
        </pc:spChg>
        <pc:spChg chg="add del mod">
          <ac:chgData name="CARLOS COSTAS INSUA" userId="e10c8832-4d3d-4782-833a-236983bbf7b2" providerId="ADAL" clId="{40958B7F-DA56-4EE4-A142-34060A6C04EA}" dt="2024-01-20T14:34:38.071" v="729" actId="478"/>
          <ac:spMkLst>
            <pc:docMk/>
            <pc:sldMk cId="2004873951" sldId="256"/>
            <ac:spMk id="26" creationId="{E5F08BEA-C6F9-8CD4-B6B1-0FFFDA5E712F}"/>
          </ac:spMkLst>
        </pc:spChg>
        <pc:spChg chg="add del mod">
          <ac:chgData name="CARLOS COSTAS INSUA" userId="e10c8832-4d3d-4782-833a-236983bbf7b2" providerId="ADAL" clId="{40958B7F-DA56-4EE4-A142-34060A6C04EA}" dt="2024-01-20T14:34:38.071" v="729" actId="478"/>
          <ac:spMkLst>
            <pc:docMk/>
            <pc:sldMk cId="2004873951" sldId="256"/>
            <ac:spMk id="27" creationId="{499B5EE4-2F11-959E-2C7F-9E1D5550D60C}"/>
          </ac:spMkLst>
        </pc:spChg>
        <pc:spChg chg="del mod topLvl">
          <ac:chgData name="CARLOS COSTAS INSUA" userId="e10c8832-4d3d-4782-833a-236983bbf7b2" providerId="ADAL" clId="{40958B7F-DA56-4EE4-A142-34060A6C04EA}" dt="2024-01-20T14:34:38.071" v="729" actId="478"/>
          <ac:spMkLst>
            <pc:docMk/>
            <pc:sldMk cId="2004873951" sldId="256"/>
            <ac:spMk id="29" creationId="{CB312FDC-524A-0D67-4C68-E04B3C2893B5}"/>
          </ac:spMkLst>
        </pc:spChg>
        <pc:spChg chg="del mod topLvl">
          <ac:chgData name="CARLOS COSTAS INSUA" userId="e10c8832-4d3d-4782-833a-236983bbf7b2" providerId="ADAL" clId="{40958B7F-DA56-4EE4-A142-34060A6C04EA}" dt="2024-01-20T14:34:38.071" v="729" actId="478"/>
          <ac:spMkLst>
            <pc:docMk/>
            <pc:sldMk cId="2004873951" sldId="256"/>
            <ac:spMk id="30" creationId="{EC7E6800-6297-F163-335D-A5B27710DD4E}"/>
          </ac:spMkLst>
        </pc:spChg>
        <pc:spChg chg="add del mod">
          <ac:chgData name="CARLOS COSTAS INSUA" userId="e10c8832-4d3d-4782-833a-236983bbf7b2" providerId="ADAL" clId="{40958B7F-DA56-4EE4-A142-34060A6C04EA}" dt="2024-01-20T14:37:24.169" v="855" actId="478"/>
          <ac:spMkLst>
            <pc:docMk/>
            <pc:sldMk cId="2004873951" sldId="256"/>
            <ac:spMk id="31" creationId="{05F6987E-809A-C391-3D1A-F33981385AA7}"/>
          </ac:spMkLst>
        </pc:spChg>
        <pc:spChg chg="add del mod">
          <ac:chgData name="CARLOS COSTAS INSUA" userId="e10c8832-4d3d-4782-833a-236983bbf7b2" providerId="ADAL" clId="{40958B7F-DA56-4EE4-A142-34060A6C04EA}" dt="2024-01-20T14:37:24.169" v="855" actId="478"/>
          <ac:spMkLst>
            <pc:docMk/>
            <pc:sldMk cId="2004873951" sldId="256"/>
            <ac:spMk id="32" creationId="{5CF72C7A-EB7B-2219-8862-BD7D28A00B0A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39" creationId="{8C04BB50-078A-E23D-BED5-81BF08E7066B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41" creationId="{59FAD608-7DB9-9F0B-A17C-B91FC69A545F}"/>
          </ac:spMkLst>
        </pc:spChg>
        <pc:spChg chg="del mod topLvl">
          <ac:chgData name="CARLOS COSTAS INSUA" userId="e10c8832-4d3d-4782-833a-236983bbf7b2" providerId="ADAL" clId="{40958B7F-DA56-4EE4-A142-34060A6C04EA}" dt="2024-01-20T14:37:24.169" v="855" actId="478"/>
          <ac:spMkLst>
            <pc:docMk/>
            <pc:sldMk cId="2004873951" sldId="256"/>
            <ac:spMk id="43" creationId="{8AE3FA93-2546-6D3B-A1BF-F87B4403DAEF}"/>
          </ac:spMkLst>
        </pc:spChg>
        <pc:spChg chg="del mod topLvl">
          <ac:chgData name="CARLOS COSTAS INSUA" userId="e10c8832-4d3d-4782-833a-236983bbf7b2" providerId="ADAL" clId="{40958B7F-DA56-4EE4-A142-34060A6C04EA}" dt="2024-01-20T14:37:24.169" v="855" actId="478"/>
          <ac:spMkLst>
            <pc:docMk/>
            <pc:sldMk cId="2004873951" sldId="256"/>
            <ac:spMk id="44" creationId="{9C00CD40-CE09-51B6-584C-2D8FF443D7CF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51" creationId="{357BE29C-55D7-DF0B-FB30-3D3C68591656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53" creationId="{695AC0FF-873B-3C94-3DFF-B5D2BE258AB0}"/>
          </ac:spMkLst>
        </pc:spChg>
        <pc:spChg chg="add del mod">
          <ac:chgData name="CARLOS COSTAS INSUA" userId="e10c8832-4d3d-4782-833a-236983bbf7b2" providerId="ADAL" clId="{40958B7F-DA56-4EE4-A142-34060A6C04EA}" dt="2024-01-20T14:37:36.006" v="862" actId="478"/>
          <ac:spMkLst>
            <pc:docMk/>
            <pc:sldMk cId="2004873951" sldId="256"/>
            <ac:spMk id="54" creationId="{526982D1-9434-C419-D731-3D9EB32D1E38}"/>
          </ac:spMkLst>
        </pc:spChg>
        <pc:spChg chg="add del mod">
          <ac:chgData name="CARLOS COSTAS INSUA" userId="e10c8832-4d3d-4782-833a-236983bbf7b2" providerId="ADAL" clId="{40958B7F-DA56-4EE4-A142-34060A6C04EA}" dt="2024-01-20T14:37:35.552" v="861" actId="478"/>
          <ac:spMkLst>
            <pc:docMk/>
            <pc:sldMk cId="2004873951" sldId="256"/>
            <ac:spMk id="55" creationId="{BD977DDD-51AA-B35B-9093-160192825A93}"/>
          </ac:spMkLst>
        </pc:spChg>
        <pc:spChg chg="del mod topLvl">
          <ac:chgData name="CARLOS COSTAS INSUA" userId="e10c8832-4d3d-4782-833a-236983bbf7b2" providerId="ADAL" clId="{40958B7F-DA56-4EE4-A142-34060A6C04EA}" dt="2024-01-20T14:37:33.388" v="859" actId="478"/>
          <ac:spMkLst>
            <pc:docMk/>
            <pc:sldMk cId="2004873951" sldId="256"/>
            <ac:spMk id="57" creationId="{1FEE9440-8109-44C1-49AA-B9AE6973AF14}"/>
          </ac:spMkLst>
        </pc:spChg>
        <pc:spChg chg="del mod topLvl">
          <ac:chgData name="CARLOS COSTAS INSUA" userId="e10c8832-4d3d-4782-833a-236983bbf7b2" providerId="ADAL" clId="{40958B7F-DA56-4EE4-A142-34060A6C04EA}" dt="2024-01-20T14:37:32.086" v="857" actId="478"/>
          <ac:spMkLst>
            <pc:docMk/>
            <pc:sldMk cId="2004873951" sldId="256"/>
            <ac:spMk id="58" creationId="{40591AA1-CAEF-E63B-B396-E04BAEB3B6ED}"/>
          </ac:spMkLst>
        </pc:spChg>
        <pc:spChg chg="del mod topLvl">
          <ac:chgData name="CARLOS COSTAS INSUA" userId="e10c8832-4d3d-4782-833a-236983bbf7b2" providerId="ADAL" clId="{40958B7F-DA56-4EE4-A142-34060A6C04EA}" dt="2024-01-20T14:25:11.068" v="210" actId="478"/>
          <ac:spMkLst>
            <pc:docMk/>
            <pc:sldMk cId="2004873951" sldId="256"/>
            <ac:spMk id="63" creationId="{C7853316-1AA2-55D0-F177-8E8FBD1C508F}"/>
          </ac:spMkLst>
        </pc:spChg>
        <pc:spChg chg="del mod topLvl">
          <ac:chgData name="CARLOS COSTAS INSUA" userId="e10c8832-4d3d-4782-833a-236983bbf7b2" providerId="ADAL" clId="{40958B7F-DA56-4EE4-A142-34060A6C04EA}" dt="2024-01-20T14:25:11.068" v="210" actId="478"/>
          <ac:spMkLst>
            <pc:docMk/>
            <pc:sldMk cId="2004873951" sldId="256"/>
            <ac:spMk id="1344" creationId="{759D7D7C-030C-B069-5095-0C7484A9FED1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1348" creationId="{2D2949D0-AD0D-DDB9-3C8D-302EC695E589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1350" creationId="{FD3653DC-69DD-6EA5-9AAF-02B8018902D6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1356" creationId="{53130765-15E9-8CDD-4F3B-5C1335BC3966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1357" creationId="{016B685A-E68F-201E-F086-168C4FA49CB6}"/>
          </ac:spMkLst>
        </pc:spChg>
        <pc:spChg chg="mod topLvl">
          <ac:chgData name="CARLOS COSTAS INSUA" userId="e10c8832-4d3d-4782-833a-236983bbf7b2" providerId="ADAL" clId="{40958B7F-DA56-4EE4-A142-34060A6C04EA}" dt="2024-01-20T14:32:24.552" v="549" actId="6549"/>
          <ac:spMkLst>
            <pc:docMk/>
            <pc:sldMk cId="2004873951" sldId="256"/>
            <ac:spMk id="1362" creationId="{A0D1A375-D2D6-FD4A-6775-D426EC941C6A}"/>
          </ac:spMkLst>
        </pc:spChg>
        <pc:spChg chg="mod">
          <ac:chgData name="CARLOS COSTAS INSUA" userId="e10c8832-4d3d-4782-833a-236983bbf7b2" providerId="ADAL" clId="{40958B7F-DA56-4EE4-A142-34060A6C04EA}" dt="2024-01-20T14:25:20.579" v="212" actId="165"/>
          <ac:spMkLst>
            <pc:docMk/>
            <pc:sldMk cId="2004873951" sldId="256"/>
            <ac:spMk id="1365" creationId="{31BD9783-A05C-69B6-3524-72B476FE7A11}"/>
          </ac:spMkLst>
        </pc:spChg>
        <pc:spChg chg="mod">
          <ac:chgData name="CARLOS COSTAS INSUA" userId="e10c8832-4d3d-4782-833a-236983bbf7b2" providerId="ADAL" clId="{40958B7F-DA56-4EE4-A142-34060A6C04EA}" dt="2024-01-20T14:25:20.579" v="212" actId="165"/>
          <ac:spMkLst>
            <pc:docMk/>
            <pc:sldMk cId="2004873951" sldId="256"/>
            <ac:spMk id="1367" creationId="{F79F3130-9EA4-90D6-9438-C67FD42D2FC6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1373" creationId="{009B7F80-94E5-DF04-1D44-B355B678C5F5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1374" creationId="{FE47CF73-2800-018A-2C1B-622CACED35FF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1378" creationId="{1F44DE2C-5C08-CD2F-6AE5-938C5C6869B6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1380" creationId="{12DD9199-719E-85FE-16F6-6DD93CFBB2F3}"/>
          </ac:spMkLst>
        </pc:spChg>
        <pc:spChg chg="add del mod">
          <ac:chgData name="CARLOS COSTAS INSUA" userId="e10c8832-4d3d-4782-833a-236983bbf7b2" providerId="ADAL" clId="{40958B7F-DA56-4EE4-A142-34060A6C04EA}" dt="2024-01-20T14:25:11.068" v="210" actId="478"/>
          <ac:spMkLst>
            <pc:docMk/>
            <pc:sldMk cId="2004873951" sldId="256"/>
            <ac:spMk id="1381" creationId="{AF993CFE-DFA9-CFA5-36F9-B337FE131474}"/>
          </ac:spMkLst>
        </pc:spChg>
        <pc:spChg chg="add del mod">
          <ac:chgData name="CARLOS COSTAS INSUA" userId="e10c8832-4d3d-4782-833a-236983bbf7b2" providerId="ADAL" clId="{40958B7F-DA56-4EE4-A142-34060A6C04EA}" dt="2024-01-20T14:25:11.068" v="210" actId="478"/>
          <ac:spMkLst>
            <pc:docMk/>
            <pc:sldMk cId="2004873951" sldId="256"/>
            <ac:spMk id="1382" creationId="{20B94101-8610-8523-49CA-3407959E7F0B}"/>
          </ac:spMkLst>
        </pc:spChg>
        <pc:spChg chg="add del mod">
          <ac:chgData name="CARLOS COSTAS INSUA" userId="e10c8832-4d3d-4782-833a-236983bbf7b2" providerId="ADAL" clId="{40958B7F-DA56-4EE4-A142-34060A6C04EA}" dt="2024-01-20T14:28:49.666" v="422" actId="478"/>
          <ac:spMkLst>
            <pc:docMk/>
            <pc:sldMk cId="2004873951" sldId="256"/>
            <ac:spMk id="1383" creationId="{2EE1E162-DE4D-4AF8-E0C8-2ED1BC579133}"/>
          </ac:spMkLst>
        </pc:spChg>
        <pc:spChg chg="add del mod">
          <ac:chgData name="CARLOS COSTAS INSUA" userId="e10c8832-4d3d-4782-833a-236983bbf7b2" providerId="ADAL" clId="{40958B7F-DA56-4EE4-A142-34060A6C04EA}" dt="2024-01-20T14:28:49.666" v="422" actId="478"/>
          <ac:spMkLst>
            <pc:docMk/>
            <pc:sldMk cId="2004873951" sldId="256"/>
            <ac:spMk id="1384" creationId="{CF31FD31-571B-2FFB-A440-09F3C6FD7BAD}"/>
          </ac:spMkLst>
        </pc:spChg>
        <pc:spChg chg="add del mod">
          <ac:chgData name="CARLOS COSTAS INSUA" userId="e10c8832-4d3d-4782-833a-236983bbf7b2" providerId="ADAL" clId="{40958B7F-DA56-4EE4-A142-34060A6C04EA}" dt="2024-01-20T14:34:38.071" v="729" actId="478"/>
          <ac:spMkLst>
            <pc:docMk/>
            <pc:sldMk cId="2004873951" sldId="256"/>
            <ac:spMk id="1385" creationId="{75B947E1-8614-214D-478B-38EFCAE34D0E}"/>
          </ac:spMkLst>
        </pc:spChg>
        <pc:spChg chg="add del mod">
          <ac:chgData name="CARLOS COSTAS INSUA" userId="e10c8832-4d3d-4782-833a-236983bbf7b2" providerId="ADAL" clId="{40958B7F-DA56-4EE4-A142-34060A6C04EA}" dt="2024-01-20T14:38:40.219" v="888" actId="478"/>
          <ac:spMkLst>
            <pc:docMk/>
            <pc:sldMk cId="2004873951" sldId="256"/>
            <ac:spMk id="1386" creationId="{9FBA4717-F637-12BB-B63C-A05416604125}"/>
          </ac:spMkLst>
        </pc:spChg>
        <pc:spChg chg="mod">
          <ac:chgData name="CARLOS COSTAS INSUA" userId="e10c8832-4d3d-4782-833a-236983bbf7b2" providerId="ADAL" clId="{40958B7F-DA56-4EE4-A142-34060A6C04EA}" dt="2024-01-20T14:38:50.749" v="895" actId="14100"/>
          <ac:spMkLst>
            <pc:docMk/>
            <pc:sldMk cId="2004873951" sldId="256"/>
            <ac:spMk id="1754" creationId="{05907BE4-EAE5-6026-200F-8E7E984B2864}"/>
          </ac:spMkLst>
        </pc:spChg>
        <pc:spChg chg="mod topLvl">
          <ac:chgData name="CARLOS COSTAS INSUA" userId="e10c8832-4d3d-4782-833a-236983bbf7b2" providerId="ADAL" clId="{40958B7F-DA56-4EE4-A142-34060A6C04EA}" dt="2024-01-20T14:23:02.072" v="126" actId="1036"/>
          <ac:spMkLst>
            <pc:docMk/>
            <pc:sldMk cId="2004873951" sldId="256"/>
            <ac:spMk id="2547" creationId="{038B4F6E-AE7C-81EF-9B70-206B249496C9}"/>
          </ac:spMkLst>
        </pc:spChg>
        <pc:spChg chg="mod topLvl">
          <ac:chgData name="CARLOS COSTAS INSUA" userId="e10c8832-4d3d-4782-833a-236983bbf7b2" providerId="ADAL" clId="{40958B7F-DA56-4EE4-A142-34060A6C04EA}" dt="2024-01-20T14:24:12.727" v="176" actId="1037"/>
          <ac:spMkLst>
            <pc:docMk/>
            <pc:sldMk cId="2004873951" sldId="256"/>
            <ac:spMk id="2549" creationId="{02083E3C-1DC7-91D7-3870-E148BEA7D4D4}"/>
          </ac:spMkLst>
        </pc:spChg>
        <pc:spChg chg="mod topLvl">
          <ac:chgData name="CARLOS COSTAS INSUA" userId="e10c8832-4d3d-4782-833a-236983bbf7b2" providerId="ADAL" clId="{40958B7F-DA56-4EE4-A142-34060A6C04EA}" dt="2024-01-20T14:32:28.831" v="556" actId="20577"/>
          <ac:spMkLst>
            <pc:docMk/>
            <pc:sldMk cId="2004873951" sldId="256"/>
            <ac:spMk id="2553" creationId="{75DAD5D6-EE9B-3F86-4DB1-13AFD23F71BE}"/>
          </ac:spMkLst>
        </pc:spChg>
        <pc:spChg chg="mod topLvl">
          <ac:chgData name="CARLOS COSTAS INSUA" userId="e10c8832-4d3d-4782-833a-236983bbf7b2" providerId="ADAL" clId="{40958B7F-DA56-4EE4-A142-34060A6C04EA}" dt="2024-01-20T14:25:04.728" v="209" actId="555"/>
          <ac:spMkLst>
            <pc:docMk/>
            <pc:sldMk cId="2004873951" sldId="256"/>
            <ac:spMk id="2554" creationId="{B0CF2F16-ED7E-E99E-EFF7-B0615AC4E336}"/>
          </ac:spMkLst>
        </pc:spChg>
        <pc:spChg chg="mod topLvl">
          <ac:chgData name="CARLOS COSTAS INSUA" userId="e10c8832-4d3d-4782-833a-236983bbf7b2" providerId="ADAL" clId="{40958B7F-DA56-4EE4-A142-34060A6C04EA}" dt="2024-01-20T14:25:00.690" v="208" actId="555"/>
          <ac:spMkLst>
            <pc:docMk/>
            <pc:sldMk cId="2004873951" sldId="256"/>
            <ac:spMk id="2555" creationId="{743B99BA-D5E8-8BE3-28D3-1D1C7A4119F3}"/>
          </ac:spMkLst>
        </pc:spChg>
        <pc:spChg chg="mod topLvl">
          <ac:chgData name="CARLOS COSTAS INSUA" userId="e10c8832-4d3d-4782-833a-236983bbf7b2" providerId="ADAL" clId="{40958B7F-DA56-4EE4-A142-34060A6C04EA}" dt="2024-01-20T14:24:51.401" v="206" actId="555"/>
          <ac:spMkLst>
            <pc:docMk/>
            <pc:sldMk cId="2004873951" sldId="256"/>
            <ac:spMk id="2556" creationId="{A934634D-990D-C344-A2A4-F1B6656D0C5D}"/>
          </ac:spMkLst>
        </pc:spChg>
        <pc:spChg chg="mod topLvl">
          <ac:chgData name="CARLOS COSTAS INSUA" userId="e10c8832-4d3d-4782-833a-236983bbf7b2" providerId="ADAL" clId="{40958B7F-DA56-4EE4-A142-34060A6C04EA}" dt="2024-01-20T14:24:36.306" v="203" actId="165"/>
          <ac:spMkLst>
            <pc:docMk/>
            <pc:sldMk cId="2004873951" sldId="256"/>
            <ac:spMk id="2562" creationId="{964DE709-22DD-7CB7-AB8A-93AA6455A50E}"/>
          </ac:spMkLst>
        </pc:spChg>
        <pc:spChg chg="mod topLvl">
          <ac:chgData name="CARLOS COSTAS INSUA" userId="e10c8832-4d3d-4782-833a-236983bbf7b2" providerId="ADAL" clId="{40958B7F-DA56-4EE4-A142-34060A6C04EA}" dt="2024-01-20T14:24:39.994" v="204" actId="165"/>
          <ac:spMkLst>
            <pc:docMk/>
            <pc:sldMk cId="2004873951" sldId="256"/>
            <ac:spMk id="2566" creationId="{186620A4-910C-F2F2-E1C8-015FF2EF112A}"/>
          </ac:spMkLst>
        </pc:spChg>
        <pc:spChg chg="mod topLvl">
          <ac:chgData name="CARLOS COSTAS INSUA" userId="e10c8832-4d3d-4782-833a-236983bbf7b2" providerId="ADAL" clId="{40958B7F-DA56-4EE4-A142-34060A6C04EA}" dt="2024-01-20T14:25:04.728" v="209" actId="555"/>
          <ac:spMkLst>
            <pc:docMk/>
            <pc:sldMk cId="2004873951" sldId="256"/>
            <ac:spMk id="2567" creationId="{CF7D08F4-A638-CA13-4285-D0CEBB3F35E1}"/>
          </ac:spMkLst>
        </pc:spChg>
        <pc:spChg chg="mod topLvl">
          <ac:chgData name="CARLOS COSTAS INSUA" userId="e10c8832-4d3d-4782-833a-236983bbf7b2" providerId="ADAL" clId="{40958B7F-DA56-4EE4-A142-34060A6C04EA}" dt="2024-01-20T14:25:00.690" v="208" actId="555"/>
          <ac:spMkLst>
            <pc:docMk/>
            <pc:sldMk cId="2004873951" sldId="256"/>
            <ac:spMk id="2568" creationId="{292FE5CD-44B9-9B72-C209-7E2E81FABDD3}"/>
          </ac:spMkLst>
        </pc:spChg>
        <pc:spChg chg="mod topLvl">
          <ac:chgData name="CARLOS COSTAS INSUA" userId="e10c8832-4d3d-4782-833a-236983bbf7b2" providerId="ADAL" clId="{40958B7F-DA56-4EE4-A142-34060A6C04EA}" dt="2024-01-20T14:24:55.136" v="207" actId="165"/>
          <ac:spMkLst>
            <pc:docMk/>
            <pc:sldMk cId="2004873951" sldId="256"/>
            <ac:spMk id="2569" creationId="{84C7EB1B-7D89-7097-0E6C-D538858D6079}"/>
          </ac:spMkLst>
        </pc:spChg>
        <pc:spChg chg="mod">
          <ac:chgData name="CARLOS COSTAS INSUA" userId="e10c8832-4d3d-4782-833a-236983bbf7b2" providerId="ADAL" clId="{40958B7F-DA56-4EE4-A142-34060A6C04EA}" dt="2024-01-20T14:25:50.868" v="220" actId="165"/>
          <ac:spMkLst>
            <pc:docMk/>
            <pc:sldMk cId="2004873951" sldId="256"/>
            <ac:spMk id="2588" creationId="{2AAFC5FB-03C2-A03D-D872-95BAC81D0E90}"/>
          </ac:spMkLst>
        </pc:spChg>
        <pc:spChg chg="mod">
          <ac:chgData name="CARLOS COSTAS INSUA" userId="e10c8832-4d3d-4782-833a-236983bbf7b2" providerId="ADAL" clId="{40958B7F-DA56-4EE4-A142-34060A6C04EA}" dt="2024-01-20T14:27:05.720" v="305" actId="1036"/>
          <ac:spMkLst>
            <pc:docMk/>
            <pc:sldMk cId="2004873951" sldId="256"/>
            <ac:spMk id="2589" creationId="{69A5F5F9-9909-4AB1-673B-F17ADE2D31E0}"/>
          </ac:spMkLst>
        </pc:spChg>
        <pc:spChg chg="mod">
          <ac:chgData name="CARLOS COSTAS INSUA" userId="e10c8832-4d3d-4782-833a-236983bbf7b2" providerId="ADAL" clId="{40958B7F-DA56-4EE4-A142-34060A6C04EA}" dt="2024-01-20T14:27:01.104" v="292" actId="1036"/>
          <ac:spMkLst>
            <pc:docMk/>
            <pc:sldMk cId="2004873951" sldId="256"/>
            <ac:spMk id="2590" creationId="{955C66DD-20B7-16F6-92C6-50BF1E41AE2A}"/>
          </ac:spMkLst>
        </pc:spChg>
        <pc:spChg chg="mod">
          <ac:chgData name="CARLOS COSTAS INSUA" userId="e10c8832-4d3d-4782-833a-236983bbf7b2" providerId="ADAL" clId="{40958B7F-DA56-4EE4-A142-34060A6C04EA}" dt="2024-01-20T14:26:56.444" v="276" actId="1036"/>
          <ac:spMkLst>
            <pc:docMk/>
            <pc:sldMk cId="2004873951" sldId="256"/>
            <ac:spMk id="2591" creationId="{E8142825-92D4-605B-0680-E449FD1DEFD4}"/>
          </ac:spMkLst>
        </pc:spChg>
        <pc:spChg chg="mod topLvl">
          <ac:chgData name="CARLOS COSTAS INSUA" userId="e10c8832-4d3d-4782-833a-236983bbf7b2" providerId="ADAL" clId="{40958B7F-DA56-4EE4-A142-34060A6C04EA}" dt="2024-01-20T14:26:48.284" v="258" actId="1036"/>
          <ac:spMkLst>
            <pc:docMk/>
            <pc:sldMk cId="2004873951" sldId="256"/>
            <ac:spMk id="2595" creationId="{195849F1-B1C1-529B-BDD8-228619FBCA2A}"/>
          </ac:spMkLst>
        </pc:spChg>
        <pc:spChg chg="mod topLvl">
          <ac:chgData name="CARLOS COSTAS INSUA" userId="e10c8832-4d3d-4782-833a-236983bbf7b2" providerId="ADAL" clId="{40958B7F-DA56-4EE4-A142-34060A6C04EA}" dt="2024-01-20T14:32:33.601" v="563" actId="20577"/>
          <ac:spMkLst>
            <pc:docMk/>
            <pc:sldMk cId="2004873951" sldId="256"/>
            <ac:spMk id="2596" creationId="{3C216ABE-A851-E86F-B037-6EB1E7CEFF39}"/>
          </ac:spMkLst>
        </pc:spChg>
        <pc:spChg chg="mod topLvl">
          <ac:chgData name="CARLOS COSTAS INSUA" userId="e10c8832-4d3d-4782-833a-236983bbf7b2" providerId="ADAL" clId="{40958B7F-DA56-4EE4-A142-34060A6C04EA}" dt="2024-01-20T14:32:39.799" v="573" actId="6549"/>
          <ac:spMkLst>
            <pc:docMk/>
            <pc:sldMk cId="2004873951" sldId="256"/>
            <ac:spMk id="2597" creationId="{DA76FD5F-F405-DC69-14A8-32184A7CB30A}"/>
          </ac:spMkLst>
        </pc:spChg>
        <pc:spChg chg="mod topLvl">
          <ac:chgData name="CARLOS COSTAS INSUA" userId="e10c8832-4d3d-4782-833a-236983bbf7b2" providerId="ADAL" clId="{40958B7F-DA56-4EE4-A142-34060A6C04EA}" dt="2024-01-20T14:28:43.782" v="421" actId="1038"/>
          <ac:spMkLst>
            <pc:docMk/>
            <pc:sldMk cId="2004873951" sldId="256"/>
            <ac:spMk id="2598" creationId="{F50718BB-89B3-97AB-C202-F68A6539B4FB}"/>
          </ac:spMkLst>
        </pc:spChg>
        <pc:spChg chg="mod topLvl">
          <ac:chgData name="CARLOS COSTAS INSUA" userId="e10c8832-4d3d-4782-833a-236983bbf7b2" providerId="ADAL" clId="{40958B7F-DA56-4EE4-A142-34060A6C04EA}" dt="2024-01-20T14:28:20.899" v="381" actId="165"/>
          <ac:spMkLst>
            <pc:docMk/>
            <pc:sldMk cId="2004873951" sldId="256"/>
            <ac:spMk id="2601" creationId="{4418FFC3-B8DE-F623-2C47-DD22285BFE76}"/>
          </ac:spMkLst>
        </pc:spChg>
        <pc:spChg chg="mod topLvl">
          <ac:chgData name="CARLOS COSTAS INSUA" userId="e10c8832-4d3d-4782-833a-236983bbf7b2" providerId="ADAL" clId="{40958B7F-DA56-4EE4-A142-34060A6C04EA}" dt="2024-01-20T14:28:38.059" v="419" actId="1036"/>
          <ac:spMkLst>
            <pc:docMk/>
            <pc:sldMk cId="2004873951" sldId="256"/>
            <ac:spMk id="2602" creationId="{EF303AF1-73D3-D6EB-0E0D-E489EE393CD9}"/>
          </ac:spMkLst>
        </pc:spChg>
        <pc:spChg chg="mod topLvl">
          <ac:chgData name="CARLOS COSTAS INSUA" userId="e10c8832-4d3d-4782-833a-236983bbf7b2" providerId="ADAL" clId="{40958B7F-DA56-4EE4-A142-34060A6C04EA}" dt="2024-01-20T14:28:34.829" v="410" actId="1035"/>
          <ac:spMkLst>
            <pc:docMk/>
            <pc:sldMk cId="2004873951" sldId="256"/>
            <ac:spMk id="2603" creationId="{3121C709-7B7F-F4EA-2408-BDE4B9D21036}"/>
          </ac:spMkLst>
        </pc:spChg>
        <pc:spChg chg="mod topLvl">
          <ac:chgData name="CARLOS COSTAS INSUA" userId="e10c8832-4d3d-4782-833a-236983bbf7b2" providerId="ADAL" clId="{40958B7F-DA56-4EE4-A142-34060A6C04EA}" dt="2024-01-20T14:28:31.314" v="398" actId="1035"/>
          <ac:spMkLst>
            <pc:docMk/>
            <pc:sldMk cId="2004873951" sldId="256"/>
            <ac:spMk id="2604" creationId="{8AC20314-E187-32DF-9C4C-D8A97241CBBE}"/>
          </ac:spMkLst>
        </pc:spChg>
        <pc:spChg chg="mod topLvl">
          <ac:chgData name="CARLOS COSTAS INSUA" userId="e10c8832-4d3d-4782-833a-236983bbf7b2" providerId="ADAL" clId="{40958B7F-DA56-4EE4-A142-34060A6C04EA}" dt="2024-01-20T14:30:26.543" v="472" actId="1038"/>
          <ac:spMkLst>
            <pc:docMk/>
            <pc:sldMk cId="2004873951" sldId="256"/>
            <ac:spMk id="2605" creationId="{96AAE413-4AA5-AC33-BFA5-08810E1D7620}"/>
          </ac:spMkLst>
        </pc:spChg>
        <pc:spChg chg="mod topLvl">
          <ac:chgData name="CARLOS COSTAS INSUA" userId="e10c8832-4d3d-4782-833a-236983bbf7b2" providerId="ADAL" clId="{40958B7F-DA56-4EE4-A142-34060A6C04EA}" dt="2024-01-20T14:31:36.130" v="509" actId="1036"/>
          <ac:spMkLst>
            <pc:docMk/>
            <pc:sldMk cId="2004873951" sldId="256"/>
            <ac:spMk id="2606" creationId="{89C092FB-9971-36EC-498E-8E1F3C62B4CF}"/>
          </ac:spMkLst>
        </pc:spChg>
        <pc:spChg chg="mod">
          <ac:chgData name="CARLOS COSTAS INSUA" userId="e10c8832-4d3d-4782-833a-236983bbf7b2" providerId="ADAL" clId="{40958B7F-DA56-4EE4-A142-34060A6C04EA}" dt="2024-01-20T14:29:34.781" v="424" actId="165"/>
          <ac:spMkLst>
            <pc:docMk/>
            <pc:sldMk cId="2004873951" sldId="256"/>
            <ac:spMk id="2609" creationId="{61BE3052-B485-1610-03AF-A1995B48DCFF}"/>
          </ac:spMkLst>
        </pc:spChg>
        <pc:spChg chg="mod">
          <ac:chgData name="CARLOS COSTAS INSUA" userId="e10c8832-4d3d-4782-833a-236983bbf7b2" providerId="ADAL" clId="{40958B7F-DA56-4EE4-A142-34060A6C04EA}" dt="2024-01-20T14:29:34.781" v="424" actId="165"/>
          <ac:spMkLst>
            <pc:docMk/>
            <pc:sldMk cId="2004873951" sldId="256"/>
            <ac:spMk id="2610" creationId="{A3641947-9787-BE43-AFBD-16700B391F8E}"/>
          </ac:spMkLst>
        </pc:spChg>
        <pc:spChg chg="mod">
          <ac:chgData name="CARLOS COSTAS INSUA" userId="e10c8832-4d3d-4782-833a-236983bbf7b2" providerId="ADAL" clId="{40958B7F-DA56-4EE4-A142-34060A6C04EA}" dt="2024-01-20T14:29:34.781" v="424" actId="165"/>
          <ac:spMkLst>
            <pc:docMk/>
            <pc:sldMk cId="2004873951" sldId="256"/>
            <ac:spMk id="2611" creationId="{7C81E3A2-3E7B-236D-46BE-7458C8A58072}"/>
          </ac:spMkLst>
        </pc:spChg>
        <pc:spChg chg="mod">
          <ac:chgData name="CARLOS COSTAS INSUA" userId="e10c8832-4d3d-4782-833a-236983bbf7b2" providerId="ADAL" clId="{40958B7F-DA56-4EE4-A142-34060A6C04EA}" dt="2024-01-20T14:29:34.781" v="424" actId="165"/>
          <ac:spMkLst>
            <pc:docMk/>
            <pc:sldMk cId="2004873951" sldId="256"/>
            <ac:spMk id="2612" creationId="{5BDCF062-D6CD-D9B2-0D34-4F419E6C1456}"/>
          </ac:spMkLst>
        </pc:spChg>
        <pc:spChg chg="mod">
          <ac:chgData name="CARLOS COSTAS INSUA" userId="e10c8832-4d3d-4782-833a-236983bbf7b2" providerId="ADAL" clId="{40958B7F-DA56-4EE4-A142-34060A6C04EA}" dt="2024-01-20T14:29:34.781" v="424" actId="165"/>
          <ac:spMkLst>
            <pc:docMk/>
            <pc:sldMk cId="2004873951" sldId="256"/>
            <ac:spMk id="2615" creationId="{8420F2A8-9368-712C-2784-E38B3B313787}"/>
          </ac:spMkLst>
        </pc:spChg>
        <pc:spChg chg="mod">
          <ac:chgData name="CARLOS COSTAS INSUA" userId="e10c8832-4d3d-4782-833a-236983bbf7b2" providerId="ADAL" clId="{40958B7F-DA56-4EE4-A142-34060A6C04EA}" dt="2024-01-20T14:29:34.781" v="424" actId="165"/>
          <ac:spMkLst>
            <pc:docMk/>
            <pc:sldMk cId="2004873951" sldId="256"/>
            <ac:spMk id="2616" creationId="{DFC6E288-8BA8-CCD2-4FD7-51A15F2A9102}"/>
          </ac:spMkLst>
        </pc:spChg>
        <pc:spChg chg="mod">
          <ac:chgData name="CARLOS COSTAS INSUA" userId="e10c8832-4d3d-4782-833a-236983bbf7b2" providerId="ADAL" clId="{40958B7F-DA56-4EE4-A142-34060A6C04EA}" dt="2024-01-20T14:31:51.379" v="532" actId="1036"/>
          <ac:spMkLst>
            <pc:docMk/>
            <pc:sldMk cId="2004873951" sldId="256"/>
            <ac:spMk id="2617" creationId="{D7B62601-EA4D-2D38-EF19-DEF6655CF8AB}"/>
          </ac:spMkLst>
        </pc:spChg>
        <pc:spChg chg="mod">
          <ac:chgData name="CARLOS COSTAS INSUA" userId="e10c8832-4d3d-4782-833a-236983bbf7b2" providerId="ADAL" clId="{40958B7F-DA56-4EE4-A142-34060A6C04EA}" dt="2024-01-20T14:32:08.943" v="538" actId="1036"/>
          <ac:spMkLst>
            <pc:docMk/>
            <pc:sldMk cId="2004873951" sldId="256"/>
            <ac:spMk id="2618" creationId="{8077C167-0E79-3690-66C1-BBF75698FD6F}"/>
          </ac:spMkLst>
        </pc:spChg>
        <pc:spChg chg="mod topLvl">
          <ac:chgData name="CARLOS COSTAS INSUA" userId="e10c8832-4d3d-4782-833a-236983bbf7b2" providerId="ADAL" clId="{40958B7F-DA56-4EE4-A142-34060A6C04EA}" dt="2024-01-20T14:32:45.385" v="580" actId="6549"/>
          <ac:spMkLst>
            <pc:docMk/>
            <pc:sldMk cId="2004873951" sldId="256"/>
            <ac:spMk id="2619" creationId="{A4B7E94F-C2E5-3139-922C-4566DE95CDA0}"/>
          </ac:spMkLst>
        </pc:spChg>
        <pc:spChg chg="mod topLvl">
          <ac:chgData name="CARLOS COSTAS INSUA" userId="e10c8832-4d3d-4782-833a-236983bbf7b2" providerId="ADAL" clId="{40958B7F-DA56-4EE4-A142-34060A6C04EA}" dt="2024-01-20T14:32:49.699" v="588" actId="20577"/>
          <ac:spMkLst>
            <pc:docMk/>
            <pc:sldMk cId="2004873951" sldId="256"/>
            <ac:spMk id="2620" creationId="{0A7CE3A5-1640-E845-5B26-7768DC5E5F67}"/>
          </ac:spMkLst>
        </pc:spChg>
        <pc:spChg chg="mod">
          <ac:chgData name="CARLOS COSTAS INSUA" userId="e10c8832-4d3d-4782-833a-236983bbf7b2" providerId="ADAL" clId="{40958B7F-DA56-4EE4-A142-34060A6C04EA}" dt="2024-01-20T14:39:11.771" v="896"/>
          <ac:spMkLst>
            <pc:docMk/>
            <pc:sldMk cId="2004873951" sldId="256"/>
            <ac:spMk id="2630" creationId="{7AF5EF7A-B7E8-F2F8-551F-4FEE4E02024D}"/>
          </ac:spMkLst>
        </pc:spChg>
        <pc:spChg chg="mod">
          <ac:chgData name="CARLOS COSTAS INSUA" userId="e10c8832-4d3d-4782-833a-236983bbf7b2" providerId="ADAL" clId="{40958B7F-DA56-4EE4-A142-34060A6C04EA}" dt="2024-01-20T14:39:11.771" v="896"/>
          <ac:spMkLst>
            <pc:docMk/>
            <pc:sldMk cId="2004873951" sldId="256"/>
            <ac:spMk id="2631" creationId="{55BF0729-F50B-5644-68AE-30A7EF4C6AFB}"/>
          </ac:spMkLst>
        </pc:spChg>
        <pc:spChg chg="mod">
          <ac:chgData name="CARLOS COSTAS INSUA" userId="e10c8832-4d3d-4782-833a-236983bbf7b2" providerId="ADAL" clId="{40958B7F-DA56-4EE4-A142-34060A6C04EA}" dt="2024-01-20T14:34:26.765" v="728" actId="1037"/>
          <ac:spMkLst>
            <pc:docMk/>
            <pc:sldMk cId="2004873951" sldId="256"/>
            <ac:spMk id="2643" creationId="{F704E449-5841-C614-C262-A7216F1A08F7}"/>
          </ac:spMkLst>
        </pc:spChg>
        <pc:spChg chg="mod">
          <ac:chgData name="CARLOS COSTAS INSUA" userId="e10c8832-4d3d-4782-833a-236983bbf7b2" providerId="ADAL" clId="{40958B7F-DA56-4EE4-A142-34060A6C04EA}" dt="2024-01-20T14:32:01.666" v="535" actId="1036"/>
          <ac:spMkLst>
            <pc:docMk/>
            <pc:sldMk cId="2004873951" sldId="256"/>
            <ac:spMk id="2646" creationId="{9B7587DB-3D85-897A-E709-B2AE15127222}"/>
          </ac:spMkLst>
        </pc:spChg>
        <pc:spChg chg="mod">
          <ac:chgData name="CARLOS COSTAS INSUA" userId="e10c8832-4d3d-4782-833a-236983bbf7b2" providerId="ADAL" clId="{40958B7F-DA56-4EE4-A142-34060A6C04EA}" dt="2024-01-20T14:39:11.771" v="896"/>
          <ac:spMkLst>
            <pc:docMk/>
            <pc:sldMk cId="2004873951" sldId="256"/>
            <ac:spMk id="2653" creationId="{D56B2F0B-2A7E-995E-138F-2BF6E63A4100}"/>
          </ac:spMkLst>
        </pc:spChg>
        <pc:spChg chg="mod">
          <ac:chgData name="CARLOS COSTAS INSUA" userId="e10c8832-4d3d-4782-833a-236983bbf7b2" providerId="ADAL" clId="{40958B7F-DA56-4EE4-A142-34060A6C04EA}" dt="2024-01-20T14:39:11.771" v="896"/>
          <ac:spMkLst>
            <pc:docMk/>
            <pc:sldMk cId="2004873951" sldId="256"/>
            <ac:spMk id="2654" creationId="{DB6799C3-8D22-C5B2-5635-1E5C1C108CDD}"/>
          </ac:spMkLst>
        </pc:spChg>
        <pc:spChg chg="mod">
          <ac:chgData name="CARLOS COSTAS INSUA" userId="e10c8832-4d3d-4782-833a-236983bbf7b2" providerId="ADAL" clId="{40958B7F-DA56-4EE4-A142-34060A6C04EA}" dt="2024-01-20T14:37:15.253" v="854" actId="1037"/>
          <ac:spMkLst>
            <pc:docMk/>
            <pc:sldMk cId="2004873951" sldId="256"/>
            <ac:spMk id="2657" creationId="{467BB8CB-B100-B73B-BC40-634A016026B9}"/>
          </ac:spMkLst>
        </pc:spChg>
        <pc:spChg chg="mod">
          <ac:chgData name="CARLOS COSTAS INSUA" userId="e10c8832-4d3d-4782-833a-236983bbf7b2" providerId="ADAL" clId="{40958B7F-DA56-4EE4-A142-34060A6C04EA}" dt="2024-01-20T14:38:19.457" v="876" actId="1037"/>
          <ac:spMkLst>
            <pc:docMk/>
            <pc:sldMk cId="2004873951" sldId="256"/>
            <ac:spMk id="2658" creationId="{2703FBF5-8FC8-D315-7B05-3E66DD813E97}"/>
          </ac:spMkLst>
        </pc:spChg>
        <pc:spChg chg="mod">
          <ac:chgData name="CARLOS COSTAS INSUA" userId="e10c8832-4d3d-4782-833a-236983bbf7b2" providerId="ADAL" clId="{40958B7F-DA56-4EE4-A142-34060A6C04EA}" dt="2024-01-20T14:39:11.771" v="896"/>
          <ac:spMkLst>
            <pc:docMk/>
            <pc:sldMk cId="2004873951" sldId="256"/>
            <ac:spMk id="2672" creationId="{C6A3D622-EAFD-E2A1-76CC-DD713B6EED42}"/>
          </ac:spMkLst>
        </pc:spChg>
        <pc:spChg chg="mod">
          <ac:chgData name="CARLOS COSTAS INSUA" userId="e10c8832-4d3d-4782-833a-236983bbf7b2" providerId="ADAL" clId="{40958B7F-DA56-4EE4-A142-34060A6C04EA}" dt="2024-01-20T14:39:11.771" v="896"/>
          <ac:spMkLst>
            <pc:docMk/>
            <pc:sldMk cId="2004873951" sldId="256"/>
            <ac:spMk id="2673" creationId="{1872F854-537C-B2E0-2857-CCA61A30A3D3}"/>
          </ac:spMkLst>
        </pc:spChg>
        <pc:spChg chg="mod">
          <ac:chgData name="CARLOS COSTAS INSUA" userId="e10c8832-4d3d-4782-833a-236983bbf7b2" providerId="ADAL" clId="{40958B7F-DA56-4EE4-A142-34060A6C04EA}" dt="2024-01-20T14:35:19.610" v="765" actId="1038"/>
          <ac:spMkLst>
            <pc:docMk/>
            <pc:sldMk cId="2004873951" sldId="256"/>
            <ac:spMk id="2675" creationId="{87D140AC-5D34-F7A8-413B-1ECCACFD9F92}"/>
          </ac:spMkLst>
        </pc:spChg>
        <pc:spChg chg="mod">
          <ac:chgData name="CARLOS COSTAS INSUA" userId="e10c8832-4d3d-4782-833a-236983bbf7b2" providerId="ADAL" clId="{40958B7F-DA56-4EE4-A142-34060A6C04EA}" dt="2024-01-20T14:36:18.743" v="818" actId="1038"/>
          <ac:spMkLst>
            <pc:docMk/>
            <pc:sldMk cId="2004873951" sldId="256"/>
            <ac:spMk id="2676" creationId="{C0350B31-1C1B-55D4-7F27-1FDF39AC80E8}"/>
          </ac:spMkLst>
        </pc:spChg>
        <pc:spChg chg="mod">
          <ac:chgData name="CARLOS COSTAS INSUA" userId="e10c8832-4d3d-4782-833a-236983bbf7b2" providerId="ADAL" clId="{40958B7F-DA56-4EE4-A142-34060A6C04EA}" dt="2024-01-20T14:35:32.453" v="771" actId="1036"/>
          <ac:spMkLst>
            <pc:docMk/>
            <pc:sldMk cId="2004873951" sldId="256"/>
            <ac:spMk id="2681" creationId="{6E2A2BF0-846B-8A1F-DE8A-D4D93C954090}"/>
          </ac:spMkLst>
        </pc:spChg>
        <pc:spChg chg="mod">
          <ac:chgData name="CARLOS COSTAS INSUA" userId="e10c8832-4d3d-4782-833a-236983bbf7b2" providerId="ADAL" clId="{40958B7F-DA56-4EE4-A142-34060A6C04EA}" dt="2024-01-20T14:35:35.746" v="774" actId="1035"/>
          <ac:spMkLst>
            <pc:docMk/>
            <pc:sldMk cId="2004873951" sldId="256"/>
            <ac:spMk id="2682" creationId="{D7D41429-905F-3C4E-CDCB-9C68B5295CBD}"/>
          </ac:spMkLst>
        </pc:spChg>
        <pc:spChg chg="mod">
          <ac:chgData name="CARLOS COSTAS INSUA" userId="e10c8832-4d3d-4782-833a-236983bbf7b2" providerId="ADAL" clId="{40958B7F-DA56-4EE4-A142-34060A6C04EA}" dt="2024-01-20T14:35:39.983" v="781" actId="1036"/>
          <ac:spMkLst>
            <pc:docMk/>
            <pc:sldMk cId="2004873951" sldId="256"/>
            <ac:spMk id="2683" creationId="{AB1BF951-8731-00D9-1CFD-6E35E035979F}"/>
          </ac:spMkLst>
        </pc:spChg>
        <pc:spChg chg="mod">
          <ac:chgData name="CARLOS COSTAS INSUA" userId="e10c8832-4d3d-4782-833a-236983bbf7b2" providerId="ADAL" clId="{40958B7F-DA56-4EE4-A142-34060A6C04EA}" dt="2024-01-20T14:36:24.638" v="822" actId="1035"/>
          <ac:spMkLst>
            <pc:docMk/>
            <pc:sldMk cId="2004873951" sldId="256"/>
            <ac:spMk id="2686" creationId="{8DD956BB-263E-C512-1417-6C3FDF48809B}"/>
          </ac:spMkLst>
        </pc:spChg>
        <pc:spChg chg="mod">
          <ac:chgData name="CARLOS COSTAS INSUA" userId="e10c8832-4d3d-4782-833a-236983bbf7b2" providerId="ADAL" clId="{40958B7F-DA56-4EE4-A142-34060A6C04EA}" dt="2024-01-20T14:36:28.669" v="825" actId="1035"/>
          <ac:spMkLst>
            <pc:docMk/>
            <pc:sldMk cId="2004873951" sldId="256"/>
            <ac:spMk id="2687" creationId="{CF06C532-63DC-D1E7-E8EC-36121768DD24}"/>
          </ac:spMkLst>
        </pc:spChg>
        <pc:spChg chg="mod">
          <ac:chgData name="CARLOS COSTAS INSUA" userId="e10c8832-4d3d-4782-833a-236983bbf7b2" providerId="ADAL" clId="{40958B7F-DA56-4EE4-A142-34060A6C04EA}" dt="2024-01-20T14:36:31.837" v="829" actId="1035"/>
          <ac:spMkLst>
            <pc:docMk/>
            <pc:sldMk cId="2004873951" sldId="256"/>
            <ac:spMk id="2688" creationId="{E0CDE1CE-1367-7A35-8BB1-199AD3A540D4}"/>
          </ac:spMkLst>
        </pc:spChg>
        <pc:spChg chg="mod">
          <ac:chgData name="CARLOS COSTAS INSUA" userId="e10c8832-4d3d-4782-833a-236983bbf7b2" providerId="ADAL" clId="{40958B7F-DA56-4EE4-A142-34060A6C04EA}" dt="2024-01-20T14:33:26.146" v="641" actId="1038"/>
          <ac:spMkLst>
            <pc:docMk/>
            <pc:sldMk cId="2004873951" sldId="256"/>
            <ac:spMk id="2691" creationId="{6F0CD617-F9A6-BF04-350C-916F13AFD145}"/>
          </ac:spMkLst>
        </pc:spChg>
        <pc:spChg chg="mod">
          <ac:chgData name="CARLOS COSTAS INSUA" userId="e10c8832-4d3d-4782-833a-236983bbf7b2" providerId="ADAL" clId="{40958B7F-DA56-4EE4-A142-34060A6C04EA}" dt="2024-01-20T14:34:19.427" v="714" actId="1038"/>
          <ac:spMkLst>
            <pc:docMk/>
            <pc:sldMk cId="2004873951" sldId="256"/>
            <ac:spMk id="2692" creationId="{FB4B3A03-BA5B-9E21-B851-F9BAD7D5260F}"/>
          </ac:spMkLst>
        </pc:spChg>
        <pc:grpChg chg="add del mod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16" creationId="{8234951C-9E66-3BAF-E3D3-8F3E2D8CD224}"/>
          </ac:grpSpMkLst>
        </pc:grpChg>
        <pc:grpChg chg="add del mod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19" creationId="{3AEE05D3-6AE5-8EE1-E92A-E9C27573B1E0}"/>
          </ac:grpSpMkLst>
        </pc:grpChg>
        <pc:grpChg chg="del mod topLvl">
          <ac:chgData name="CARLOS COSTAS INSUA" userId="e10c8832-4d3d-4782-833a-236983bbf7b2" providerId="ADAL" clId="{40958B7F-DA56-4EE4-A142-34060A6C04EA}" dt="2024-01-20T14:34:38.071" v="729" actId="478"/>
          <ac:grpSpMkLst>
            <pc:docMk/>
            <pc:sldMk cId="2004873951" sldId="256"/>
            <ac:grpSpMk id="20" creationId="{4E61BFB6-126C-D815-1972-DF4A571B1D9F}"/>
          </ac:grpSpMkLst>
        </pc:grpChg>
        <pc:grpChg chg="del mod topLvl">
          <ac:chgData name="CARLOS COSTAS INSUA" userId="e10c8832-4d3d-4782-833a-236983bbf7b2" providerId="ADAL" clId="{40958B7F-DA56-4EE4-A142-34060A6C04EA}" dt="2024-01-20T14:34:38.071" v="729" actId="478"/>
          <ac:grpSpMkLst>
            <pc:docMk/>
            <pc:sldMk cId="2004873951" sldId="256"/>
            <ac:grpSpMk id="21" creationId="{14ED7738-5D48-D85E-9B57-2A77E0E4401A}"/>
          </ac:grpSpMkLst>
        </pc:grpChg>
        <pc:grpChg chg="add del mod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28" creationId="{1DE6E555-E2D3-D4C7-6E10-FBBAEFB2AA05}"/>
          </ac:grpSpMkLst>
        </pc:grpChg>
        <pc:grpChg chg="add del mod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35" creationId="{B93385A0-08B5-1C26-C736-3C28255F31D6}"/>
          </ac:grpSpMkLst>
        </pc:grpChg>
        <pc:grpChg chg="del mod topLvl">
          <ac:chgData name="CARLOS COSTAS INSUA" userId="e10c8832-4d3d-4782-833a-236983bbf7b2" providerId="ADAL" clId="{40958B7F-DA56-4EE4-A142-34060A6C04EA}" dt="2024-01-20T14:37:24.169" v="855" actId="478"/>
          <ac:grpSpMkLst>
            <pc:docMk/>
            <pc:sldMk cId="2004873951" sldId="256"/>
            <ac:grpSpMk id="36" creationId="{43282D52-E754-C526-59DD-34899990368C}"/>
          </ac:grpSpMkLst>
        </pc:grpChg>
        <pc:grpChg chg="del mod topLvl">
          <ac:chgData name="CARLOS COSTAS INSUA" userId="e10c8832-4d3d-4782-833a-236983bbf7b2" providerId="ADAL" clId="{40958B7F-DA56-4EE4-A142-34060A6C04EA}" dt="2024-01-20T14:37:24.169" v="855" actId="478"/>
          <ac:grpSpMkLst>
            <pc:docMk/>
            <pc:sldMk cId="2004873951" sldId="256"/>
            <ac:grpSpMk id="37" creationId="{8EC9E70D-71E1-1A72-9FB6-8A3D069762C1}"/>
          </ac:grpSpMkLst>
        </pc:grpChg>
        <pc:grpChg chg="add del mod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42" creationId="{342CB478-BE64-4677-4041-35992138E348}"/>
          </ac:grpSpMkLst>
        </pc:grpChg>
        <pc:grpChg chg="add del mod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47" creationId="{B0653FF1-1300-A010-6B5B-EC8DF32D81EB}"/>
          </ac:grpSpMkLst>
        </pc:grpChg>
        <pc:grpChg chg="del mod topLvl">
          <ac:chgData name="CARLOS COSTAS INSUA" userId="e10c8832-4d3d-4782-833a-236983bbf7b2" providerId="ADAL" clId="{40958B7F-DA56-4EE4-A142-34060A6C04EA}" dt="2024-01-20T14:37:34.690" v="860" actId="478"/>
          <ac:grpSpMkLst>
            <pc:docMk/>
            <pc:sldMk cId="2004873951" sldId="256"/>
            <ac:grpSpMk id="48" creationId="{7DB043D3-0E2B-A780-D9EE-8D1F4139EA8A}"/>
          </ac:grpSpMkLst>
        </pc:grpChg>
        <pc:grpChg chg="del mod topLvl">
          <ac:chgData name="CARLOS COSTAS INSUA" userId="e10c8832-4d3d-4782-833a-236983bbf7b2" providerId="ADAL" clId="{40958B7F-DA56-4EE4-A142-34060A6C04EA}" dt="2024-01-20T14:37:34.690" v="860" actId="478"/>
          <ac:grpSpMkLst>
            <pc:docMk/>
            <pc:sldMk cId="2004873951" sldId="256"/>
            <ac:grpSpMk id="49" creationId="{31DC2C17-C2D4-CE30-7A44-2221A9AC38DE}"/>
          </ac:grpSpMkLst>
        </pc:grpChg>
        <pc:grpChg chg="add del mod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56" creationId="{A9C644C3-C2C7-459E-90F5-ED826BE0259E}"/>
          </ac:grpSpMkLst>
        </pc:grpChg>
        <pc:grpChg chg="add del mod">
          <ac:chgData name="CARLOS COSTAS INSUA" userId="e10c8832-4d3d-4782-833a-236983bbf7b2" providerId="ADAL" clId="{40958B7F-DA56-4EE4-A142-34060A6C04EA}" dt="2024-01-20T14:21:22.591" v="15" actId="165"/>
          <ac:grpSpMkLst>
            <pc:docMk/>
            <pc:sldMk cId="2004873951" sldId="256"/>
            <ac:grpSpMk id="59" creationId="{8CD8BDF7-D2FB-EE48-AEAC-2726713232C0}"/>
          </ac:grpSpMkLst>
        </pc:grpChg>
        <pc:grpChg chg="del mod topLvl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60" creationId="{BCC6A28B-F7FF-17DE-E94C-00753FEB9B46}"/>
          </ac:grpSpMkLst>
        </pc:grpChg>
        <pc:grpChg chg="del mod topLvl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61" creationId="{6ED78C4F-238E-0839-62F9-1F924F648EFD}"/>
          </ac:grpSpMkLst>
        </pc:grpChg>
        <pc:grpChg chg="del mod topLvl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62" creationId="{18311EF0-D2DC-874D-7931-F3DD261DEC11}"/>
          </ac:grpSpMkLst>
        </pc:grpChg>
        <pc:grpChg chg="del mod topLvl">
          <ac:chgData name="CARLOS COSTAS INSUA" userId="e10c8832-4d3d-4782-833a-236983bbf7b2" providerId="ADAL" clId="{40958B7F-DA56-4EE4-A142-34060A6C04EA}" dt="2024-01-20T14:25:11.068" v="210" actId="478"/>
          <ac:grpSpMkLst>
            <pc:docMk/>
            <pc:sldMk cId="2004873951" sldId="256"/>
            <ac:grpSpMk id="1345" creationId="{532506CF-C808-B92A-A49E-6BA33B1F8EF3}"/>
          </ac:grpSpMkLst>
        </pc:grpChg>
        <pc:grpChg chg="del mod topLvl">
          <ac:chgData name="CARLOS COSTAS INSUA" userId="e10c8832-4d3d-4782-833a-236983bbf7b2" providerId="ADAL" clId="{40958B7F-DA56-4EE4-A142-34060A6C04EA}" dt="2024-01-20T14:25:11.068" v="210" actId="478"/>
          <ac:grpSpMkLst>
            <pc:docMk/>
            <pc:sldMk cId="2004873951" sldId="256"/>
            <ac:grpSpMk id="1346" creationId="{D1899FB3-5816-170E-058E-45ACC58F98B9}"/>
          </ac:grpSpMkLst>
        </pc:grpChg>
        <pc:grpChg chg="add del mod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1353" creationId="{C65AE276-87F5-6B19-0028-96EBD561493A}"/>
          </ac:grpSpMkLst>
        </pc:grpChg>
        <pc:grpChg chg="del mod topLvl">
          <ac:chgData name="CARLOS COSTAS INSUA" userId="e10c8832-4d3d-4782-833a-236983bbf7b2" providerId="ADAL" clId="{40958B7F-DA56-4EE4-A142-34060A6C04EA}" dt="2024-01-20T14:25:20.579" v="212" actId="165"/>
          <ac:grpSpMkLst>
            <pc:docMk/>
            <pc:sldMk cId="2004873951" sldId="256"/>
            <ac:grpSpMk id="1354" creationId="{459AC29F-CD8A-C8AB-619F-518795986C07}"/>
          </ac:grpSpMkLst>
        </pc:grpChg>
        <pc:grpChg chg="del mod topLvl">
          <ac:chgData name="CARLOS COSTAS INSUA" userId="e10c8832-4d3d-4782-833a-236983bbf7b2" providerId="ADAL" clId="{40958B7F-DA56-4EE4-A142-34060A6C04EA}" dt="2024-01-20T14:28:49.666" v="422" actId="478"/>
          <ac:grpSpMkLst>
            <pc:docMk/>
            <pc:sldMk cId="2004873951" sldId="256"/>
            <ac:grpSpMk id="1355" creationId="{76D11BAE-E76E-3D38-E940-4B829F15B9E3}"/>
          </ac:grpSpMkLst>
        </pc:grpChg>
        <pc:grpChg chg="del mod topLvl">
          <ac:chgData name="CARLOS COSTAS INSUA" userId="e10c8832-4d3d-4782-833a-236983bbf7b2" providerId="ADAL" clId="{40958B7F-DA56-4EE4-A142-34060A6C04EA}" dt="2024-01-20T14:28:49.666" v="422" actId="478"/>
          <ac:grpSpMkLst>
            <pc:docMk/>
            <pc:sldMk cId="2004873951" sldId="256"/>
            <ac:grpSpMk id="1360" creationId="{2D820C93-4113-879C-9AA1-6CB6E7D51423}"/>
          </ac:grpSpMkLst>
        </pc:grpChg>
        <pc:grpChg chg="mod">
          <ac:chgData name="CARLOS COSTAS INSUA" userId="e10c8832-4d3d-4782-833a-236983bbf7b2" providerId="ADAL" clId="{40958B7F-DA56-4EE4-A142-34060A6C04EA}" dt="2024-01-20T14:25:20.579" v="212" actId="165"/>
          <ac:grpSpMkLst>
            <pc:docMk/>
            <pc:sldMk cId="2004873951" sldId="256"/>
            <ac:grpSpMk id="1361" creationId="{EEF48A26-EAF0-6D73-FBCE-235E8067F129}"/>
          </ac:grpSpMkLst>
        </pc:grpChg>
        <pc:grpChg chg="mod">
          <ac:chgData name="CARLOS COSTAS INSUA" userId="e10c8832-4d3d-4782-833a-236983bbf7b2" providerId="ADAL" clId="{40958B7F-DA56-4EE4-A142-34060A6C04EA}" dt="2024-01-20T14:25:20.579" v="212" actId="165"/>
          <ac:grpSpMkLst>
            <pc:docMk/>
            <pc:sldMk cId="2004873951" sldId="256"/>
            <ac:grpSpMk id="1363" creationId="{74BBB631-C83A-807D-ED9C-5FE056BA6E60}"/>
          </ac:grpSpMkLst>
        </pc:grpChg>
        <pc:grpChg chg="add del mod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1368" creationId="{BDB4DF8A-3211-6630-61B9-A453457058F3}"/>
          </ac:grpSpMkLst>
        </pc:grpChg>
        <pc:grpChg chg="del mod topLvl">
          <ac:chgData name="CARLOS COSTAS INSUA" userId="e10c8832-4d3d-4782-833a-236983bbf7b2" providerId="ADAL" clId="{40958B7F-DA56-4EE4-A142-34060A6C04EA}" dt="2024-01-20T14:34:38.071" v="729" actId="478"/>
          <ac:grpSpMkLst>
            <pc:docMk/>
            <pc:sldMk cId="2004873951" sldId="256"/>
            <ac:grpSpMk id="1371" creationId="{06588A31-4FD3-5B8C-E545-AC88C77A98A3}"/>
          </ac:grpSpMkLst>
        </pc:grpChg>
        <pc:grpChg chg="del mod topLvl">
          <ac:chgData name="CARLOS COSTAS INSUA" userId="e10c8832-4d3d-4782-833a-236983bbf7b2" providerId="ADAL" clId="{40958B7F-DA56-4EE4-A142-34060A6C04EA}" dt="2024-01-20T14:34:38.071" v="729" actId="478"/>
          <ac:grpSpMkLst>
            <pc:docMk/>
            <pc:sldMk cId="2004873951" sldId="256"/>
            <ac:grpSpMk id="1372" creationId="{983B26E2-1067-BA7D-C3AC-25DBC26911B9}"/>
          </ac:grpSpMkLst>
        </pc:grpChg>
        <pc:grpChg chg="mod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1375" creationId="{D79D7326-9AC9-04F4-3F6D-AC683E76D89B}"/>
          </ac:grpSpMkLst>
        </pc:grpChg>
        <pc:grpChg chg="mod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1376" creationId="{49B6227D-ADDA-3691-D04E-2785EDBEBA6A}"/>
          </ac:grpSpMkLst>
        </pc:grpChg>
        <pc:grpChg chg="del mod topLvl">
          <ac:chgData name="CARLOS COSTAS INSUA" userId="e10c8832-4d3d-4782-833a-236983bbf7b2" providerId="ADAL" clId="{40958B7F-DA56-4EE4-A142-34060A6C04EA}" dt="2024-01-20T14:22:34.084" v="31" actId="478"/>
          <ac:grpSpMkLst>
            <pc:docMk/>
            <pc:sldMk cId="2004873951" sldId="256"/>
            <ac:grpSpMk id="2550" creationId="{FC84AB11-72A4-EE3C-BB97-20FBA4D091D3}"/>
          </ac:grpSpMkLst>
        </pc:grpChg>
        <pc:grpChg chg="del mod topLvl">
          <ac:chgData name="CARLOS COSTAS INSUA" userId="e10c8832-4d3d-4782-833a-236983bbf7b2" providerId="ADAL" clId="{40958B7F-DA56-4EE4-A142-34060A6C04EA}" dt="2024-01-20T14:23:56.203" v="133" actId="165"/>
          <ac:grpSpMkLst>
            <pc:docMk/>
            <pc:sldMk cId="2004873951" sldId="256"/>
            <ac:grpSpMk id="2551" creationId="{7B5CDF60-EF4A-5A38-2538-3D415957573B}"/>
          </ac:grpSpMkLst>
        </pc:grpChg>
        <pc:grpChg chg="del mod topLvl">
          <ac:chgData name="CARLOS COSTAS INSUA" userId="e10c8832-4d3d-4782-833a-236983bbf7b2" providerId="ADAL" clId="{40958B7F-DA56-4EE4-A142-34060A6C04EA}" dt="2024-01-20T14:24:45.377" v="205" actId="165"/>
          <ac:grpSpMkLst>
            <pc:docMk/>
            <pc:sldMk cId="2004873951" sldId="256"/>
            <ac:grpSpMk id="2557" creationId="{85D37F30-EFB2-3857-7DD5-F7FA8A37B3E0}"/>
          </ac:grpSpMkLst>
        </pc:grpChg>
        <pc:grpChg chg="del mod topLvl">
          <ac:chgData name="CARLOS COSTAS INSUA" userId="e10c8832-4d3d-4782-833a-236983bbf7b2" providerId="ADAL" clId="{40958B7F-DA56-4EE4-A142-34060A6C04EA}" dt="2024-01-20T14:24:36.306" v="203" actId="165"/>
          <ac:grpSpMkLst>
            <pc:docMk/>
            <pc:sldMk cId="2004873951" sldId="256"/>
            <ac:grpSpMk id="2563" creationId="{FF171540-32FD-1AC3-2370-E210FB1176C4}"/>
          </ac:grpSpMkLst>
        </pc:grpChg>
        <pc:grpChg chg="del mod topLvl">
          <ac:chgData name="CARLOS COSTAS INSUA" userId="e10c8832-4d3d-4782-833a-236983bbf7b2" providerId="ADAL" clId="{40958B7F-DA56-4EE4-A142-34060A6C04EA}" dt="2024-01-20T14:24:39.994" v="204" actId="165"/>
          <ac:grpSpMkLst>
            <pc:docMk/>
            <pc:sldMk cId="2004873951" sldId="256"/>
            <ac:grpSpMk id="2564" creationId="{BDEB5313-0316-D343-C3A1-5CECC5807C47}"/>
          </ac:grpSpMkLst>
        </pc:grpChg>
        <pc:grpChg chg="del mod topLvl">
          <ac:chgData name="CARLOS COSTAS INSUA" userId="e10c8832-4d3d-4782-833a-236983bbf7b2" providerId="ADAL" clId="{40958B7F-DA56-4EE4-A142-34060A6C04EA}" dt="2024-01-20T14:24:55.136" v="207" actId="165"/>
          <ac:grpSpMkLst>
            <pc:docMk/>
            <pc:sldMk cId="2004873951" sldId="256"/>
            <ac:grpSpMk id="2565" creationId="{93E59482-6BB1-7281-3E2D-8D49E1D07DD9}"/>
          </ac:grpSpMkLst>
        </pc:grpChg>
        <pc:grpChg chg="mod topLvl">
          <ac:chgData name="CARLOS COSTAS INSUA" userId="e10c8832-4d3d-4782-833a-236983bbf7b2" providerId="ADAL" clId="{40958B7F-DA56-4EE4-A142-34060A6C04EA}" dt="2024-01-20T14:28:15.833" v="380" actId="554"/>
          <ac:grpSpMkLst>
            <pc:docMk/>
            <pc:sldMk cId="2004873951" sldId="256"/>
            <ac:grpSpMk id="2586" creationId="{57C35D29-D1FF-810D-43EC-7CCCD12B22C4}"/>
          </ac:grpSpMkLst>
        </pc:grpChg>
        <pc:grpChg chg="mod">
          <ac:chgData name="CARLOS COSTAS INSUA" userId="e10c8832-4d3d-4782-833a-236983bbf7b2" providerId="ADAL" clId="{40958B7F-DA56-4EE4-A142-34060A6C04EA}" dt="2024-01-20T14:25:50.868" v="220" actId="165"/>
          <ac:grpSpMkLst>
            <pc:docMk/>
            <pc:sldMk cId="2004873951" sldId="256"/>
            <ac:grpSpMk id="2587" creationId="{4C387F59-0650-B35B-6D8B-9681AE7B2ACF}"/>
          </ac:grpSpMkLst>
        </pc:grpChg>
        <pc:grpChg chg="del mod topLvl">
          <ac:chgData name="CARLOS COSTAS INSUA" userId="e10c8832-4d3d-4782-833a-236983bbf7b2" providerId="ADAL" clId="{40958B7F-DA56-4EE4-A142-34060A6C04EA}" dt="2024-01-20T14:28:20.899" v="381" actId="165"/>
          <ac:grpSpMkLst>
            <pc:docMk/>
            <pc:sldMk cId="2004873951" sldId="256"/>
            <ac:grpSpMk id="2599" creationId="{49815D71-98D3-C6C4-4F92-FF1A58A6A9D9}"/>
          </ac:grpSpMkLst>
        </pc:grpChg>
        <pc:grpChg chg="del mod topLvl">
          <ac:chgData name="CARLOS COSTAS INSUA" userId="e10c8832-4d3d-4782-833a-236983bbf7b2" providerId="ADAL" clId="{40958B7F-DA56-4EE4-A142-34060A6C04EA}" dt="2024-01-20T14:28:24.505" v="382" actId="165"/>
          <ac:grpSpMkLst>
            <pc:docMk/>
            <pc:sldMk cId="2004873951" sldId="256"/>
            <ac:grpSpMk id="2600" creationId="{FE5F15FD-56F4-9BEF-8843-240E46D64B1F}"/>
          </ac:grpSpMkLst>
        </pc:grpChg>
        <pc:grpChg chg="mod topLvl">
          <ac:chgData name="CARLOS COSTAS INSUA" userId="e10c8832-4d3d-4782-833a-236983bbf7b2" providerId="ADAL" clId="{40958B7F-DA56-4EE4-A142-34060A6C04EA}" dt="2024-01-20T14:29:34.781" v="424" actId="165"/>
          <ac:grpSpMkLst>
            <pc:docMk/>
            <pc:sldMk cId="2004873951" sldId="256"/>
            <ac:grpSpMk id="2607" creationId="{7EBC1A4B-0428-FE94-9515-C7351D7542B1}"/>
          </ac:grpSpMkLst>
        </pc:grpChg>
        <pc:grpChg chg="mod">
          <ac:chgData name="CARLOS COSTAS INSUA" userId="e10c8832-4d3d-4782-833a-236983bbf7b2" providerId="ADAL" clId="{40958B7F-DA56-4EE4-A142-34060A6C04EA}" dt="2024-01-20T14:29:34.781" v="424" actId="165"/>
          <ac:grpSpMkLst>
            <pc:docMk/>
            <pc:sldMk cId="2004873951" sldId="256"/>
            <ac:grpSpMk id="2608" creationId="{8DD8EFFC-A6FB-BFB0-EA4C-D55ACECE8B1C}"/>
          </ac:grpSpMkLst>
        </pc:grpChg>
        <pc:grpChg chg="mod topLvl">
          <ac:chgData name="CARLOS COSTAS INSUA" userId="e10c8832-4d3d-4782-833a-236983bbf7b2" providerId="ADAL" clId="{40958B7F-DA56-4EE4-A142-34060A6C04EA}" dt="2024-01-20T14:29:34.781" v="424" actId="165"/>
          <ac:grpSpMkLst>
            <pc:docMk/>
            <pc:sldMk cId="2004873951" sldId="256"/>
            <ac:grpSpMk id="2613" creationId="{C19D0571-6F25-BA50-94F2-8D17D467DFF0}"/>
          </ac:grpSpMkLst>
        </pc:grpChg>
        <pc:grpChg chg="mod">
          <ac:chgData name="CARLOS COSTAS INSUA" userId="e10c8832-4d3d-4782-833a-236983bbf7b2" providerId="ADAL" clId="{40958B7F-DA56-4EE4-A142-34060A6C04EA}" dt="2024-01-20T14:29:34.781" v="424" actId="165"/>
          <ac:grpSpMkLst>
            <pc:docMk/>
            <pc:sldMk cId="2004873951" sldId="256"/>
            <ac:grpSpMk id="2614" creationId="{03020668-F3A2-7F2D-21DF-789BD0DE935D}"/>
          </ac:grpSpMkLst>
        </pc:grpChg>
        <pc:grpChg chg="del mod topLvl">
          <ac:chgData name="CARLOS COSTAS INSUA" userId="e10c8832-4d3d-4782-833a-236983bbf7b2" providerId="ADAL" clId="{40958B7F-DA56-4EE4-A142-34060A6C04EA}" dt="2024-01-20T14:22:20.955" v="27" actId="165"/>
          <ac:grpSpMkLst>
            <pc:docMk/>
            <pc:sldMk cId="2004873951" sldId="256"/>
            <ac:grpSpMk id="2621" creationId="{12EBCF4B-5CB0-05B6-1DBA-5A1E74467DDC}"/>
          </ac:grpSpMkLst>
        </pc:grpChg>
        <pc:grpChg chg="del mod topLvl">
          <ac:chgData name="CARLOS COSTAS INSUA" userId="e10c8832-4d3d-4782-833a-236983bbf7b2" providerId="ADAL" clId="{40958B7F-DA56-4EE4-A142-34060A6C04EA}" dt="2024-01-20T14:25:54.183" v="221" actId="165"/>
          <ac:grpSpMkLst>
            <pc:docMk/>
            <pc:sldMk cId="2004873951" sldId="256"/>
            <ac:grpSpMk id="2622" creationId="{0F07C9DB-CE01-4BD4-8E7B-77B0E59004F5}"/>
          </ac:grpSpMkLst>
        </pc:grpChg>
        <pc:grpChg chg="del mod topLvl">
          <ac:chgData name="CARLOS COSTAS INSUA" userId="e10c8832-4d3d-4782-833a-236983bbf7b2" providerId="ADAL" clId="{40958B7F-DA56-4EE4-A142-34060A6C04EA}" dt="2024-01-20T14:29:34.781" v="424" actId="165"/>
          <ac:grpSpMkLst>
            <pc:docMk/>
            <pc:sldMk cId="2004873951" sldId="256"/>
            <ac:grpSpMk id="2624" creationId="{428531C5-8514-BB15-8576-F7F78996766B}"/>
          </ac:grpSpMkLst>
        </pc:grpChg>
        <pc:grpChg chg="del">
          <ac:chgData name="CARLOS COSTAS INSUA" userId="e10c8832-4d3d-4782-833a-236983bbf7b2" providerId="ADAL" clId="{40958B7F-DA56-4EE4-A142-34060A6C04EA}" dt="2024-01-20T14:22:16.987" v="26" actId="165"/>
          <ac:grpSpMkLst>
            <pc:docMk/>
            <pc:sldMk cId="2004873951" sldId="256"/>
            <ac:grpSpMk id="2625" creationId="{7E63BD30-D8EB-04F6-62BE-93F7A244E192}"/>
          </ac:grpSpMkLst>
        </pc:grpChg>
        <pc:grpChg chg="del">
          <ac:chgData name="CARLOS COSTAS INSUA" userId="e10c8832-4d3d-4782-833a-236983bbf7b2" providerId="ADAL" clId="{40958B7F-DA56-4EE4-A142-34060A6C04EA}" dt="2024-01-20T14:25:50.868" v="220" actId="165"/>
          <ac:grpSpMkLst>
            <pc:docMk/>
            <pc:sldMk cId="2004873951" sldId="256"/>
            <ac:grpSpMk id="2627" creationId="{04F4D224-F2FF-7073-AFBE-7E3298D06F7B}"/>
          </ac:grpSpMkLst>
        </pc:grpChg>
        <pc:grpChg chg="del">
          <ac:chgData name="CARLOS COSTAS INSUA" userId="e10c8832-4d3d-4782-833a-236983bbf7b2" providerId="ADAL" clId="{40958B7F-DA56-4EE4-A142-34060A6C04EA}" dt="2024-01-20T14:29:31.522" v="423" actId="165"/>
          <ac:grpSpMkLst>
            <pc:docMk/>
            <pc:sldMk cId="2004873951" sldId="256"/>
            <ac:grpSpMk id="2628" creationId="{DCCEA666-25C0-7E68-2DFD-052C13259EC8}"/>
          </ac:grpSpMkLst>
        </pc:grpChg>
        <pc:grpChg chg="mod">
          <ac:chgData name="CARLOS COSTAS INSUA" userId="e10c8832-4d3d-4782-833a-236983bbf7b2" providerId="ADAL" clId="{40958B7F-DA56-4EE4-A142-34060A6C04EA}" dt="2024-01-20T14:33:36.642" v="662" actId="1037"/>
          <ac:grpSpMkLst>
            <pc:docMk/>
            <pc:sldMk cId="2004873951" sldId="256"/>
            <ac:grpSpMk id="2636" creationId="{1F9E191C-778C-7B14-4229-081456194647}"/>
          </ac:grpSpMkLst>
        </pc:grpChg>
        <pc:grpChg chg="mod">
          <ac:chgData name="CARLOS COSTAS INSUA" userId="e10c8832-4d3d-4782-833a-236983bbf7b2" providerId="ADAL" clId="{40958B7F-DA56-4EE4-A142-34060A6C04EA}" dt="2024-01-20T14:34:26.765" v="728" actId="1037"/>
          <ac:grpSpMkLst>
            <pc:docMk/>
            <pc:sldMk cId="2004873951" sldId="256"/>
            <ac:grpSpMk id="2642" creationId="{64806836-AE34-423D-8778-6DBABD0331E9}"/>
          </ac:grpSpMkLst>
        </pc:grpChg>
        <pc:grpChg chg="mod">
          <ac:chgData name="CARLOS COSTAS INSUA" userId="e10c8832-4d3d-4782-833a-236983bbf7b2" providerId="ADAL" clId="{40958B7F-DA56-4EE4-A142-34060A6C04EA}" dt="2024-01-20T14:38:37.255" v="887" actId="1035"/>
          <ac:grpSpMkLst>
            <pc:docMk/>
            <pc:sldMk cId="2004873951" sldId="256"/>
            <ac:grpSpMk id="2661" creationId="{268DA54E-C364-20F9-65C1-A15338664BE2}"/>
          </ac:grpSpMkLst>
        </pc:grpChg>
        <pc:picChg chg="mod ord topLvl modCrop">
          <ac:chgData name="CARLOS COSTAS INSUA" userId="e10c8832-4d3d-4782-833a-236983bbf7b2" providerId="ADAL" clId="{40958B7F-DA56-4EE4-A142-34060A6C04EA}" dt="2024-01-20T14:33:17.028" v="596" actId="167"/>
          <ac:picMkLst>
            <pc:docMk/>
            <pc:sldMk cId="2004873951" sldId="256"/>
            <ac:picMk id="17" creationId="{3DB22280-92D9-B962-C01A-4358E8F29C5E}"/>
          </ac:picMkLst>
        </pc:picChg>
        <pc:picChg chg="mod ord topLvl modCrop">
          <ac:chgData name="CARLOS COSTAS INSUA" userId="e10c8832-4d3d-4782-833a-236983bbf7b2" providerId="ADAL" clId="{40958B7F-DA56-4EE4-A142-34060A6C04EA}" dt="2024-01-20T14:34:10.836" v="670" actId="167"/>
          <ac:picMkLst>
            <pc:docMk/>
            <pc:sldMk cId="2004873951" sldId="256"/>
            <ac:picMk id="18" creationId="{A66167CB-8C7C-C2CF-B3AB-0C2510BA7943}"/>
          </ac:picMkLst>
        </pc:picChg>
        <pc:picChg chg="add mod ord modCrop">
          <ac:chgData name="CARLOS COSTAS INSUA" userId="e10c8832-4d3d-4782-833a-236983bbf7b2" providerId="ADAL" clId="{40958B7F-DA56-4EE4-A142-34060A6C04EA}" dt="2024-01-20T14:36:11.433" v="789" actId="167"/>
          <ac:picMkLst>
            <pc:docMk/>
            <pc:sldMk cId="2004873951" sldId="256"/>
            <ac:picMk id="33" creationId="{7D63F8BB-A658-C4DB-58B1-77FC174CCB48}"/>
          </ac:picMkLst>
        </pc:picChg>
        <pc:picChg chg="add mod ord modCrop">
          <ac:chgData name="CARLOS COSTAS INSUA" userId="e10c8832-4d3d-4782-833a-236983bbf7b2" providerId="ADAL" clId="{40958B7F-DA56-4EE4-A142-34060A6C04EA}" dt="2024-01-20T14:35:13.428" v="738" actId="167"/>
          <ac:picMkLst>
            <pc:docMk/>
            <pc:sldMk cId="2004873951" sldId="256"/>
            <ac:picMk id="34" creationId="{BA63CD44-373C-20CA-C7AA-4A5045B53656}"/>
          </ac:picMkLst>
        </pc:picChg>
        <pc:picChg chg="add mod ord modCrop">
          <ac:chgData name="CARLOS COSTAS INSUA" userId="e10c8832-4d3d-4782-833a-236983bbf7b2" providerId="ADAL" clId="{40958B7F-DA56-4EE4-A142-34060A6C04EA}" dt="2024-01-20T14:38:12.731" v="873" actId="167"/>
          <ac:picMkLst>
            <pc:docMk/>
            <pc:sldMk cId="2004873951" sldId="256"/>
            <ac:picMk id="45" creationId="{9EF28668-01BC-5FAB-6D52-4F0A45ABEBFB}"/>
          </ac:picMkLst>
        </pc:picChg>
        <pc:picChg chg="add mod ord modCrop">
          <ac:chgData name="CARLOS COSTAS INSUA" userId="e10c8832-4d3d-4782-833a-236983bbf7b2" providerId="ADAL" clId="{40958B7F-DA56-4EE4-A142-34060A6C04EA}" dt="2024-01-20T14:37:08.977" v="838" actId="167"/>
          <ac:picMkLst>
            <pc:docMk/>
            <pc:sldMk cId="2004873951" sldId="256"/>
            <ac:picMk id="46" creationId="{586F894F-5930-3A25-D848-A4388749E775}"/>
          </ac:picMkLst>
        </pc:picChg>
        <pc:picChg chg="del mod">
          <ac:chgData name="CARLOS COSTAS INSUA" userId="e10c8832-4d3d-4782-833a-236983bbf7b2" providerId="ADAL" clId="{40958B7F-DA56-4EE4-A142-34060A6C04EA}" dt="2024-01-20T14:34:12.876" v="671" actId="478"/>
          <ac:picMkLst>
            <pc:docMk/>
            <pc:sldMk cId="2004873951" sldId="256"/>
            <ac:picMk id="1276" creationId="{9AA9593A-01C5-86D4-0807-1F8D5A175024}"/>
          </ac:picMkLst>
        </pc:picChg>
        <pc:picChg chg="del mod">
          <ac:chgData name="CARLOS COSTAS INSUA" userId="e10c8832-4d3d-4782-833a-236983bbf7b2" providerId="ADAL" clId="{40958B7F-DA56-4EE4-A142-34060A6C04EA}" dt="2024-01-20T14:33:19.037" v="597" actId="478"/>
          <ac:picMkLst>
            <pc:docMk/>
            <pc:sldMk cId="2004873951" sldId="256"/>
            <ac:picMk id="1277" creationId="{A59613A2-F7EB-6670-31BA-27BD5C1843F2}"/>
          </ac:picMkLst>
        </pc:picChg>
        <pc:picChg chg="mod ord topLvl modCrop">
          <ac:chgData name="CARLOS COSTAS INSUA" userId="e10c8832-4d3d-4782-833a-236983bbf7b2" providerId="ADAL" clId="{40958B7F-DA56-4EE4-A142-34060A6C04EA}" dt="2024-01-20T14:22:31.119" v="30" actId="167"/>
          <ac:picMkLst>
            <pc:docMk/>
            <pc:sldMk cId="2004873951" sldId="256"/>
            <ac:picMk id="1351" creationId="{0F81475C-4A3C-28C2-02D3-B10CC2BBB61D}"/>
          </ac:picMkLst>
        </pc:picChg>
        <pc:picChg chg="mod ord topLvl modCrop">
          <ac:chgData name="CARLOS COSTAS INSUA" userId="e10c8832-4d3d-4782-833a-236983bbf7b2" providerId="ADAL" clId="{40958B7F-DA56-4EE4-A142-34060A6C04EA}" dt="2024-01-20T14:24:04.239" v="136" actId="167"/>
          <ac:picMkLst>
            <pc:docMk/>
            <pc:sldMk cId="2004873951" sldId="256"/>
            <ac:picMk id="1352" creationId="{F85D98BE-1B3A-75F9-E3B9-39C277E3DF81}"/>
          </ac:picMkLst>
        </pc:picChg>
        <pc:picChg chg="mod ord topLvl modCrop">
          <ac:chgData name="CARLOS COSTAS INSUA" userId="e10c8832-4d3d-4782-833a-236983bbf7b2" providerId="ADAL" clId="{40958B7F-DA56-4EE4-A142-34060A6C04EA}" dt="2024-01-20T14:27:55.615" v="332" actId="167"/>
          <ac:picMkLst>
            <pc:docMk/>
            <pc:sldMk cId="2004873951" sldId="256"/>
            <ac:picMk id="1358" creationId="{50853B11-EA30-FD77-3ACB-DEA6493CB3C3}"/>
          </ac:picMkLst>
        </pc:picChg>
        <pc:picChg chg="mod ord topLvl modCrop">
          <ac:chgData name="CARLOS COSTAS INSUA" userId="e10c8832-4d3d-4782-833a-236983bbf7b2" providerId="ADAL" clId="{40958B7F-DA56-4EE4-A142-34060A6C04EA}" dt="2024-01-20T14:26:13.280" v="226" actId="167"/>
          <ac:picMkLst>
            <pc:docMk/>
            <pc:sldMk cId="2004873951" sldId="256"/>
            <ac:picMk id="1359" creationId="{9D5A8C4A-84A3-8884-6F30-4691B4EC8807}"/>
          </ac:picMkLst>
        </pc:picChg>
        <pc:picChg chg="mod ord topLvl modCrop">
          <ac:chgData name="CARLOS COSTAS INSUA" userId="e10c8832-4d3d-4782-833a-236983bbf7b2" providerId="ADAL" clId="{40958B7F-DA56-4EE4-A142-34060A6C04EA}" dt="2024-01-20T14:31:21.552" v="479" actId="167"/>
          <ac:picMkLst>
            <pc:docMk/>
            <pc:sldMk cId="2004873951" sldId="256"/>
            <ac:picMk id="1369" creationId="{AC31266E-4B04-A579-18D7-FD68AC0CF89B}"/>
          </ac:picMkLst>
        </pc:picChg>
        <pc:picChg chg="mod ord topLvl modCrop">
          <ac:chgData name="CARLOS COSTAS INSUA" userId="e10c8832-4d3d-4782-833a-236983bbf7b2" providerId="ADAL" clId="{40958B7F-DA56-4EE4-A142-34060A6C04EA}" dt="2024-01-20T14:30:20.830" v="438" actId="1076"/>
          <ac:picMkLst>
            <pc:docMk/>
            <pc:sldMk cId="2004873951" sldId="256"/>
            <ac:picMk id="1370" creationId="{5153288B-942D-8F85-13F1-A0F325D759CE}"/>
          </ac:picMkLst>
        </pc:picChg>
        <pc:picChg chg="del mod">
          <ac:chgData name="CARLOS COSTAS INSUA" userId="e10c8832-4d3d-4782-833a-236983bbf7b2" providerId="ADAL" clId="{40958B7F-DA56-4EE4-A142-34060A6C04EA}" dt="2024-01-20T14:38:15.048" v="874" actId="478"/>
          <ac:picMkLst>
            <pc:docMk/>
            <pc:sldMk cId="2004873951" sldId="256"/>
            <ac:picMk id="1842" creationId="{200C4773-7BC4-3850-8779-A73114D1F8C8}"/>
          </ac:picMkLst>
        </pc:picChg>
        <pc:picChg chg="del mod">
          <ac:chgData name="CARLOS COSTAS INSUA" userId="e10c8832-4d3d-4782-833a-236983bbf7b2" providerId="ADAL" clId="{40958B7F-DA56-4EE4-A142-34060A6C04EA}" dt="2024-01-20T14:37:11.095" v="839" actId="478"/>
          <ac:picMkLst>
            <pc:docMk/>
            <pc:sldMk cId="2004873951" sldId="256"/>
            <ac:picMk id="1843" creationId="{2C7F9231-2A6B-1102-DA35-EAF77D70C792}"/>
          </ac:picMkLst>
        </pc:picChg>
        <pc:picChg chg="del mod">
          <ac:chgData name="CARLOS COSTAS INSUA" userId="e10c8832-4d3d-4782-833a-236983bbf7b2" providerId="ADAL" clId="{40958B7F-DA56-4EE4-A142-34060A6C04EA}" dt="2024-01-20T14:36:14.195" v="790" actId="478"/>
          <ac:picMkLst>
            <pc:docMk/>
            <pc:sldMk cId="2004873951" sldId="256"/>
            <ac:picMk id="1902" creationId="{FD5CB626-8140-808F-A626-C7D5AA4D38E9}"/>
          </ac:picMkLst>
        </pc:picChg>
        <pc:picChg chg="del mod">
          <ac:chgData name="CARLOS COSTAS INSUA" userId="e10c8832-4d3d-4782-833a-236983bbf7b2" providerId="ADAL" clId="{40958B7F-DA56-4EE4-A142-34060A6C04EA}" dt="2024-01-20T14:35:15.766" v="739" actId="478"/>
          <ac:picMkLst>
            <pc:docMk/>
            <pc:sldMk cId="2004873951" sldId="256"/>
            <ac:picMk id="1903" creationId="{73D01273-A618-9FBA-4125-F00CB8784806}"/>
          </ac:picMkLst>
        </pc:picChg>
        <pc:picChg chg="del mod topLvl">
          <ac:chgData name="CARLOS COSTAS INSUA" userId="e10c8832-4d3d-4782-833a-236983bbf7b2" providerId="ADAL" clId="{40958B7F-DA56-4EE4-A142-34060A6C04EA}" dt="2024-01-20T14:31:23.452" v="480" actId="478"/>
          <ac:picMkLst>
            <pc:docMk/>
            <pc:sldMk cId="2004873951" sldId="256"/>
            <ac:picMk id="2014" creationId="{A78E13CF-1788-408E-674D-1E5B5078A223}"/>
          </ac:picMkLst>
        </pc:picChg>
        <pc:picChg chg="del mod topLvl">
          <ac:chgData name="CARLOS COSTAS INSUA" userId="e10c8832-4d3d-4782-833a-236983bbf7b2" providerId="ADAL" clId="{40958B7F-DA56-4EE4-A142-34060A6C04EA}" dt="2024-01-20T14:30:15.087" v="436" actId="478"/>
          <ac:picMkLst>
            <pc:docMk/>
            <pc:sldMk cId="2004873951" sldId="256"/>
            <ac:picMk id="2015" creationId="{06D18087-46F9-9C3E-A5C0-434D55DCF02D}"/>
          </ac:picMkLst>
        </pc:picChg>
        <pc:picChg chg="del mod topLvl">
          <ac:chgData name="CARLOS COSTAS INSUA" userId="e10c8832-4d3d-4782-833a-236983bbf7b2" providerId="ADAL" clId="{40958B7F-DA56-4EE4-A142-34060A6C04EA}" dt="2024-01-20T14:22:34.084" v="31" actId="478"/>
          <ac:picMkLst>
            <pc:docMk/>
            <pc:sldMk cId="2004873951" sldId="256"/>
            <ac:picMk id="2546" creationId="{7B76D1BB-904C-0F50-FCDF-FAD01C223EC3}"/>
          </ac:picMkLst>
        </pc:picChg>
        <pc:picChg chg="del mod topLvl">
          <ac:chgData name="CARLOS COSTAS INSUA" userId="e10c8832-4d3d-4782-833a-236983bbf7b2" providerId="ADAL" clId="{40958B7F-DA56-4EE4-A142-34060A6C04EA}" dt="2024-01-20T14:24:06.278" v="137" actId="478"/>
          <ac:picMkLst>
            <pc:docMk/>
            <pc:sldMk cId="2004873951" sldId="256"/>
            <ac:picMk id="2548" creationId="{314494E4-2CD1-F029-B050-2BA6509C13B8}"/>
          </ac:picMkLst>
        </pc:picChg>
        <pc:picChg chg="del mod topLvl">
          <ac:chgData name="CARLOS COSTAS INSUA" userId="e10c8832-4d3d-4782-833a-236983bbf7b2" providerId="ADAL" clId="{40958B7F-DA56-4EE4-A142-34060A6C04EA}" dt="2024-01-20T14:26:38.111" v="227" actId="478"/>
          <ac:picMkLst>
            <pc:docMk/>
            <pc:sldMk cId="2004873951" sldId="256"/>
            <ac:picMk id="2583" creationId="{56028FBE-4ACE-25E6-DFF2-C93079F13C98}"/>
          </ac:picMkLst>
        </pc:picChg>
        <pc:picChg chg="del mod topLvl">
          <ac:chgData name="CARLOS COSTAS INSUA" userId="e10c8832-4d3d-4782-833a-236983bbf7b2" providerId="ADAL" clId="{40958B7F-DA56-4EE4-A142-34060A6C04EA}" dt="2024-01-20T14:27:57.860" v="333" actId="478"/>
          <ac:picMkLst>
            <pc:docMk/>
            <pc:sldMk cId="2004873951" sldId="256"/>
            <ac:picMk id="2593" creationId="{70BCB204-2788-EFE8-D077-CE305C51CBDF}"/>
          </ac:picMkLst>
        </pc:picChg>
        <pc:cxnChg chg="mod">
          <ac:chgData name="CARLOS COSTAS INSUA" userId="e10c8832-4d3d-4782-833a-236983bbf7b2" providerId="ADAL" clId="{40958B7F-DA56-4EE4-A142-34060A6C04EA}" dt="2024-01-20T14:21:29.740" v="16" actId="165"/>
          <ac:cxnSpMkLst>
            <pc:docMk/>
            <pc:sldMk cId="2004873951" sldId="256"/>
            <ac:cxnSpMk id="22" creationId="{C373B12E-9AD8-A46E-BA94-9211EB400949}"/>
          </ac:cxnSpMkLst>
        </pc:cxnChg>
        <pc:cxnChg chg="mod">
          <ac:chgData name="CARLOS COSTAS INSUA" userId="e10c8832-4d3d-4782-833a-236983bbf7b2" providerId="ADAL" clId="{40958B7F-DA56-4EE4-A142-34060A6C04EA}" dt="2024-01-20T14:21:29.740" v="16" actId="165"/>
          <ac:cxnSpMkLst>
            <pc:docMk/>
            <pc:sldMk cId="2004873951" sldId="256"/>
            <ac:cxnSpMk id="24" creationId="{607D0D74-4C7D-1D30-451D-DED8A3AD7441}"/>
          </ac:cxnSpMkLst>
        </pc:cxnChg>
        <pc:cxnChg chg="mod">
          <ac:chgData name="CARLOS COSTAS INSUA" userId="e10c8832-4d3d-4782-833a-236983bbf7b2" providerId="ADAL" clId="{40958B7F-DA56-4EE4-A142-34060A6C04EA}" dt="2024-01-20T14:21:29.740" v="16" actId="165"/>
          <ac:cxnSpMkLst>
            <pc:docMk/>
            <pc:sldMk cId="2004873951" sldId="256"/>
            <ac:cxnSpMk id="38" creationId="{16D19F64-7355-824F-79D5-93E474CA58DB}"/>
          </ac:cxnSpMkLst>
        </pc:cxnChg>
        <pc:cxnChg chg="mod">
          <ac:chgData name="CARLOS COSTAS INSUA" userId="e10c8832-4d3d-4782-833a-236983bbf7b2" providerId="ADAL" clId="{40958B7F-DA56-4EE4-A142-34060A6C04EA}" dt="2024-01-20T14:21:29.740" v="16" actId="165"/>
          <ac:cxnSpMkLst>
            <pc:docMk/>
            <pc:sldMk cId="2004873951" sldId="256"/>
            <ac:cxnSpMk id="40" creationId="{16E20311-E9E3-B8F4-C18A-3BC24A4255F6}"/>
          </ac:cxnSpMkLst>
        </pc:cxnChg>
        <pc:cxnChg chg="mod">
          <ac:chgData name="CARLOS COSTAS INSUA" userId="e10c8832-4d3d-4782-833a-236983bbf7b2" providerId="ADAL" clId="{40958B7F-DA56-4EE4-A142-34060A6C04EA}" dt="2024-01-20T14:21:29.740" v="16" actId="165"/>
          <ac:cxnSpMkLst>
            <pc:docMk/>
            <pc:sldMk cId="2004873951" sldId="256"/>
            <ac:cxnSpMk id="50" creationId="{9B125EA4-570C-4EA9-1D67-97367678987F}"/>
          </ac:cxnSpMkLst>
        </pc:cxnChg>
        <pc:cxnChg chg="mod">
          <ac:chgData name="CARLOS COSTAS INSUA" userId="e10c8832-4d3d-4782-833a-236983bbf7b2" providerId="ADAL" clId="{40958B7F-DA56-4EE4-A142-34060A6C04EA}" dt="2024-01-20T14:21:29.740" v="16" actId="165"/>
          <ac:cxnSpMkLst>
            <pc:docMk/>
            <pc:sldMk cId="2004873951" sldId="256"/>
            <ac:cxnSpMk id="52" creationId="{88CE68CA-D31B-F846-050F-F3DA654DC248}"/>
          </ac:cxnSpMkLst>
        </pc:cxnChg>
        <pc:cxnChg chg="mod">
          <ac:chgData name="CARLOS COSTAS INSUA" userId="e10c8832-4d3d-4782-833a-236983bbf7b2" providerId="ADAL" clId="{40958B7F-DA56-4EE4-A142-34060A6C04EA}" dt="2024-01-20T14:21:29.740" v="16" actId="165"/>
          <ac:cxnSpMkLst>
            <pc:docMk/>
            <pc:sldMk cId="2004873951" sldId="256"/>
            <ac:cxnSpMk id="1347" creationId="{9A3191C4-D4BF-31A8-EF0D-7D926E52033D}"/>
          </ac:cxnSpMkLst>
        </pc:cxnChg>
        <pc:cxnChg chg="mod">
          <ac:chgData name="CARLOS COSTAS INSUA" userId="e10c8832-4d3d-4782-833a-236983bbf7b2" providerId="ADAL" clId="{40958B7F-DA56-4EE4-A142-34060A6C04EA}" dt="2024-01-20T14:21:29.740" v="16" actId="165"/>
          <ac:cxnSpMkLst>
            <pc:docMk/>
            <pc:sldMk cId="2004873951" sldId="256"/>
            <ac:cxnSpMk id="1349" creationId="{E635BAF7-82FD-9BAF-8F2D-6B06365FC612}"/>
          </ac:cxnSpMkLst>
        </pc:cxnChg>
        <pc:cxnChg chg="mod">
          <ac:chgData name="CARLOS COSTAS INSUA" userId="e10c8832-4d3d-4782-833a-236983bbf7b2" providerId="ADAL" clId="{40958B7F-DA56-4EE4-A142-34060A6C04EA}" dt="2024-01-20T14:25:20.579" v="212" actId="165"/>
          <ac:cxnSpMkLst>
            <pc:docMk/>
            <pc:sldMk cId="2004873951" sldId="256"/>
            <ac:cxnSpMk id="1364" creationId="{B6AA2F71-E6E0-EA89-6053-8B5F287F63A0}"/>
          </ac:cxnSpMkLst>
        </pc:cxnChg>
        <pc:cxnChg chg="mod">
          <ac:chgData name="CARLOS COSTAS INSUA" userId="e10c8832-4d3d-4782-833a-236983bbf7b2" providerId="ADAL" clId="{40958B7F-DA56-4EE4-A142-34060A6C04EA}" dt="2024-01-20T14:25:20.579" v="212" actId="165"/>
          <ac:cxnSpMkLst>
            <pc:docMk/>
            <pc:sldMk cId="2004873951" sldId="256"/>
            <ac:cxnSpMk id="1366" creationId="{FC367B35-C563-7312-717A-CEE2EB7EB9EB}"/>
          </ac:cxnSpMkLst>
        </pc:cxnChg>
        <pc:cxnChg chg="mod">
          <ac:chgData name="CARLOS COSTAS INSUA" userId="e10c8832-4d3d-4782-833a-236983bbf7b2" providerId="ADAL" clId="{40958B7F-DA56-4EE4-A142-34060A6C04EA}" dt="2024-01-20T14:21:29.740" v="16" actId="165"/>
          <ac:cxnSpMkLst>
            <pc:docMk/>
            <pc:sldMk cId="2004873951" sldId="256"/>
            <ac:cxnSpMk id="1377" creationId="{205DC622-AE8B-4CBE-9AC1-EDDCEFA19491}"/>
          </ac:cxnSpMkLst>
        </pc:cxnChg>
        <pc:cxnChg chg="mod">
          <ac:chgData name="CARLOS COSTAS INSUA" userId="e10c8832-4d3d-4782-833a-236983bbf7b2" providerId="ADAL" clId="{40958B7F-DA56-4EE4-A142-34060A6C04EA}" dt="2024-01-20T14:21:29.740" v="16" actId="165"/>
          <ac:cxnSpMkLst>
            <pc:docMk/>
            <pc:sldMk cId="2004873951" sldId="256"/>
            <ac:cxnSpMk id="1379" creationId="{6AC2DAC2-5EAE-8D68-723A-791E2B80982E}"/>
          </ac:cxnSpMkLst>
        </pc:cxnChg>
        <pc:cxnChg chg="add del mod">
          <ac:chgData name="CARLOS COSTAS INSUA" userId="e10c8832-4d3d-4782-833a-236983bbf7b2" providerId="ADAL" clId="{40958B7F-DA56-4EE4-A142-34060A6C04EA}" dt="2024-01-20T14:21:19.026" v="14" actId="478"/>
          <ac:cxnSpMkLst>
            <pc:docMk/>
            <pc:sldMk cId="2004873951" sldId="256"/>
            <ac:cxnSpMk id="1387" creationId="{CA1F8A69-447B-97D7-ABC7-0747176EAC51}"/>
          </ac:cxnSpMkLst>
        </pc:cxnChg>
        <pc:cxnChg chg="add del mod">
          <ac:chgData name="CARLOS COSTAS INSUA" userId="e10c8832-4d3d-4782-833a-236983bbf7b2" providerId="ADAL" clId="{40958B7F-DA56-4EE4-A142-34060A6C04EA}" dt="2024-01-20T14:34:39.105" v="730" actId="478"/>
          <ac:cxnSpMkLst>
            <pc:docMk/>
            <pc:sldMk cId="2004873951" sldId="256"/>
            <ac:cxnSpMk id="1388" creationId="{F402F5A3-D931-1BEF-F83F-883D1F32B7FE}"/>
          </ac:cxnSpMkLst>
        </pc:cxnChg>
      </pc:sldChg>
    </pc:docChg>
  </pc:docChgLst>
  <pc:docChgLst>
    <pc:chgData name="CARLOS COSTAS INSUA" userId="e10c8832-4d3d-4782-833a-236983bbf7b2" providerId="ADAL" clId="{47E41604-0C7C-435B-A107-D9296C7C3701}"/>
    <pc:docChg chg="undo custSel modSld">
      <pc:chgData name="CARLOS COSTAS INSUA" userId="e10c8832-4d3d-4782-833a-236983bbf7b2" providerId="ADAL" clId="{47E41604-0C7C-435B-A107-D9296C7C3701}" dt="2024-01-20T17:49:01.114" v="129" actId="1076"/>
      <pc:docMkLst>
        <pc:docMk/>
      </pc:docMkLst>
      <pc:sldChg chg="addSp delSp modSp mod">
        <pc:chgData name="CARLOS COSTAS INSUA" userId="e10c8832-4d3d-4782-833a-236983bbf7b2" providerId="ADAL" clId="{47E41604-0C7C-435B-A107-D9296C7C3701}" dt="2024-01-20T17:49:01.114" v="129" actId="1076"/>
        <pc:sldMkLst>
          <pc:docMk/>
          <pc:sldMk cId="2004873951" sldId="256"/>
        </pc:sldMkLst>
        <pc:spChg chg="del">
          <ac:chgData name="CARLOS COSTAS INSUA" userId="e10c8832-4d3d-4782-833a-236983bbf7b2" providerId="ADAL" clId="{47E41604-0C7C-435B-A107-D9296C7C3701}" dt="2024-01-20T17:48:35.097" v="104" actId="478"/>
          <ac:spMkLst>
            <pc:docMk/>
            <pc:sldMk cId="2004873951" sldId="256"/>
            <ac:spMk id="6" creationId="{062AEB9E-797E-A12A-0F53-B288691E624C}"/>
          </ac:spMkLst>
        </pc:spChg>
        <pc:spChg chg="mod topLvl">
          <ac:chgData name="CARLOS COSTAS INSUA" userId="e10c8832-4d3d-4782-833a-236983bbf7b2" providerId="ADAL" clId="{47E41604-0C7C-435B-A107-D9296C7C3701}" dt="2024-01-20T17:44:35.285" v="14" actId="14100"/>
          <ac:spMkLst>
            <pc:docMk/>
            <pc:sldMk cId="2004873951" sldId="256"/>
            <ac:spMk id="11" creationId="{407C6F6A-5A2B-EDFD-B031-9CCC950236DB}"/>
          </ac:spMkLst>
        </pc:spChg>
        <pc:spChg chg="mod topLvl">
          <ac:chgData name="CARLOS COSTAS INSUA" userId="e10c8832-4d3d-4782-833a-236983bbf7b2" providerId="ADAL" clId="{47E41604-0C7C-435B-A107-D9296C7C3701}" dt="2024-01-20T17:45:50.343" v="64" actId="1037"/>
          <ac:spMkLst>
            <pc:docMk/>
            <pc:sldMk cId="2004873951" sldId="256"/>
            <ac:spMk id="12" creationId="{81F1C6DB-4FE9-14EF-C6C8-289969765A58}"/>
          </ac:spMkLst>
        </pc:spChg>
        <pc:spChg chg="mod topLvl">
          <ac:chgData name="CARLOS COSTAS INSUA" userId="e10c8832-4d3d-4782-833a-236983bbf7b2" providerId="ADAL" clId="{47E41604-0C7C-435B-A107-D9296C7C3701}" dt="2024-01-20T17:45:50.343" v="64" actId="1037"/>
          <ac:spMkLst>
            <pc:docMk/>
            <pc:sldMk cId="2004873951" sldId="256"/>
            <ac:spMk id="13" creationId="{F9F5E387-24BF-8EFB-7B1D-CC83678FEEDE}"/>
          </ac:spMkLst>
        </pc:spChg>
        <pc:spChg chg="mod topLvl">
          <ac:chgData name="CARLOS COSTAS INSUA" userId="e10c8832-4d3d-4782-833a-236983bbf7b2" providerId="ADAL" clId="{47E41604-0C7C-435B-A107-D9296C7C3701}" dt="2024-01-20T17:45:50.343" v="64" actId="1037"/>
          <ac:spMkLst>
            <pc:docMk/>
            <pc:sldMk cId="2004873951" sldId="256"/>
            <ac:spMk id="14" creationId="{99016635-A630-214E-F4FF-B9F22A5DC3E5}"/>
          </ac:spMkLst>
        </pc:spChg>
        <pc:spChg chg="mod topLvl">
          <ac:chgData name="CARLOS COSTAS INSUA" userId="e10c8832-4d3d-4782-833a-236983bbf7b2" providerId="ADAL" clId="{47E41604-0C7C-435B-A107-D9296C7C3701}" dt="2024-01-20T17:45:50.343" v="64" actId="1037"/>
          <ac:spMkLst>
            <pc:docMk/>
            <pc:sldMk cId="2004873951" sldId="256"/>
            <ac:spMk id="15" creationId="{AB7C22C8-F05F-E354-CA99-7D1B3EDFDD1D}"/>
          </ac:spMkLst>
        </pc:spChg>
        <pc:spChg chg="add mod">
          <ac:chgData name="CARLOS COSTAS INSUA" userId="e10c8832-4d3d-4782-833a-236983bbf7b2" providerId="ADAL" clId="{47E41604-0C7C-435B-A107-D9296C7C3701}" dt="2024-01-20T17:45:35.074" v="40" actId="1076"/>
          <ac:spMkLst>
            <pc:docMk/>
            <pc:sldMk cId="2004873951" sldId="256"/>
            <ac:spMk id="18" creationId="{5F284BA3-B96B-D9AC-C8DB-42FCE30123EA}"/>
          </ac:spMkLst>
        </pc:spChg>
        <pc:spChg chg="del mod topLvl">
          <ac:chgData name="CARLOS COSTAS INSUA" userId="e10c8832-4d3d-4782-833a-236983bbf7b2" providerId="ADAL" clId="{47E41604-0C7C-435B-A107-D9296C7C3701}" dt="2024-01-20T17:45:26.241" v="38" actId="478"/>
          <ac:spMkLst>
            <pc:docMk/>
            <pc:sldMk cId="2004873951" sldId="256"/>
            <ac:spMk id="19" creationId="{81F8EAA6-995A-294F-4081-14763EB80FBD}"/>
          </ac:spMkLst>
        </pc:spChg>
        <pc:spChg chg="mod">
          <ac:chgData name="CARLOS COSTAS INSUA" userId="e10c8832-4d3d-4782-833a-236983bbf7b2" providerId="ADAL" clId="{47E41604-0C7C-435B-A107-D9296C7C3701}" dt="2024-01-20T17:44:20.033" v="8" actId="165"/>
          <ac:spMkLst>
            <pc:docMk/>
            <pc:sldMk cId="2004873951" sldId="256"/>
            <ac:spMk id="21" creationId="{98E5F04E-1E86-5DC9-94AD-2F640FEB67D2}"/>
          </ac:spMkLst>
        </pc:spChg>
        <pc:spChg chg="mod">
          <ac:chgData name="CARLOS COSTAS INSUA" userId="e10c8832-4d3d-4782-833a-236983bbf7b2" providerId="ADAL" clId="{47E41604-0C7C-435B-A107-D9296C7C3701}" dt="2024-01-20T17:44:46.979" v="28" actId="1035"/>
          <ac:spMkLst>
            <pc:docMk/>
            <pc:sldMk cId="2004873951" sldId="256"/>
            <ac:spMk id="22" creationId="{59A133B0-79D2-959F-8222-5E37E828B334}"/>
          </ac:spMkLst>
        </pc:spChg>
        <pc:spChg chg="mod">
          <ac:chgData name="CARLOS COSTAS INSUA" userId="e10c8832-4d3d-4782-833a-236983bbf7b2" providerId="ADAL" clId="{47E41604-0C7C-435B-A107-D9296C7C3701}" dt="2024-01-20T17:44:46.979" v="28" actId="1035"/>
          <ac:spMkLst>
            <pc:docMk/>
            <pc:sldMk cId="2004873951" sldId="256"/>
            <ac:spMk id="23" creationId="{9A9B5B7A-42D6-94E5-EF46-EDEEDE36C8FE}"/>
          </ac:spMkLst>
        </pc:spChg>
        <pc:spChg chg="mod">
          <ac:chgData name="CARLOS COSTAS INSUA" userId="e10c8832-4d3d-4782-833a-236983bbf7b2" providerId="ADAL" clId="{47E41604-0C7C-435B-A107-D9296C7C3701}" dt="2024-01-20T17:44:46.979" v="28" actId="1035"/>
          <ac:spMkLst>
            <pc:docMk/>
            <pc:sldMk cId="2004873951" sldId="256"/>
            <ac:spMk id="24" creationId="{6E8D5B12-D73D-F80A-56D3-FEFD41B2B4F4}"/>
          </ac:spMkLst>
        </pc:spChg>
        <pc:spChg chg="add mod">
          <ac:chgData name="CARLOS COSTAS INSUA" userId="e10c8832-4d3d-4782-833a-236983bbf7b2" providerId="ADAL" clId="{47E41604-0C7C-435B-A107-D9296C7C3701}" dt="2024-01-20T17:46:50.195" v="87" actId="1076"/>
          <ac:spMkLst>
            <pc:docMk/>
            <pc:sldMk cId="2004873951" sldId="256"/>
            <ac:spMk id="25" creationId="{1C4782DB-1EE5-902A-7FE7-FC2309E2F217}"/>
          </ac:spMkLst>
        </pc:spChg>
        <pc:spChg chg="add mod">
          <ac:chgData name="CARLOS COSTAS INSUA" userId="e10c8832-4d3d-4782-833a-236983bbf7b2" providerId="ADAL" clId="{47E41604-0C7C-435B-A107-D9296C7C3701}" dt="2024-01-20T17:49:01.114" v="129" actId="1076"/>
          <ac:spMkLst>
            <pc:docMk/>
            <pc:sldMk cId="2004873951" sldId="256"/>
            <ac:spMk id="26" creationId="{F9351E69-FCDB-7DFB-41F3-85D6BD9C1FB3}"/>
          </ac:spMkLst>
        </pc:spChg>
        <pc:spChg chg="mod">
          <ac:chgData name="CARLOS COSTAS INSUA" userId="e10c8832-4d3d-4782-833a-236983bbf7b2" providerId="ADAL" clId="{47E41604-0C7C-435B-A107-D9296C7C3701}" dt="2024-01-20T17:45:55.018" v="68" actId="20577"/>
          <ac:spMkLst>
            <pc:docMk/>
            <pc:sldMk cId="2004873951" sldId="256"/>
            <ac:spMk id="1754" creationId="{05907BE4-EAE5-6026-200F-8E7E984B2864}"/>
          </ac:spMkLst>
        </pc:spChg>
        <pc:spChg chg="mod">
          <ac:chgData name="CARLOS COSTAS INSUA" userId="e10c8832-4d3d-4782-833a-236983bbf7b2" providerId="ADAL" clId="{47E41604-0C7C-435B-A107-D9296C7C3701}" dt="2024-01-20T17:46:54.812" v="95" actId="1035"/>
          <ac:spMkLst>
            <pc:docMk/>
            <pc:sldMk cId="2004873951" sldId="256"/>
            <ac:spMk id="2589" creationId="{69A5F5F9-9909-4AB1-673B-F17ADE2D31E0}"/>
          </ac:spMkLst>
        </pc:spChg>
        <pc:spChg chg="mod">
          <ac:chgData name="CARLOS COSTAS INSUA" userId="e10c8832-4d3d-4782-833a-236983bbf7b2" providerId="ADAL" clId="{47E41604-0C7C-435B-A107-D9296C7C3701}" dt="2024-01-20T17:46:54.812" v="95" actId="1035"/>
          <ac:spMkLst>
            <pc:docMk/>
            <pc:sldMk cId="2004873951" sldId="256"/>
            <ac:spMk id="2590" creationId="{955C66DD-20B7-16F6-92C6-50BF1E41AE2A}"/>
          </ac:spMkLst>
        </pc:spChg>
        <pc:spChg chg="mod">
          <ac:chgData name="CARLOS COSTAS INSUA" userId="e10c8832-4d3d-4782-833a-236983bbf7b2" providerId="ADAL" clId="{47E41604-0C7C-435B-A107-D9296C7C3701}" dt="2024-01-20T17:46:54.812" v="95" actId="1035"/>
          <ac:spMkLst>
            <pc:docMk/>
            <pc:sldMk cId="2004873951" sldId="256"/>
            <ac:spMk id="2591" creationId="{E8142825-92D4-605B-0680-E449FD1DEFD4}"/>
          </ac:spMkLst>
        </pc:spChg>
        <pc:spChg chg="del">
          <ac:chgData name="CARLOS COSTAS INSUA" userId="e10c8832-4d3d-4782-833a-236983bbf7b2" providerId="ADAL" clId="{47E41604-0C7C-435B-A107-D9296C7C3701}" dt="2024-01-20T17:46:37.309" v="83" actId="478"/>
          <ac:spMkLst>
            <pc:docMk/>
            <pc:sldMk cId="2004873951" sldId="256"/>
            <ac:spMk id="2595" creationId="{195849F1-B1C1-529B-BDD8-228619FBCA2A}"/>
          </ac:spMkLst>
        </pc:spChg>
        <pc:spChg chg="mod">
          <ac:chgData name="CARLOS COSTAS INSUA" userId="e10c8832-4d3d-4782-833a-236983bbf7b2" providerId="ADAL" clId="{47E41604-0C7C-435B-A107-D9296C7C3701}" dt="2024-01-20T17:46:03.979" v="74" actId="20577"/>
          <ac:spMkLst>
            <pc:docMk/>
            <pc:sldMk cId="2004873951" sldId="256"/>
            <ac:spMk id="2596" creationId="{3C216ABE-A851-E86F-B037-6EB1E7CEFF39}"/>
          </ac:spMkLst>
        </pc:spChg>
        <pc:spChg chg="mod">
          <ac:chgData name="CARLOS COSTAS INSUA" userId="e10c8832-4d3d-4782-833a-236983bbf7b2" providerId="ADAL" clId="{47E41604-0C7C-435B-A107-D9296C7C3701}" dt="2024-01-20T17:48:43.951" v="124" actId="1035"/>
          <ac:spMkLst>
            <pc:docMk/>
            <pc:sldMk cId="2004873951" sldId="256"/>
            <ac:spMk id="2602" creationId="{EF303AF1-73D3-D6EB-0E0D-E489EE393CD9}"/>
          </ac:spMkLst>
        </pc:spChg>
        <pc:spChg chg="mod">
          <ac:chgData name="CARLOS COSTAS INSUA" userId="e10c8832-4d3d-4782-833a-236983bbf7b2" providerId="ADAL" clId="{47E41604-0C7C-435B-A107-D9296C7C3701}" dt="2024-01-20T17:48:43.951" v="124" actId="1035"/>
          <ac:spMkLst>
            <pc:docMk/>
            <pc:sldMk cId="2004873951" sldId="256"/>
            <ac:spMk id="2603" creationId="{3121C709-7B7F-F4EA-2408-BDE4B9D21036}"/>
          </ac:spMkLst>
        </pc:spChg>
        <pc:spChg chg="mod">
          <ac:chgData name="CARLOS COSTAS INSUA" userId="e10c8832-4d3d-4782-833a-236983bbf7b2" providerId="ADAL" clId="{47E41604-0C7C-435B-A107-D9296C7C3701}" dt="2024-01-20T17:48:43.951" v="124" actId="1035"/>
          <ac:spMkLst>
            <pc:docMk/>
            <pc:sldMk cId="2004873951" sldId="256"/>
            <ac:spMk id="2604" creationId="{8AC20314-E187-32DF-9C4C-D8A97241CBBE}"/>
          </ac:spMkLst>
        </pc:spChg>
        <pc:grpChg chg="del">
          <ac:chgData name="CARLOS COSTAS INSUA" userId="e10c8832-4d3d-4782-833a-236983bbf7b2" providerId="ADAL" clId="{47E41604-0C7C-435B-A107-D9296C7C3701}" dt="2024-01-20T17:44:20.033" v="8" actId="165"/>
          <ac:grpSpMkLst>
            <pc:docMk/>
            <pc:sldMk cId="2004873951" sldId="256"/>
            <ac:grpSpMk id="8" creationId="{0EA5F65C-EF2D-C720-F0A1-1EE734242075}"/>
          </ac:grpSpMkLst>
        </pc:grpChg>
        <pc:grpChg chg="mod topLvl">
          <ac:chgData name="CARLOS COSTAS INSUA" userId="e10c8832-4d3d-4782-833a-236983bbf7b2" providerId="ADAL" clId="{47E41604-0C7C-435B-A107-D9296C7C3701}" dt="2024-01-20T17:44:20.033" v="8" actId="165"/>
          <ac:grpSpMkLst>
            <pc:docMk/>
            <pc:sldMk cId="2004873951" sldId="256"/>
            <ac:grpSpMk id="16" creationId="{D633F6BD-977A-E2D8-E2B5-AD76B9A9A452}"/>
          </ac:grpSpMkLst>
        </pc:grpChg>
        <pc:grpChg chg="mod">
          <ac:chgData name="CARLOS COSTAS INSUA" userId="e10c8832-4d3d-4782-833a-236983bbf7b2" providerId="ADAL" clId="{47E41604-0C7C-435B-A107-D9296C7C3701}" dt="2024-01-20T17:44:20.033" v="8" actId="165"/>
          <ac:grpSpMkLst>
            <pc:docMk/>
            <pc:sldMk cId="2004873951" sldId="256"/>
            <ac:grpSpMk id="20" creationId="{A6F17EAB-BE5F-E35D-2170-8FF519FF9C10}"/>
          </ac:grpSpMkLst>
        </pc:grpChg>
        <pc:picChg chg="add mod ord modCrop">
          <ac:chgData name="CARLOS COSTAS INSUA" userId="e10c8832-4d3d-4782-833a-236983bbf7b2" providerId="ADAL" clId="{47E41604-0C7C-435B-A107-D9296C7C3701}" dt="2024-01-20T17:48:30.568" v="102" actId="167"/>
          <ac:picMkLst>
            <pc:docMk/>
            <pc:sldMk cId="2004873951" sldId="256"/>
            <ac:picMk id="2" creationId="{4B6D36AB-4F72-BAB8-F268-7C1057719173}"/>
          </ac:picMkLst>
        </pc:picChg>
        <pc:picChg chg="add mod ord modCrop">
          <ac:chgData name="CARLOS COSTAS INSUA" userId="e10c8832-4d3d-4782-833a-236983bbf7b2" providerId="ADAL" clId="{47E41604-0C7C-435B-A107-D9296C7C3701}" dt="2024-01-20T17:48:51.176" v="127" actId="1076"/>
          <ac:picMkLst>
            <pc:docMk/>
            <pc:sldMk cId="2004873951" sldId="256"/>
            <ac:picMk id="3" creationId="{FD7D97B8-3E4C-B884-C17E-3D1870C53AFE}"/>
          </ac:picMkLst>
        </pc:picChg>
        <pc:picChg chg="del mod">
          <ac:chgData name="CARLOS COSTAS INSUA" userId="e10c8832-4d3d-4782-833a-236983bbf7b2" providerId="ADAL" clId="{47E41604-0C7C-435B-A107-D9296C7C3701}" dt="2024-01-20T17:46:34.810" v="82" actId="478"/>
          <ac:picMkLst>
            <pc:docMk/>
            <pc:sldMk cId="2004873951" sldId="256"/>
            <ac:picMk id="4" creationId="{F4174E87-5A8F-6FDB-D478-F4E6EADCA5FD}"/>
          </ac:picMkLst>
        </pc:picChg>
        <pc:picChg chg="del mod">
          <ac:chgData name="CARLOS COSTAS INSUA" userId="e10c8832-4d3d-4782-833a-236983bbf7b2" providerId="ADAL" clId="{47E41604-0C7C-435B-A107-D9296C7C3701}" dt="2024-01-20T17:48:32.225" v="103" actId="478"/>
          <ac:picMkLst>
            <pc:docMk/>
            <pc:sldMk cId="2004873951" sldId="256"/>
            <ac:picMk id="5" creationId="{6E3FCCF2-483D-C2E0-CE9F-F22D7E0933EB}"/>
          </ac:picMkLst>
        </pc:picChg>
        <pc:picChg chg="add mod ord modCrop">
          <ac:chgData name="CARLOS COSTAS INSUA" userId="e10c8832-4d3d-4782-833a-236983bbf7b2" providerId="ADAL" clId="{47E41604-0C7C-435B-A107-D9296C7C3701}" dt="2024-01-20T17:45:18.522" v="36" actId="167"/>
          <ac:picMkLst>
            <pc:docMk/>
            <pc:sldMk cId="2004873951" sldId="256"/>
            <ac:picMk id="7" creationId="{C1234F58-D2DA-D3FB-42CE-1DDCBE23A1BB}"/>
          </ac:picMkLst>
        </pc:picChg>
        <pc:picChg chg="del mod topLvl">
          <ac:chgData name="CARLOS COSTAS INSUA" userId="e10c8832-4d3d-4782-833a-236983bbf7b2" providerId="ADAL" clId="{47E41604-0C7C-435B-A107-D9296C7C3701}" dt="2024-01-20T17:45:21.095" v="37" actId="478"/>
          <ac:picMkLst>
            <pc:docMk/>
            <pc:sldMk cId="2004873951" sldId="256"/>
            <ac:picMk id="9" creationId="{A73EC47C-6762-3BCD-1E2C-CABD59027AC2}"/>
          </ac:picMkLst>
        </pc:picChg>
        <pc:picChg chg="del mod topLvl">
          <ac:chgData name="CARLOS COSTAS INSUA" userId="e10c8832-4d3d-4782-833a-236983bbf7b2" providerId="ADAL" clId="{47E41604-0C7C-435B-A107-D9296C7C3701}" dt="2024-01-20T17:44:28.675" v="12" actId="478"/>
          <ac:picMkLst>
            <pc:docMk/>
            <pc:sldMk cId="2004873951" sldId="256"/>
            <ac:picMk id="10" creationId="{D29A1802-3AA5-74FD-59C3-C0EDECCC5315}"/>
          </ac:picMkLst>
        </pc:picChg>
        <pc:picChg chg="add mod ord modCrop">
          <ac:chgData name="CARLOS COSTAS INSUA" userId="e10c8832-4d3d-4782-833a-236983bbf7b2" providerId="ADAL" clId="{47E41604-0C7C-435B-A107-D9296C7C3701}" dt="2024-01-20T17:46:44.530" v="86" actId="1076"/>
          <ac:picMkLst>
            <pc:docMk/>
            <pc:sldMk cId="2004873951" sldId="256"/>
            <ac:picMk id="17" creationId="{B5B433BC-5628-C16F-4F4A-75B6A1C7E156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93631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7848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8274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1759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3455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16573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47065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4753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66391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18848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48144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9340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o 3">
            <a:extLst>
              <a:ext uri="{FF2B5EF4-FFF2-40B4-BE49-F238E27FC236}">
                <a16:creationId xmlns:a16="http://schemas.microsoft.com/office/drawing/2014/main" id="{5320780F-D324-D93E-A0C2-72F3210C23D1}"/>
              </a:ext>
            </a:extLst>
          </p:cNvPr>
          <p:cNvGrpSpPr/>
          <p:nvPr/>
        </p:nvGrpSpPr>
        <p:grpSpPr>
          <a:xfrm>
            <a:off x="353987" y="164592"/>
            <a:ext cx="6504013" cy="2937280"/>
            <a:chOff x="353987" y="164592"/>
            <a:chExt cx="6504013" cy="2937280"/>
          </a:xfrm>
        </p:grpSpPr>
        <p:pic>
          <p:nvPicPr>
            <p:cNvPr id="2" name="Imagen 1" descr="Imagen que contiene firmar, gato, parado, cuarto&#10;&#10;Descripción generada automáticamente">
              <a:extLst>
                <a:ext uri="{FF2B5EF4-FFF2-40B4-BE49-F238E27FC236}">
                  <a16:creationId xmlns:a16="http://schemas.microsoft.com/office/drawing/2014/main" id="{4B6D36AB-4F72-BAB8-F268-7C1057719173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240" t="19153" r="6296" b="20958"/>
            <a:stretch/>
          </p:blipFill>
          <p:spPr>
            <a:xfrm>
              <a:off x="3612529" y="1880065"/>
              <a:ext cx="2804400" cy="10224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3" name="Imagen 2" descr="Imagen que contiene interior, pequeño, refrigerador, reloj&#10;&#10;Descripción generada automáticamente">
              <a:extLst>
                <a:ext uri="{FF2B5EF4-FFF2-40B4-BE49-F238E27FC236}">
                  <a16:creationId xmlns:a16="http://schemas.microsoft.com/office/drawing/2014/main" id="{FD7D97B8-3E4C-B884-C17E-3D1870C53AFE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32" t="24589" r="11318" b="18227"/>
            <a:stretch/>
          </p:blipFill>
          <p:spPr>
            <a:xfrm>
              <a:off x="431891" y="1880065"/>
              <a:ext cx="2804400" cy="10224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7" name="Imagen 6" descr="Imagen que contiene interior, pequeño, luz, cuarto&#10;&#10;Descripción generada automáticamente">
              <a:extLst>
                <a:ext uri="{FF2B5EF4-FFF2-40B4-BE49-F238E27FC236}">
                  <a16:creationId xmlns:a16="http://schemas.microsoft.com/office/drawing/2014/main" id="{C1234F58-D2DA-D3FB-42CE-1DDCBE23A1BB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5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71" t="26413" r="9408" b="17352"/>
            <a:stretch/>
          </p:blipFill>
          <p:spPr>
            <a:xfrm>
              <a:off x="3612529" y="610802"/>
              <a:ext cx="2804400" cy="10224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7" name="Imagen 16" descr="Imagen que contiene luz, cuarto&#10;&#10;Descripción generada automáticamente">
              <a:extLst>
                <a:ext uri="{FF2B5EF4-FFF2-40B4-BE49-F238E27FC236}">
                  <a16:creationId xmlns:a16="http://schemas.microsoft.com/office/drawing/2014/main" id="{B5B433BC-5628-C16F-4F4A-75B6A1C7E156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7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91" t="24657" r="9620" b="17532"/>
            <a:stretch/>
          </p:blipFill>
          <p:spPr>
            <a:xfrm>
              <a:off x="431891" y="610802"/>
              <a:ext cx="2804400" cy="10224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1" name="Rectángulo 10">
              <a:extLst>
                <a:ext uri="{FF2B5EF4-FFF2-40B4-BE49-F238E27FC236}">
                  <a16:creationId xmlns:a16="http://schemas.microsoft.com/office/drawing/2014/main" id="{407C6F6A-5A2B-EDFD-B031-9CCC950236DB}"/>
                </a:ext>
              </a:extLst>
            </p:cNvPr>
            <p:cNvSpPr/>
            <p:nvPr/>
          </p:nvSpPr>
          <p:spPr>
            <a:xfrm>
              <a:off x="769241" y="1117524"/>
              <a:ext cx="2109690" cy="246380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81F1C6DB-4FE9-14EF-C6C8-289969765A58}"/>
                </a:ext>
              </a:extLst>
            </p:cNvPr>
            <p:cNvSpPr txBox="1"/>
            <p:nvPr/>
          </p:nvSpPr>
          <p:spPr>
            <a:xfrm>
              <a:off x="3576273" y="840366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75</a:t>
              </a:r>
            </a:p>
          </p:txBody>
        </p:sp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F9F5E387-24BF-8EFB-7B1D-CC83678FEEDE}"/>
                </a:ext>
              </a:extLst>
            </p:cNvPr>
            <p:cNvSpPr txBox="1"/>
            <p:nvPr/>
          </p:nvSpPr>
          <p:spPr>
            <a:xfrm>
              <a:off x="3576273" y="992261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50</a:t>
              </a:r>
            </a:p>
          </p:txBody>
        </p:sp>
        <p:sp>
          <p:nvSpPr>
            <p:cNvPr id="14" name="CuadroTexto 13">
              <a:extLst>
                <a:ext uri="{FF2B5EF4-FFF2-40B4-BE49-F238E27FC236}">
                  <a16:creationId xmlns:a16="http://schemas.microsoft.com/office/drawing/2014/main" id="{99016635-A630-214E-F4FF-B9F22A5DC3E5}"/>
                </a:ext>
              </a:extLst>
            </p:cNvPr>
            <p:cNvSpPr txBox="1"/>
            <p:nvPr/>
          </p:nvSpPr>
          <p:spPr>
            <a:xfrm>
              <a:off x="3576273" y="1100159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37</a:t>
              </a:r>
            </a:p>
          </p:txBody>
        </p:sp>
        <p:sp>
          <p:nvSpPr>
            <p:cNvPr id="15" name="CuadroTexto 14">
              <a:extLst>
                <a:ext uri="{FF2B5EF4-FFF2-40B4-BE49-F238E27FC236}">
                  <a16:creationId xmlns:a16="http://schemas.microsoft.com/office/drawing/2014/main" id="{AB7C22C8-F05F-E354-CA99-7D1B3EDFDD1D}"/>
                </a:ext>
              </a:extLst>
            </p:cNvPr>
            <p:cNvSpPr txBox="1"/>
            <p:nvPr/>
          </p:nvSpPr>
          <p:spPr>
            <a:xfrm>
              <a:off x="3522975" y="627918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s-ES" sz="7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16" name="Grupo 15">
              <a:extLst>
                <a:ext uri="{FF2B5EF4-FFF2-40B4-BE49-F238E27FC236}">
                  <a16:creationId xmlns:a16="http://schemas.microsoft.com/office/drawing/2014/main" id="{D633F6BD-977A-E2D8-E2B5-AD76B9A9A452}"/>
                </a:ext>
              </a:extLst>
            </p:cNvPr>
            <p:cNvGrpSpPr/>
            <p:nvPr/>
          </p:nvGrpSpPr>
          <p:grpSpPr>
            <a:xfrm>
              <a:off x="361718" y="597938"/>
              <a:ext cx="357790" cy="778444"/>
              <a:chOff x="3806601" y="536350"/>
              <a:chExt cx="357790" cy="778444"/>
            </a:xfrm>
          </p:grpSpPr>
          <p:grpSp>
            <p:nvGrpSpPr>
              <p:cNvPr id="20" name="Grupo 19">
                <a:extLst>
                  <a:ext uri="{FF2B5EF4-FFF2-40B4-BE49-F238E27FC236}">
                    <a16:creationId xmlns:a16="http://schemas.microsoft.com/office/drawing/2014/main" id="{A6F17EAB-BE5F-E35D-2170-8FF519FF9C10}"/>
                  </a:ext>
                </a:extLst>
              </p:cNvPr>
              <p:cNvGrpSpPr/>
              <p:nvPr/>
            </p:nvGrpSpPr>
            <p:grpSpPr>
              <a:xfrm>
                <a:off x="3859899" y="828670"/>
                <a:ext cx="284052" cy="486124"/>
                <a:chOff x="3859899" y="828670"/>
                <a:chExt cx="284052" cy="486124"/>
              </a:xfrm>
            </p:grpSpPr>
            <p:sp>
              <p:nvSpPr>
                <p:cNvPr id="22" name="CuadroTexto 21">
                  <a:extLst>
                    <a:ext uri="{FF2B5EF4-FFF2-40B4-BE49-F238E27FC236}">
                      <a16:creationId xmlns:a16="http://schemas.microsoft.com/office/drawing/2014/main" id="{59A133B0-79D2-959F-8222-5E37E828B334}"/>
                    </a:ext>
                  </a:extLst>
                </p:cNvPr>
                <p:cNvSpPr txBox="1"/>
                <p:nvPr/>
              </p:nvSpPr>
              <p:spPr>
                <a:xfrm>
                  <a:off x="3859899" y="828670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23" name="CuadroTexto 22">
                  <a:extLst>
                    <a:ext uri="{FF2B5EF4-FFF2-40B4-BE49-F238E27FC236}">
                      <a16:creationId xmlns:a16="http://schemas.microsoft.com/office/drawing/2014/main" id="{9A9B5B7A-42D6-94E5-EF46-EDEEDE36C8FE}"/>
                    </a:ext>
                  </a:extLst>
                </p:cNvPr>
                <p:cNvSpPr txBox="1"/>
                <p:nvPr/>
              </p:nvSpPr>
              <p:spPr>
                <a:xfrm>
                  <a:off x="3859899" y="981903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4" name="CuadroTexto 23">
                  <a:extLst>
                    <a:ext uri="{FF2B5EF4-FFF2-40B4-BE49-F238E27FC236}">
                      <a16:creationId xmlns:a16="http://schemas.microsoft.com/office/drawing/2014/main" id="{6E8D5B12-D73D-F80A-56D3-FEFD41B2B4F4}"/>
                    </a:ext>
                  </a:extLst>
                </p:cNvPr>
                <p:cNvSpPr txBox="1"/>
                <p:nvPr/>
              </p:nvSpPr>
              <p:spPr>
                <a:xfrm>
                  <a:off x="3859899" y="1114739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21" name="CuadroTexto 20">
                <a:extLst>
                  <a:ext uri="{FF2B5EF4-FFF2-40B4-BE49-F238E27FC236}">
                    <a16:creationId xmlns:a16="http://schemas.microsoft.com/office/drawing/2014/main" id="{98E5F04E-1E86-5DC9-94AD-2F640FEB67D2}"/>
                  </a:ext>
                </a:extLst>
              </p:cNvPr>
              <p:cNvSpPr txBox="1"/>
              <p:nvPr/>
            </p:nvSpPr>
            <p:spPr>
              <a:xfrm>
                <a:off x="3806601" y="536350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1754" name="CuadroTexto 1753">
              <a:extLst>
                <a:ext uri="{FF2B5EF4-FFF2-40B4-BE49-F238E27FC236}">
                  <a16:creationId xmlns:a16="http://schemas.microsoft.com/office/drawing/2014/main" id="{05907BE4-EAE5-6026-200F-8E7E984B2864}"/>
                </a:ext>
              </a:extLst>
            </p:cNvPr>
            <p:cNvSpPr txBox="1"/>
            <p:nvPr/>
          </p:nvSpPr>
          <p:spPr>
            <a:xfrm>
              <a:off x="4361607" y="164592"/>
              <a:ext cx="249639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Figure EV3D – </a:t>
              </a:r>
              <a:r>
                <a:rPr lang="es-E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Uncropped</a:t>
              </a:r>
              <a:r>
                <a:rPr lang="es-E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Bs</a:t>
              </a:r>
              <a:endParaRPr lang="es-ES" sz="12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62" name="CuadroTexto 1361">
              <a:extLst>
                <a:ext uri="{FF2B5EF4-FFF2-40B4-BE49-F238E27FC236}">
                  <a16:creationId xmlns:a16="http://schemas.microsoft.com/office/drawing/2014/main" id="{A0D1A375-D2D6-FD4A-6775-D426EC941C6A}"/>
                </a:ext>
              </a:extLst>
            </p:cNvPr>
            <p:cNvSpPr txBox="1"/>
            <p:nvPr/>
          </p:nvSpPr>
          <p:spPr>
            <a:xfrm>
              <a:off x="353987" y="1618909"/>
              <a:ext cx="3071144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Anti-pERK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(T202/Y204)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553" name="CuadroTexto 2552">
              <a:extLst>
                <a:ext uri="{FF2B5EF4-FFF2-40B4-BE49-F238E27FC236}">
                  <a16:creationId xmlns:a16="http://schemas.microsoft.com/office/drawing/2014/main" id="{75DAD5D6-EE9B-3F86-4DB1-13AFD23F71BE}"/>
                </a:ext>
              </a:extLst>
            </p:cNvPr>
            <p:cNvSpPr txBox="1"/>
            <p:nvPr/>
          </p:nvSpPr>
          <p:spPr>
            <a:xfrm>
              <a:off x="3535584" y="1618909"/>
              <a:ext cx="30711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ERK (T202/Y204)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596" name="CuadroTexto 2595">
              <a:extLst>
                <a:ext uri="{FF2B5EF4-FFF2-40B4-BE49-F238E27FC236}">
                  <a16:creationId xmlns:a16="http://schemas.microsoft.com/office/drawing/2014/main" id="{3C216ABE-A851-E86F-B037-6EB1E7CEFF39}"/>
                </a:ext>
              </a:extLst>
            </p:cNvPr>
            <p:cNvSpPr txBox="1"/>
            <p:nvPr/>
          </p:nvSpPr>
          <p:spPr>
            <a:xfrm>
              <a:off x="353987" y="2886428"/>
              <a:ext cx="31922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CRBN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597" name="CuadroTexto 2596">
              <a:extLst>
                <a:ext uri="{FF2B5EF4-FFF2-40B4-BE49-F238E27FC236}">
                  <a16:creationId xmlns:a16="http://schemas.microsoft.com/office/drawing/2014/main" id="{DA76FD5F-F405-DC69-14A8-32184A7CB30A}"/>
                </a:ext>
              </a:extLst>
            </p:cNvPr>
            <p:cNvSpPr txBox="1"/>
            <p:nvPr/>
          </p:nvSpPr>
          <p:spPr>
            <a:xfrm>
              <a:off x="3535584" y="2886428"/>
              <a:ext cx="31922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Tubuli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602" name="CuadroTexto 2601">
              <a:extLst>
                <a:ext uri="{FF2B5EF4-FFF2-40B4-BE49-F238E27FC236}">
                  <a16:creationId xmlns:a16="http://schemas.microsoft.com/office/drawing/2014/main" id="{EF303AF1-73D3-D6EB-0E0D-E489EE393CD9}"/>
                </a:ext>
              </a:extLst>
            </p:cNvPr>
            <p:cNvSpPr txBox="1"/>
            <p:nvPr/>
          </p:nvSpPr>
          <p:spPr>
            <a:xfrm>
              <a:off x="3623011" y="2174133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75</a:t>
              </a:r>
            </a:p>
          </p:txBody>
        </p:sp>
        <p:sp>
          <p:nvSpPr>
            <p:cNvPr id="2603" name="CuadroTexto 2602">
              <a:extLst>
                <a:ext uri="{FF2B5EF4-FFF2-40B4-BE49-F238E27FC236}">
                  <a16:creationId xmlns:a16="http://schemas.microsoft.com/office/drawing/2014/main" id="{3121C709-7B7F-F4EA-2408-BDE4B9D21036}"/>
                </a:ext>
              </a:extLst>
            </p:cNvPr>
            <p:cNvSpPr txBox="1"/>
            <p:nvPr/>
          </p:nvSpPr>
          <p:spPr>
            <a:xfrm>
              <a:off x="3623011" y="2326028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50</a:t>
              </a:r>
            </a:p>
          </p:txBody>
        </p:sp>
        <p:sp>
          <p:nvSpPr>
            <p:cNvPr id="2604" name="CuadroTexto 2603">
              <a:extLst>
                <a:ext uri="{FF2B5EF4-FFF2-40B4-BE49-F238E27FC236}">
                  <a16:creationId xmlns:a16="http://schemas.microsoft.com/office/drawing/2014/main" id="{8AC20314-E187-32DF-9C4C-D8A97241CBBE}"/>
                </a:ext>
              </a:extLst>
            </p:cNvPr>
            <p:cNvSpPr txBox="1"/>
            <p:nvPr/>
          </p:nvSpPr>
          <p:spPr>
            <a:xfrm>
              <a:off x="3623011" y="2433926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37</a:t>
              </a:r>
            </a:p>
          </p:txBody>
        </p:sp>
        <p:sp>
          <p:nvSpPr>
            <p:cNvPr id="2601" name="CuadroTexto 2600">
              <a:extLst>
                <a:ext uri="{FF2B5EF4-FFF2-40B4-BE49-F238E27FC236}">
                  <a16:creationId xmlns:a16="http://schemas.microsoft.com/office/drawing/2014/main" id="{4418FFC3-B8DE-F623-2C47-DD22285BFE76}"/>
                </a:ext>
              </a:extLst>
            </p:cNvPr>
            <p:cNvSpPr txBox="1"/>
            <p:nvPr/>
          </p:nvSpPr>
          <p:spPr>
            <a:xfrm>
              <a:off x="3569713" y="1897181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s-ES" sz="7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2586" name="Grupo 2585">
              <a:extLst>
                <a:ext uri="{FF2B5EF4-FFF2-40B4-BE49-F238E27FC236}">
                  <a16:creationId xmlns:a16="http://schemas.microsoft.com/office/drawing/2014/main" id="{57C35D29-D1FF-810D-43EC-7CCCD12B22C4}"/>
                </a:ext>
              </a:extLst>
            </p:cNvPr>
            <p:cNvGrpSpPr/>
            <p:nvPr/>
          </p:nvGrpSpPr>
          <p:grpSpPr>
            <a:xfrm>
              <a:off x="361718" y="1867201"/>
              <a:ext cx="357790" cy="720212"/>
              <a:chOff x="3806601" y="536350"/>
              <a:chExt cx="357790" cy="720212"/>
            </a:xfrm>
          </p:grpSpPr>
          <p:grpSp>
            <p:nvGrpSpPr>
              <p:cNvPr id="2587" name="Grupo 2586">
                <a:extLst>
                  <a:ext uri="{FF2B5EF4-FFF2-40B4-BE49-F238E27FC236}">
                    <a16:creationId xmlns:a16="http://schemas.microsoft.com/office/drawing/2014/main" id="{4C387F59-0650-B35B-6D8B-9681AE7B2ACF}"/>
                  </a:ext>
                </a:extLst>
              </p:cNvPr>
              <p:cNvGrpSpPr/>
              <p:nvPr/>
            </p:nvGrpSpPr>
            <p:grpSpPr>
              <a:xfrm>
                <a:off x="3859899" y="770438"/>
                <a:ext cx="284052" cy="486124"/>
                <a:chOff x="3859899" y="770438"/>
                <a:chExt cx="284052" cy="486124"/>
              </a:xfrm>
            </p:grpSpPr>
            <p:sp>
              <p:nvSpPr>
                <p:cNvPr id="2589" name="CuadroTexto 2588">
                  <a:extLst>
                    <a:ext uri="{FF2B5EF4-FFF2-40B4-BE49-F238E27FC236}">
                      <a16:creationId xmlns:a16="http://schemas.microsoft.com/office/drawing/2014/main" id="{69A5F5F9-9909-4AB1-673B-F17ADE2D31E0}"/>
                    </a:ext>
                  </a:extLst>
                </p:cNvPr>
                <p:cNvSpPr txBox="1"/>
                <p:nvPr/>
              </p:nvSpPr>
              <p:spPr>
                <a:xfrm>
                  <a:off x="3859899" y="770438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2590" name="CuadroTexto 2589">
                  <a:extLst>
                    <a:ext uri="{FF2B5EF4-FFF2-40B4-BE49-F238E27FC236}">
                      <a16:creationId xmlns:a16="http://schemas.microsoft.com/office/drawing/2014/main" id="{955C66DD-20B7-16F6-92C6-50BF1E41AE2A}"/>
                    </a:ext>
                  </a:extLst>
                </p:cNvPr>
                <p:cNvSpPr txBox="1"/>
                <p:nvPr/>
              </p:nvSpPr>
              <p:spPr>
                <a:xfrm>
                  <a:off x="3859899" y="923671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591" name="CuadroTexto 2590">
                  <a:extLst>
                    <a:ext uri="{FF2B5EF4-FFF2-40B4-BE49-F238E27FC236}">
                      <a16:creationId xmlns:a16="http://schemas.microsoft.com/office/drawing/2014/main" id="{E8142825-92D4-605B-0680-E449FD1DEFD4}"/>
                    </a:ext>
                  </a:extLst>
                </p:cNvPr>
                <p:cNvSpPr txBox="1"/>
                <p:nvPr/>
              </p:nvSpPr>
              <p:spPr>
                <a:xfrm>
                  <a:off x="3859899" y="1056507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2588" name="CuadroTexto 2587">
                <a:extLst>
                  <a:ext uri="{FF2B5EF4-FFF2-40B4-BE49-F238E27FC236}">
                    <a16:creationId xmlns:a16="http://schemas.microsoft.com/office/drawing/2014/main" id="{2AAFC5FB-03C2-A03D-D872-95BAC81D0E90}"/>
                  </a:ext>
                </a:extLst>
              </p:cNvPr>
              <p:cNvSpPr txBox="1"/>
              <p:nvPr/>
            </p:nvSpPr>
            <p:spPr>
              <a:xfrm>
                <a:off x="3806601" y="536350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18" name="Rectángulo 17">
              <a:extLst>
                <a:ext uri="{FF2B5EF4-FFF2-40B4-BE49-F238E27FC236}">
                  <a16:creationId xmlns:a16="http://schemas.microsoft.com/office/drawing/2014/main" id="{5F284BA3-B96B-D9AC-C8DB-42FCE30123EA}"/>
                </a:ext>
              </a:extLst>
            </p:cNvPr>
            <p:cNvSpPr/>
            <p:nvPr/>
          </p:nvSpPr>
          <p:spPr>
            <a:xfrm>
              <a:off x="3942949" y="1063492"/>
              <a:ext cx="2109690" cy="246380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5" name="Rectángulo 24">
              <a:extLst>
                <a:ext uri="{FF2B5EF4-FFF2-40B4-BE49-F238E27FC236}">
                  <a16:creationId xmlns:a16="http://schemas.microsoft.com/office/drawing/2014/main" id="{1C4782DB-1EE5-902A-7FE7-FC2309E2F217}"/>
                </a:ext>
              </a:extLst>
            </p:cNvPr>
            <p:cNvSpPr/>
            <p:nvPr/>
          </p:nvSpPr>
          <p:spPr>
            <a:xfrm>
              <a:off x="791739" y="2230462"/>
              <a:ext cx="2109690" cy="246380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6" name="Rectángulo 25">
              <a:extLst>
                <a:ext uri="{FF2B5EF4-FFF2-40B4-BE49-F238E27FC236}">
                  <a16:creationId xmlns:a16="http://schemas.microsoft.com/office/drawing/2014/main" id="{F9351E69-FCDB-7DFB-41F3-85D6BD9C1FB3}"/>
                </a:ext>
              </a:extLst>
            </p:cNvPr>
            <p:cNvSpPr/>
            <p:nvPr/>
          </p:nvSpPr>
          <p:spPr>
            <a:xfrm>
              <a:off x="4016311" y="2302218"/>
              <a:ext cx="2109690" cy="246380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</p:spTree>
    <p:extLst>
      <p:ext uri="{BB962C8B-B14F-4D97-AF65-F5344CB8AC3E}">
        <p14:creationId xmlns:p14="http://schemas.microsoft.com/office/powerpoint/2010/main" val="200487395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82</TotalTime>
  <Words>47</Words>
  <Application>Microsoft Office PowerPoint</Application>
  <PresentationFormat>A4 (210 x 297 mm)</PresentationFormat>
  <Paragraphs>2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LOS COSTAS INSUA</dc:creator>
  <cp:lastModifiedBy>MANUEL GUZMAN PASTOR</cp:lastModifiedBy>
  <cp:revision>4</cp:revision>
  <dcterms:created xsi:type="dcterms:W3CDTF">2023-12-26T11:36:59Z</dcterms:created>
  <dcterms:modified xsi:type="dcterms:W3CDTF">2024-02-26T07:46:12Z</dcterms:modified>
</cp:coreProperties>
</file>